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4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82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picellum\Spicellum%20roseum%208d%20YEPD.CSV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Spicellum roseum 8d YEPD'!$A$4:$A$1472</c:f>
              <c:numCache>
                <c:formatCode>General</c:formatCode>
                <c:ptCount val="1469"/>
                <c:pt idx="0">
                  <c:v>3.085</c:v>
                </c:pt>
                <c:pt idx="1">
                  <c:v>3.0909999999999997</c:v>
                </c:pt>
                <c:pt idx="2">
                  <c:v>3.097</c:v>
                </c:pt>
                <c:pt idx="3">
                  <c:v>3.1019999999999999</c:v>
                </c:pt>
                <c:pt idx="4">
                  <c:v>3.1080000000000001</c:v>
                </c:pt>
                <c:pt idx="5">
                  <c:v>3.1139999999999999</c:v>
                </c:pt>
                <c:pt idx="6">
                  <c:v>3.1189999999999998</c:v>
                </c:pt>
                <c:pt idx="7">
                  <c:v>3.125</c:v>
                </c:pt>
                <c:pt idx="8">
                  <c:v>3.1309999999999998</c:v>
                </c:pt>
                <c:pt idx="9">
                  <c:v>3.137</c:v>
                </c:pt>
                <c:pt idx="10">
                  <c:v>3.1419999999999999</c:v>
                </c:pt>
                <c:pt idx="11">
                  <c:v>3.1480000000000001</c:v>
                </c:pt>
                <c:pt idx="12">
                  <c:v>3.1539999999999999</c:v>
                </c:pt>
                <c:pt idx="13">
                  <c:v>3.16</c:v>
                </c:pt>
                <c:pt idx="14">
                  <c:v>3.165</c:v>
                </c:pt>
                <c:pt idx="15">
                  <c:v>3.1709999999999998</c:v>
                </c:pt>
                <c:pt idx="16">
                  <c:v>3.177</c:v>
                </c:pt>
                <c:pt idx="17">
                  <c:v>3.1819999999999999</c:v>
                </c:pt>
                <c:pt idx="18">
                  <c:v>3.1880000000000002</c:v>
                </c:pt>
                <c:pt idx="19">
                  <c:v>3.194</c:v>
                </c:pt>
                <c:pt idx="20">
                  <c:v>3.2</c:v>
                </c:pt>
                <c:pt idx="21">
                  <c:v>3.2050000000000001</c:v>
                </c:pt>
                <c:pt idx="22">
                  <c:v>3.2109999999999999</c:v>
                </c:pt>
                <c:pt idx="23">
                  <c:v>3.2170000000000001</c:v>
                </c:pt>
                <c:pt idx="24">
                  <c:v>3.222</c:v>
                </c:pt>
                <c:pt idx="25">
                  <c:v>3.2280000000000002</c:v>
                </c:pt>
                <c:pt idx="26">
                  <c:v>3.234</c:v>
                </c:pt>
                <c:pt idx="27">
                  <c:v>3.24</c:v>
                </c:pt>
                <c:pt idx="28">
                  <c:v>3.2450000000000001</c:v>
                </c:pt>
                <c:pt idx="29">
                  <c:v>3.2509999999999999</c:v>
                </c:pt>
                <c:pt idx="30">
                  <c:v>3.2570000000000001</c:v>
                </c:pt>
                <c:pt idx="31">
                  <c:v>3.262</c:v>
                </c:pt>
                <c:pt idx="32">
                  <c:v>3.2680000000000002</c:v>
                </c:pt>
                <c:pt idx="33">
                  <c:v>3.274</c:v>
                </c:pt>
                <c:pt idx="34">
                  <c:v>3.2800000000000002</c:v>
                </c:pt>
                <c:pt idx="35">
                  <c:v>3.2850000000000001</c:v>
                </c:pt>
                <c:pt idx="36">
                  <c:v>3.2909999999999999</c:v>
                </c:pt>
                <c:pt idx="37">
                  <c:v>3.2970000000000002</c:v>
                </c:pt>
                <c:pt idx="38">
                  <c:v>3.3019999999999996</c:v>
                </c:pt>
                <c:pt idx="39">
                  <c:v>3.3079999999999998</c:v>
                </c:pt>
                <c:pt idx="40">
                  <c:v>3.3139999999999996</c:v>
                </c:pt>
                <c:pt idx="41">
                  <c:v>3.32</c:v>
                </c:pt>
                <c:pt idx="42">
                  <c:v>3.3249999999999997</c:v>
                </c:pt>
                <c:pt idx="43">
                  <c:v>3.3309999999999995</c:v>
                </c:pt>
                <c:pt idx="44">
                  <c:v>3.3369999999999997</c:v>
                </c:pt>
                <c:pt idx="45">
                  <c:v>3.3419999999999996</c:v>
                </c:pt>
                <c:pt idx="46">
                  <c:v>3.3479999999999999</c:v>
                </c:pt>
                <c:pt idx="47">
                  <c:v>3.3539999999999996</c:v>
                </c:pt>
                <c:pt idx="48">
                  <c:v>3.36</c:v>
                </c:pt>
                <c:pt idx="49">
                  <c:v>3.3649999999999998</c:v>
                </c:pt>
                <c:pt idx="50">
                  <c:v>3.3709999999999996</c:v>
                </c:pt>
                <c:pt idx="51">
                  <c:v>3.3769999999999993</c:v>
                </c:pt>
                <c:pt idx="52">
                  <c:v>3.3819999999999997</c:v>
                </c:pt>
                <c:pt idx="53">
                  <c:v>3.3879999999999999</c:v>
                </c:pt>
                <c:pt idx="54">
                  <c:v>3.3939999999999997</c:v>
                </c:pt>
                <c:pt idx="55">
                  <c:v>3.4</c:v>
                </c:pt>
                <c:pt idx="56">
                  <c:v>3.4049999999999998</c:v>
                </c:pt>
                <c:pt idx="57">
                  <c:v>3.4109999999999996</c:v>
                </c:pt>
                <c:pt idx="58">
                  <c:v>3.4169999999999994</c:v>
                </c:pt>
                <c:pt idx="59">
                  <c:v>3.4219999999999997</c:v>
                </c:pt>
                <c:pt idx="60">
                  <c:v>3.4279999999999999</c:v>
                </c:pt>
                <c:pt idx="61">
                  <c:v>3.4339999999999997</c:v>
                </c:pt>
                <c:pt idx="62">
                  <c:v>3.44</c:v>
                </c:pt>
                <c:pt idx="63">
                  <c:v>3.4449999999999998</c:v>
                </c:pt>
                <c:pt idx="64">
                  <c:v>3.4509999999999996</c:v>
                </c:pt>
                <c:pt idx="65">
                  <c:v>3.4569999999999994</c:v>
                </c:pt>
                <c:pt idx="66">
                  <c:v>3.4619999999999997</c:v>
                </c:pt>
                <c:pt idx="67">
                  <c:v>3.468</c:v>
                </c:pt>
                <c:pt idx="68">
                  <c:v>3.4739999999999998</c:v>
                </c:pt>
                <c:pt idx="69">
                  <c:v>3.48</c:v>
                </c:pt>
                <c:pt idx="70">
                  <c:v>3.4849999999999999</c:v>
                </c:pt>
                <c:pt idx="71">
                  <c:v>3.4909999999999997</c:v>
                </c:pt>
                <c:pt idx="72">
                  <c:v>3.4969999999999994</c:v>
                </c:pt>
                <c:pt idx="73">
                  <c:v>3.5019999999999998</c:v>
                </c:pt>
                <c:pt idx="74">
                  <c:v>3.508</c:v>
                </c:pt>
                <c:pt idx="75">
                  <c:v>3.5139999999999998</c:v>
                </c:pt>
                <c:pt idx="76">
                  <c:v>3.52</c:v>
                </c:pt>
                <c:pt idx="77">
                  <c:v>3.5249999999999999</c:v>
                </c:pt>
                <c:pt idx="78">
                  <c:v>3.5309999999999997</c:v>
                </c:pt>
                <c:pt idx="79">
                  <c:v>3.5369999999999995</c:v>
                </c:pt>
                <c:pt idx="80">
                  <c:v>3.5419999999999998</c:v>
                </c:pt>
                <c:pt idx="81">
                  <c:v>3.548</c:v>
                </c:pt>
                <c:pt idx="82">
                  <c:v>3.5539999999999998</c:v>
                </c:pt>
                <c:pt idx="83">
                  <c:v>3.56</c:v>
                </c:pt>
                <c:pt idx="84">
                  <c:v>3.5649999999999999</c:v>
                </c:pt>
                <c:pt idx="85">
                  <c:v>3.5709999999999997</c:v>
                </c:pt>
                <c:pt idx="86">
                  <c:v>3.577</c:v>
                </c:pt>
                <c:pt idx="87">
                  <c:v>3.5819999999999999</c:v>
                </c:pt>
                <c:pt idx="88">
                  <c:v>3.5880000000000001</c:v>
                </c:pt>
                <c:pt idx="89">
                  <c:v>3.5939999999999999</c:v>
                </c:pt>
                <c:pt idx="90">
                  <c:v>3.6</c:v>
                </c:pt>
                <c:pt idx="91">
                  <c:v>3.605</c:v>
                </c:pt>
                <c:pt idx="92">
                  <c:v>3.6109999999999998</c:v>
                </c:pt>
                <c:pt idx="93">
                  <c:v>3.617</c:v>
                </c:pt>
                <c:pt idx="94">
                  <c:v>3.6219999999999999</c:v>
                </c:pt>
                <c:pt idx="95">
                  <c:v>3.6280000000000001</c:v>
                </c:pt>
                <c:pt idx="96">
                  <c:v>3.6339999999999999</c:v>
                </c:pt>
                <c:pt idx="97">
                  <c:v>3.64</c:v>
                </c:pt>
                <c:pt idx="98">
                  <c:v>3.645</c:v>
                </c:pt>
                <c:pt idx="99">
                  <c:v>3.6509999999999998</c:v>
                </c:pt>
                <c:pt idx="100">
                  <c:v>3.657</c:v>
                </c:pt>
                <c:pt idx="101">
                  <c:v>3.6619999999999999</c:v>
                </c:pt>
                <c:pt idx="102">
                  <c:v>3.6680000000000001</c:v>
                </c:pt>
                <c:pt idx="103">
                  <c:v>3.6739999999999999</c:v>
                </c:pt>
                <c:pt idx="104">
                  <c:v>3.68</c:v>
                </c:pt>
                <c:pt idx="105">
                  <c:v>3.6850000000000001</c:v>
                </c:pt>
                <c:pt idx="106">
                  <c:v>3.6909999999999998</c:v>
                </c:pt>
                <c:pt idx="107">
                  <c:v>3.6970000000000001</c:v>
                </c:pt>
                <c:pt idx="108">
                  <c:v>3.702</c:v>
                </c:pt>
                <c:pt idx="109">
                  <c:v>3.7080000000000002</c:v>
                </c:pt>
                <c:pt idx="110">
                  <c:v>3.714</c:v>
                </c:pt>
                <c:pt idx="111">
                  <c:v>3.72</c:v>
                </c:pt>
                <c:pt idx="112">
                  <c:v>3.7250000000000001</c:v>
                </c:pt>
                <c:pt idx="113">
                  <c:v>3.7309999999999999</c:v>
                </c:pt>
                <c:pt idx="114">
                  <c:v>3.7370000000000001</c:v>
                </c:pt>
                <c:pt idx="115">
                  <c:v>3.742</c:v>
                </c:pt>
                <c:pt idx="116">
                  <c:v>3.7480000000000002</c:v>
                </c:pt>
                <c:pt idx="117">
                  <c:v>3.754</c:v>
                </c:pt>
                <c:pt idx="118">
                  <c:v>3.7600000000000002</c:v>
                </c:pt>
                <c:pt idx="119">
                  <c:v>3.7650000000000001</c:v>
                </c:pt>
                <c:pt idx="120">
                  <c:v>3.7709999999999999</c:v>
                </c:pt>
                <c:pt idx="121">
                  <c:v>3.7770000000000001</c:v>
                </c:pt>
                <c:pt idx="122">
                  <c:v>3.782</c:v>
                </c:pt>
                <c:pt idx="123">
                  <c:v>3.7880000000000003</c:v>
                </c:pt>
                <c:pt idx="124">
                  <c:v>3.794</c:v>
                </c:pt>
                <c:pt idx="125">
                  <c:v>3.8</c:v>
                </c:pt>
                <c:pt idx="126">
                  <c:v>3.8049999999999997</c:v>
                </c:pt>
                <c:pt idx="127">
                  <c:v>3.8109999999999995</c:v>
                </c:pt>
                <c:pt idx="128">
                  <c:v>3.8169999999999997</c:v>
                </c:pt>
                <c:pt idx="129">
                  <c:v>3.8219999999999996</c:v>
                </c:pt>
                <c:pt idx="130">
                  <c:v>3.8279999999999998</c:v>
                </c:pt>
                <c:pt idx="131">
                  <c:v>3.8339999999999996</c:v>
                </c:pt>
                <c:pt idx="132">
                  <c:v>3.84</c:v>
                </c:pt>
                <c:pt idx="133">
                  <c:v>3.8449999999999998</c:v>
                </c:pt>
                <c:pt idx="134">
                  <c:v>3.8509999999999995</c:v>
                </c:pt>
                <c:pt idx="135">
                  <c:v>3.8569999999999998</c:v>
                </c:pt>
                <c:pt idx="136">
                  <c:v>3.8619999999999997</c:v>
                </c:pt>
                <c:pt idx="137">
                  <c:v>3.8679999999999999</c:v>
                </c:pt>
                <c:pt idx="138">
                  <c:v>3.8739999999999997</c:v>
                </c:pt>
                <c:pt idx="139">
                  <c:v>3.88</c:v>
                </c:pt>
                <c:pt idx="140">
                  <c:v>3.8849999999999998</c:v>
                </c:pt>
                <c:pt idx="141">
                  <c:v>3.8909999999999996</c:v>
                </c:pt>
                <c:pt idx="142">
                  <c:v>3.8969999999999994</c:v>
                </c:pt>
                <c:pt idx="143">
                  <c:v>3.903</c:v>
                </c:pt>
                <c:pt idx="144">
                  <c:v>3.9079999999999999</c:v>
                </c:pt>
                <c:pt idx="145">
                  <c:v>3.9139999999999997</c:v>
                </c:pt>
                <c:pt idx="146">
                  <c:v>3.92</c:v>
                </c:pt>
                <c:pt idx="147">
                  <c:v>3.9249999999999998</c:v>
                </c:pt>
                <c:pt idx="148">
                  <c:v>3.9309999999999996</c:v>
                </c:pt>
                <c:pt idx="149">
                  <c:v>3.9369999999999994</c:v>
                </c:pt>
                <c:pt idx="150">
                  <c:v>3.9430000000000001</c:v>
                </c:pt>
                <c:pt idx="151">
                  <c:v>3.948</c:v>
                </c:pt>
                <c:pt idx="152">
                  <c:v>3.9539999999999997</c:v>
                </c:pt>
                <c:pt idx="153">
                  <c:v>3.96</c:v>
                </c:pt>
                <c:pt idx="154">
                  <c:v>3.9649999999999999</c:v>
                </c:pt>
                <c:pt idx="155">
                  <c:v>3.9709999999999996</c:v>
                </c:pt>
                <c:pt idx="156">
                  <c:v>3.9769999999999994</c:v>
                </c:pt>
                <c:pt idx="157">
                  <c:v>3.9830000000000001</c:v>
                </c:pt>
                <c:pt idx="158">
                  <c:v>3.988</c:v>
                </c:pt>
                <c:pt idx="159">
                  <c:v>3.9939999999999998</c:v>
                </c:pt>
                <c:pt idx="160">
                  <c:v>4</c:v>
                </c:pt>
                <c:pt idx="161">
                  <c:v>4.004999999999999</c:v>
                </c:pt>
                <c:pt idx="162">
                  <c:v>4.0110000000000001</c:v>
                </c:pt>
                <c:pt idx="163">
                  <c:v>4.0169999999999995</c:v>
                </c:pt>
                <c:pt idx="164">
                  <c:v>4.0229999999999988</c:v>
                </c:pt>
                <c:pt idx="165">
                  <c:v>4.0279999999999987</c:v>
                </c:pt>
                <c:pt idx="166">
                  <c:v>4.0339999999999998</c:v>
                </c:pt>
                <c:pt idx="167">
                  <c:v>4.04</c:v>
                </c:pt>
                <c:pt idx="168">
                  <c:v>4.044999999999999</c:v>
                </c:pt>
                <c:pt idx="169">
                  <c:v>4.0510000000000002</c:v>
                </c:pt>
                <c:pt idx="170">
                  <c:v>4.0569999999999995</c:v>
                </c:pt>
                <c:pt idx="171">
                  <c:v>4.0629999999999988</c:v>
                </c:pt>
                <c:pt idx="172">
                  <c:v>4.0679999999999987</c:v>
                </c:pt>
                <c:pt idx="173">
                  <c:v>4.0739999999999998</c:v>
                </c:pt>
                <c:pt idx="174">
                  <c:v>4.08</c:v>
                </c:pt>
                <c:pt idx="175">
                  <c:v>4.085</c:v>
                </c:pt>
                <c:pt idx="176">
                  <c:v>4.0910000000000002</c:v>
                </c:pt>
                <c:pt idx="177">
                  <c:v>4.0969999999999995</c:v>
                </c:pt>
                <c:pt idx="178">
                  <c:v>4.1029999999999989</c:v>
                </c:pt>
                <c:pt idx="179">
                  <c:v>4.1079999999999988</c:v>
                </c:pt>
                <c:pt idx="180">
                  <c:v>4.113999999999999</c:v>
                </c:pt>
                <c:pt idx="181">
                  <c:v>4.1199999999999992</c:v>
                </c:pt>
                <c:pt idx="182">
                  <c:v>4.1249999999999991</c:v>
                </c:pt>
                <c:pt idx="183">
                  <c:v>4.1310000000000002</c:v>
                </c:pt>
                <c:pt idx="184">
                  <c:v>4.1369999999999996</c:v>
                </c:pt>
                <c:pt idx="185">
                  <c:v>4.1429999999999989</c:v>
                </c:pt>
                <c:pt idx="186">
                  <c:v>4.1479999999999988</c:v>
                </c:pt>
                <c:pt idx="187">
                  <c:v>4.153999999999999</c:v>
                </c:pt>
                <c:pt idx="188">
                  <c:v>4.1599999999999993</c:v>
                </c:pt>
                <c:pt idx="189">
                  <c:v>4.1649999999999991</c:v>
                </c:pt>
                <c:pt idx="190">
                  <c:v>4.1710000000000003</c:v>
                </c:pt>
                <c:pt idx="191">
                  <c:v>4.1769999999999996</c:v>
                </c:pt>
                <c:pt idx="192">
                  <c:v>4.1829999999999989</c:v>
                </c:pt>
                <c:pt idx="193">
                  <c:v>4.1879999999999988</c:v>
                </c:pt>
                <c:pt idx="194">
                  <c:v>4.1939999999999991</c:v>
                </c:pt>
                <c:pt idx="195">
                  <c:v>4.2</c:v>
                </c:pt>
                <c:pt idx="196">
                  <c:v>4.2050000000000001</c:v>
                </c:pt>
                <c:pt idx="197">
                  <c:v>4.2110000000000003</c:v>
                </c:pt>
                <c:pt idx="198">
                  <c:v>4.2169999999999996</c:v>
                </c:pt>
                <c:pt idx="199">
                  <c:v>4.222999999999999</c:v>
                </c:pt>
                <c:pt idx="200">
                  <c:v>4.2279999999999989</c:v>
                </c:pt>
                <c:pt idx="201">
                  <c:v>4.234</c:v>
                </c:pt>
                <c:pt idx="202">
                  <c:v>4.24</c:v>
                </c:pt>
                <c:pt idx="203">
                  <c:v>4.2450000000000001</c:v>
                </c:pt>
                <c:pt idx="204">
                  <c:v>4.2510000000000003</c:v>
                </c:pt>
                <c:pt idx="205">
                  <c:v>4.2569999999999997</c:v>
                </c:pt>
                <c:pt idx="206">
                  <c:v>4.262999999999999</c:v>
                </c:pt>
                <c:pt idx="207">
                  <c:v>4.2679999999999989</c:v>
                </c:pt>
                <c:pt idx="208">
                  <c:v>4.274</c:v>
                </c:pt>
                <c:pt idx="209">
                  <c:v>4.28</c:v>
                </c:pt>
                <c:pt idx="210">
                  <c:v>4.2850000000000001</c:v>
                </c:pt>
                <c:pt idx="211">
                  <c:v>4.2910000000000004</c:v>
                </c:pt>
                <c:pt idx="212">
                  <c:v>4.2969999999999997</c:v>
                </c:pt>
                <c:pt idx="213">
                  <c:v>4.302999999999999</c:v>
                </c:pt>
                <c:pt idx="214">
                  <c:v>4.3079999999999989</c:v>
                </c:pt>
                <c:pt idx="215">
                  <c:v>4.3139999999999992</c:v>
                </c:pt>
                <c:pt idx="216">
                  <c:v>4.3199999999999994</c:v>
                </c:pt>
                <c:pt idx="217">
                  <c:v>4.3249999999999993</c:v>
                </c:pt>
                <c:pt idx="218">
                  <c:v>4.3310000000000004</c:v>
                </c:pt>
                <c:pt idx="219">
                  <c:v>4.3369999999999997</c:v>
                </c:pt>
                <c:pt idx="220">
                  <c:v>4.343</c:v>
                </c:pt>
                <c:pt idx="221">
                  <c:v>4.347999999999999</c:v>
                </c:pt>
                <c:pt idx="222">
                  <c:v>4.3539999999999992</c:v>
                </c:pt>
                <c:pt idx="223">
                  <c:v>4.3599999999999994</c:v>
                </c:pt>
                <c:pt idx="224">
                  <c:v>4.3649999999999993</c:v>
                </c:pt>
                <c:pt idx="225">
                  <c:v>4.3710000000000004</c:v>
                </c:pt>
                <c:pt idx="226">
                  <c:v>4.3769999999999998</c:v>
                </c:pt>
                <c:pt idx="227">
                  <c:v>4.383</c:v>
                </c:pt>
                <c:pt idx="228">
                  <c:v>4.387999999999999</c:v>
                </c:pt>
                <c:pt idx="229">
                  <c:v>4.3939999999999992</c:v>
                </c:pt>
                <c:pt idx="230">
                  <c:v>4.4000000000000004</c:v>
                </c:pt>
                <c:pt idx="231">
                  <c:v>4.4050000000000002</c:v>
                </c:pt>
                <c:pt idx="232">
                  <c:v>4.4109999999999996</c:v>
                </c:pt>
                <c:pt idx="233">
                  <c:v>4.4169999999999998</c:v>
                </c:pt>
                <c:pt idx="234">
                  <c:v>4.423</c:v>
                </c:pt>
                <c:pt idx="235">
                  <c:v>4.427999999999999</c:v>
                </c:pt>
                <c:pt idx="236">
                  <c:v>4.4340000000000002</c:v>
                </c:pt>
                <c:pt idx="237">
                  <c:v>4.4400000000000004</c:v>
                </c:pt>
                <c:pt idx="238">
                  <c:v>4.4450000000000003</c:v>
                </c:pt>
                <c:pt idx="239">
                  <c:v>4.4509999999999996</c:v>
                </c:pt>
                <c:pt idx="240">
                  <c:v>4.4569999999999999</c:v>
                </c:pt>
                <c:pt idx="241">
                  <c:v>4.4630000000000001</c:v>
                </c:pt>
                <c:pt idx="242">
                  <c:v>4.468</c:v>
                </c:pt>
                <c:pt idx="243">
                  <c:v>4.4740000000000002</c:v>
                </c:pt>
                <c:pt idx="244">
                  <c:v>4.4800000000000004</c:v>
                </c:pt>
                <c:pt idx="245">
                  <c:v>4.4850000000000003</c:v>
                </c:pt>
                <c:pt idx="246">
                  <c:v>4.4909999999999997</c:v>
                </c:pt>
                <c:pt idx="247">
                  <c:v>4.4969999999999999</c:v>
                </c:pt>
                <c:pt idx="248">
                  <c:v>4.5030000000000001</c:v>
                </c:pt>
                <c:pt idx="249">
                  <c:v>4.508</c:v>
                </c:pt>
                <c:pt idx="250">
                  <c:v>4.5139999999999993</c:v>
                </c:pt>
                <c:pt idx="251">
                  <c:v>4.5199999999999996</c:v>
                </c:pt>
                <c:pt idx="252">
                  <c:v>4.5249999999999995</c:v>
                </c:pt>
                <c:pt idx="253">
                  <c:v>4.5309999999999997</c:v>
                </c:pt>
                <c:pt idx="254">
                  <c:v>4.5369999999999999</c:v>
                </c:pt>
                <c:pt idx="255">
                  <c:v>4.5430000000000001</c:v>
                </c:pt>
                <c:pt idx="256">
                  <c:v>4.548</c:v>
                </c:pt>
                <c:pt idx="257">
                  <c:v>4.5539999999999994</c:v>
                </c:pt>
                <c:pt idx="258">
                  <c:v>4.5599999999999996</c:v>
                </c:pt>
                <c:pt idx="259">
                  <c:v>4.5649999999999995</c:v>
                </c:pt>
                <c:pt idx="260">
                  <c:v>4.5709999999999997</c:v>
                </c:pt>
                <c:pt idx="261">
                  <c:v>4.577</c:v>
                </c:pt>
                <c:pt idx="262">
                  <c:v>4.5830000000000002</c:v>
                </c:pt>
                <c:pt idx="263">
                  <c:v>4.5880000000000001</c:v>
                </c:pt>
                <c:pt idx="264">
                  <c:v>4.5939999999999994</c:v>
                </c:pt>
                <c:pt idx="265">
                  <c:v>4.5999999999999996</c:v>
                </c:pt>
                <c:pt idx="266">
                  <c:v>4.6049999999999995</c:v>
                </c:pt>
                <c:pt idx="267">
                  <c:v>4.6109999999999989</c:v>
                </c:pt>
                <c:pt idx="268">
                  <c:v>4.6169999999999991</c:v>
                </c:pt>
                <c:pt idx="269">
                  <c:v>4.6229999999999993</c:v>
                </c:pt>
                <c:pt idx="270">
                  <c:v>4.6279999999999992</c:v>
                </c:pt>
                <c:pt idx="271">
                  <c:v>4.6339999999999995</c:v>
                </c:pt>
                <c:pt idx="272">
                  <c:v>4.6399999999999997</c:v>
                </c:pt>
                <c:pt idx="273">
                  <c:v>4.6449999999999987</c:v>
                </c:pt>
                <c:pt idx="274">
                  <c:v>4.6509999999999989</c:v>
                </c:pt>
                <c:pt idx="275">
                  <c:v>4.6569999999999991</c:v>
                </c:pt>
                <c:pt idx="276">
                  <c:v>4.6629999999999994</c:v>
                </c:pt>
                <c:pt idx="277">
                  <c:v>4.6679999999999993</c:v>
                </c:pt>
                <c:pt idx="278">
                  <c:v>4.6739999999999995</c:v>
                </c:pt>
                <c:pt idx="279">
                  <c:v>4.68</c:v>
                </c:pt>
                <c:pt idx="280">
                  <c:v>4.6859999999999991</c:v>
                </c:pt>
                <c:pt idx="281">
                  <c:v>4.6909999999999989</c:v>
                </c:pt>
                <c:pt idx="282">
                  <c:v>4.6969999999999992</c:v>
                </c:pt>
                <c:pt idx="283">
                  <c:v>4.7030000000000003</c:v>
                </c:pt>
                <c:pt idx="284">
                  <c:v>4.7080000000000002</c:v>
                </c:pt>
                <c:pt idx="285">
                  <c:v>4.7139999999999995</c:v>
                </c:pt>
                <c:pt idx="286">
                  <c:v>4.72</c:v>
                </c:pt>
                <c:pt idx="287">
                  <c:v>4.726</c:v>
                </c:pt>
                <c:pt idx="288">
                  <c:v>4.7309999999999999</c:v>
                </c:pt>
                <c:pt idx="289">
                  <c:v>4.7370000000000001</c:v>
                </c:pt>
                <c:pt idx="290">
                  <c:v>4.7430000000000003</c:v>
                </c:pt>
                <c:pt idx="291">
                  <c:v>4.7480000000000002</c:v>
                </c:pt>
                <c:pt idx="292">
                  <c:v>4.7539999999999996</c:v>
                </c:pt>
                <c:pt idx="293">
                  <c:v>4.76</c:v>
                </c:pt>
                <c:pt idx="294">
                  <c:v>4.766</c:v>
                </c:pt>
                <c:pt idx="295">
                  <c:v>4.7709999999999999</c:v>
                </c:pt>
                <c:pt idx="296">
                  <c:v>4.7770000000000001</c:v>
                </c:pt>
                <c:pt idx="297">
                  <c:v>4.7830000000000004</c:v>
                </c:pt>
                <c:pt idx="298">
                  <c:v>4.7880000000000003</c:v>
                </c:pt>
                <c:pt idx="299">
                  <c:v>4.7939999999999996</c:v>
                </c:pt>
                <c:pt idx="300">
                  <c:v>4.8</c:v>
                </c:pt>
                <c:pt idx="301">
                  <c:v>4.806</c:v>
                </c:pt>
                <c:pt idx="302">
                  <c:v>4.8109999999999991</c:v>
                </c:pt>
                <c:pt idx="303">
                  <c:v>4.8169999999999993</c:v>
                </c:pt>
                <c:pt idx="304">
                  <c:v>4.8229999999999995</c:v>
                </c:pt>
                <c:pt idx="305">
                  <c:v>4.8279999999999994</c:v>
                </c:pt>
                <c:pt idx="306">
                  <c:v>4.8339999999999996</c:v>
                </c:pt>
                <c:pt idx="307">
                  <c:v>4.84</c:v>
                </c:pt>
                <c:pt idx="308">
                  <c:v>4.8460000000000001</c:v>
                </c:pt>
                <c:pt idx="309">
                  <c:v>4.851</c:v>
                </c:pt>
                <c:pt idx="310">
                  <c:v>4.8569999999999993</c:v>
                </c:pt>
                <c:pt idx="311">
                  <c:v>4.8629999999999995</c:v>
                </c:pt>
                <c:pt idx="312">
                  <c:v>4.8679999999999994</c:v>
                </c:pt>
                <c:pt idx="313">
                  <c:v>4.8739999999999997</c:v>
                </c:pt>
                <c:pt idx="314">
                  <c:v>4.88</c:v>
                </c:pt>
                <c:pt idx="315">
                  <c:v>4.8860000000000001</c:v>
                </c:pt>
                <c:pt idx="316">
                  <c:v>4.891</c:v>
                </c:pt>
                <c:pt idx="317">
                  <c:v>4.8969999999999994</c:v>
                </c:pt>
                <c:pt idx="318">
                  <c:v>4.9029999999999996</c:v>
                </c:pt>
                <c:pt idx="319">
                  <c:v>4.9080000000000004</c:v>
                </c:pt>
                <c:pt idx="320">
                  <c:v>4.9139999999999997</c:v>
                </c:pt>
                <c:pt idx="321">
                  <c:v>4.92</c:v>
                </c:pt>
                <c:pt idx="322">
                  <c:v>4.9260000000000002</c:v>
                </c:pt>
                <c:pt idx="323">
                  <c:v>4.9310000000000009</c:v>
                </c:pt>
                <c:pt idx="324">
                  <c:v>4.9370000000000003</c:v>
                </c:pt>
                <c:pt idx="325">
                  <c:v>4.9429999999999996</c:v>
                </c:pt>
                <c:pt idx="326">
                  <c:v>4.9480000000000004</c:v>
                </c:pt>
                <c:pt idx="327">
                  <c:v>4.9539999999999997</c:v>
                </c:pt>
                <c:pt idx="328">
                  <c:v>4.96</c:v>
                </c:pt>
                <c:pt idx="329">
                  <c:v>4.9660000000000002</c:v>
                </c:pt>
                <c:pt idx="330">
                  <c:v>4.971000000000001</c:v>
                </c:pt>
                <c:pt idx="331">
                  <c:v>4.9770000000000003</c:v>
                </c:pt>
                <c:pt idx="332">
                  <c:v>4.9829999999999997</c:v>
                </c:pt>
                <c:pt idx="333">
                  <c:v>4.9880000000000004</c:v>
                </c:pt>
                <c:pt idx="334">
                  <c:v>4.9939999999999998</c:v>
                </c:pt>
                <c:pt idx="335">
                  <c:v>5</c:v>
                </c:pt>
                <c:pt idx="336">
                  <c:v>5.0060000000000002</c:v>
                </c:pt>
                <c:pt idx="337">
                  <c:v>5.0110000000000001</c:v>
                </c:pt>
                <c:pt idx="338">
                  <c:v>5.0169999999999995</c:v>
                </c:pt>
                <c:pt idx="339">
                  <c:v>5.0229999999999988</c:v>
                </c:pt>
                <c:pt idx="340">
                  <c:v>5.0279999999999987</c:v>
                </c:pt>
                <c:pt idx="341">
                  <c:v>5.0339999999999998</c:v>
                </c:pt>
                <c:pt idx="342">
                  <c:v>5.04</c:v>
                </c:pt>
                <c:pt idx="343">
                  <c:v>5.0460000000000003</c:v>
                </c:pt>
                <c:pt idx="344">
                  <c:v>5.0510000000000002</c:v>
                </c:pt>
                <c:pt idx="345">
                  <c:v>5.0569999999999995</c:v>
                </c:pt>
                <c:pt idx="346">
                  <c:v>5.0629999999999988</c:v>
                </c:pt>
                <c:pt idx="347">
                  <c:v>5.0679999999999987</c:v>
                </c:pt>
                <c:pt idx="348">
                  <c:v>5.0739999999999998</c:v>
                </c:pt>
                <c:pt idx="349">
                  <c:v>5.08</c:v>
                </c:pt>
                <c:pt idx="350">
                  <c:v>5.0860000000000003</c:v>
                </c:pt>
                <c:pt idx="351">
                  <c:v>5.0910000000000002</c:v>
                </c:pt>
                <c:pt idx="352">
                  <c:v>5.0969999999999995</c:v>
                </c:pt>
                <c:pt idx="353">
                  <c:v>5.1029999999999989</c:v>
                </c:pt>
                <c:pt idx="354">
                  <c:v>5.1079999999999988</c:v>
                </c:pt>
                <c:pt idx="355">
                  <c:v>5.113999999999999</c:v>
                </c:pt>
                <c:pt idx="356">
                  <c:v>5.1199999999999992</c:v>
                </c:pt>
                <c:pt idx="357">
                  <c:v>5.1259999999999994</c:v>
                </c:pt>
                <c:pt idx="358">
                  <c:v>5.1310000000000002</c:v>
                </c:pt>
                <c:pt idx="359">
                  <c:v>5.1369999999999996</c:v>
                </c:pt>
                <c:pt idx="360">
                  <c:v>5.1429999999999989</c:v>
                </c:pt>
                <c:pt idx="361">
                  <c:v>5.1479999999999988</c:v>
                </c:pt>
                <c:pt idx="362">
                  <c:v>5.153999999999999</c:v>
                </c:pt>
                <c:pt idx="363">
                  <c:v>5.1599999999999993</c:v>
                </c:pt>
                <c:pt idx="364">
                  <c:v>5.1659999999999995</c:v>
                </c:pt>
                <c:pt idx="365">
                  <c:v>5.1710000000000003</c:v>
                </c:pt>
                <c:pt idx="366">
                  <c:v>5.1769999999999996</c:v>
                </c:pt>
                <c:pt idx="367">
                  <c:v>5.1829999999999989</c:v>
                </c:pt>
                <c:pt idx="368">
                  <c:v>5.1879999999999988</c:v>
                </c:pt>
                <c:pt idx="369">
                  <c:v>5.1939999999999991</c:v>
                </c:pt>
                <c:pt idx="370">
                  <c:v>5.2</c:v>
                </c:pt>
                <c:pt idx="371">
                  <c:v>5.2060000000000004</c:v>
                </c:pt>
                <c:pt idx="372">
                  <c:v>5.2110000000000003</c:v>
                </c:pt>
                <c:pt idx="373">
                  <c:v>5.2169999999999996</c:v>
                </c:pt>
                <c:pt idx="374">
                  <c:v>5.222999999999999</c:v>
                </c:pt>
                <c:pt idx="375">
                  <c:v>5.2279999999999989</c:v>
                </c:pt>
                <c:pt idx="376">
                  <c:v>5.234</c:v>
                </c:pt>
                <c:pt idx="377">
                  <c:v>5.24</c:v>
                </c:pt>
                <c:pt idx="378">
                  <c:v>5.2460000000000004</c:v>
                </c:pt>
                <c:pt idx="379">
                  <c:v>5.2510000000000003</c:v>
                </c:pt>
                <c:pt idx="380">
                  <c:v>5.2569999999999997</c:v>
                </c:pt>
                <c:pt idx="381">
                  <c:v>5.262999999999999</c:v>
                </c:pt>
                <c:pt idx="382">
                  <c:v>5.2679999999999989</c:v>
                </c:pt>
                <c:pt idx="383">
                  <c:v>5.274</c:v>
                </c:pt>
                <c:pt idx="384">
                  <c:v>5.28</c:v>
                </c:pt>
                <c:pt idx="385">
                  <c:v>5.2859999999999996</c:v>
                </c:pt>
                <c:pt idx="386">
                  <c:v>5.2910000000000004</c:v>
                </c:pt>
                <c:pt idx="387">
                  <c:v>5.2969999999999997</c:v>
                </c:pt>
                <c:pt idx="388">
                  <c:v>5.302999999999999</c:v>
                </c:pt>
                <c:pt idx="389">
                  <c:v>5.3079999999999989</c:v>
                </c:pt>
                <c:pt idx="390">
                  <c:v>5.3139999999999992</c:v>
                </c:pt>
                <c:pt idx="391">
                  <c:v>5.3199999999999994</c:v>
                </c:pt>
                <c:pt idx="392">
                  <c:v>5.3259999999999987</c:v>
                </c:pt>
                <c:pt idx="393">
                  <c:v>5.3310000000000004</c:v>
                </c:pt>
                <c:pt idx="394">
                  <c:v>5.3369999999999997</c:v>
                </c:pt>
                <c:pt idx="395">
                  <c:v>5.343</c:v>
                </c:pt>
                <c:pt idx="396">
                  <c:v>5.347999999999999</c:v>
                </c:pt>
                <c:pt idx="397">
                  <c:v>5.3539999999999992</c:v>
                </c:pt>
                <c:pt idx="398">
                  <c:v>5.3599999999999994</c:v>
                </c:pt>
                <c:pt idx="399">
                  <c:v>5.3659999999999988</c:v>
                </c:pt>
                <c:pt idx="400">
                  <c:v>5.3710000000000004</c:v>
                </c:pt>
                <c:pt idx="401">
                  <c:v>5.3769999999999998</c:v>
                </c:pt>
                <c:pt idx="402">
                  <c:v>5.383</c:v>
                </c:pt>
                <c:pt idx="403">
                  <c:v>5.387999999999999</c:v>
                </c:pt>
                <c:pt idx="404">
                  <c:v>5.3939999999999992</c:v>
                </c:pt>
                <c:pt idx="405">
                  <c:v>5.4</c:v>
                </c:pt>
                <c:pt idx="406">
                  <c:v>5.4059999999999997</c:v>
                </c:pt>
                <c:pt idx="407">
                  <c:v>5.4109999999999996</c:v>
                </c:pt>
                <c:pt idx="408">
                  <c:v>5.4169999999999998</c:v>
                </c:pt>
                <c:pt idx="409">
                  <c:v>5.423</c:v>
                </c:pt>
                <c:pt idx="410">
                  <c:v>5.427999999999999</c:v>
                </c:pt>
                <c:pt idx="411">
                  <c:v>5.4340000000000002</c:v>
                </c:pt>
                <c:pt idx="412">
                  <c:v>5.44</c:v>
                </c:pt>
                <c:pt idx="413">
                  <c:v>5.4459999999999997</c:v>
                </c:pt>
                <c:pt idx="414">
                  <c:v>5.4509999999999996</c:v>
                </c:pt>
                <c:pt idx="415">
                  <c:v>5.4569999999999999</c:v>
                </c:pt>
                <c:pt idx="416">
                  <c:v>5.4630000000000001</c:v>
                </c:pt>
                <c:pt idx="417">
                  <c:v>5.4690000000000003</c:v>
                </c:pt>
                <c:pt idx="418">
                  <c:v>5.4740000000000002</c:v>
                </c:pt>
                <c:pt idx="419">
                  <c:v>5.48</c:v>
                </c:pt>
                <c:pt idx="420">
                  <c:v>5.4859999999999998</c:v>
                </c:pt>
                <c:pt idx="421">
                  <c:v>5.4909999999999997</c:v>
                </c:pt>
                <c:pt idx="422">
                  <c:v>5.4969999999999999</c:v>
                </c:pt>
                <c:pt idx="423">
                  <c:v>5.5030000000000001</c:v>
                </c:pt>
                <c:pt idx="424">
                  <c:v>5.5090000000000003</c:v>
                </c:pt>
                <c:pt idx="425">
                  <c:v>5.5139999999999993</c:v>
                </c:pt>
                <c:pt idx="426">
                  <c:v>5.52</c:v>
                </c:pt>
                <c:pt idx="427">
                  <c:v>5.5259999999999989</c:v>
                </c:pt>
                <c:pt idx="428">
                  <c:v>5.5309999999999997</c:v>
                </c:pt>
                <c:pt idx="429">
                  <c:v>5.5369999999999999</c:v>
                </c:pt>
                <c:pt idx="430">
                  <c:v>5.5430000000000001</c:v>
                </c:pt>
                <c:pt idx="431">
                  <c:v>5.5490000000000004</c:v>
                </c:pt>
                <c:pt idx="432">
                  <c:v>5.5539999999999994</c:v>
                </c:pt>
                <c:pt idx="433">
                  <c:v>5.56</c:v>
                </c:pt>
                <c:pt idx="434">
                  <c:v>5.5659999999999989</c:v>
                </c:pt>
                <c:pt idx="435">
                  <c:v>5.5709999999999997</c:v>
                </c:pt>
                <c:pt idx="436">
                  <c:v>5.577</c:v>
                </c:pt>
                <c:pt idx="437">
                  <c:v>5.5830000000000002</c:v>
                </c:pt>
                <c:pt idx="438">
                  <c:v>5.5890000000000004</c:v>
                </c:pt>
                <c:pt idx="439">
                  <c:v>5.5939999999999994</c:v>
                </c:pt>
                <c:pt idx="440">
                  <c:v>5.6</c:v>
                </c:pt>
                <c:pt idx="441">
                  <c:v>5.605999999999999</c:v>
                </c:pt>
                <c:pt idx="442">
                  <c:v>5.6109999999999989</c:v>
                </c:pt>
                <c:pt idx="443">
                  <c:v>5.6169999999999991</c:v>
                </c:pt>
                <c:pt idx="444">
                  <c:v>5.6229999999999993</c:v>
                </c:pt>
                <c:pt idx="445">
                  <c:v>5.6289999999999987</c:v>
                </c:pt>
                <c:pt idx="446">
                  <c:v>5.6339999999999995</c:v>
                </c:pt>
                <c:pt idx="447">
                  <c:v>5.64</c:v>
                </c:pt>
                <c:pt idx="448">
                  <c:v>5.645999999999999</c:v>
                </c:pt>
                <c:pt idx="449">
                  <c:v>5.6509999999999989</c:v>
                </c:pt>
                <c:pt idx="450">
                  <c:v>5.6569999999999991</c:v>
                </c:pt>
                <c:pt idx="451">
                  <c:v>5.6629999999999994</c:v>
                </c:pt>
                <c:pt idx="452">
                  <c:v>5.6689999999999987</c:v>
                </c:pt>
                <c:pt idx="453">
                  <c:v>5.6739999999999995</c:v>
                </c:pt>
                <c:pt idx="454">
                  <c:v>5.68</c:v>
                </c:pt>
                <c:pt idx="455">
                  <c:v>5.6859999999999991</c:v>
                </c:pt>
                <c:pt idx="456">
                  <c:v>5.6909999999999989</c:v>
                </c:pt>
                <c:pt idx="457">
                  <c:v>5.6969999999999992</c:v>
                </c:pt>
                <c:pt idx="458">
                  <c:v>5.7030000000000003</c:v>
                </c:pt>
                <c:pt idx="459">
                  <c:v>5.7089999999999996</c:v>
                </c:pt>
                <c:pt idx="460">
                  <c:v>5.7139999999999995</c:v>
                </c:pt>
                <c:pt idx="461">
                  <c:v>5.72</c:v>
                </c:pt>
                <c:pt idx="462">
                  <c:v>5.726</c:v>
                </c:pt>
                <c:pt idx="463">
                  <c:v>5.7309999999999999</c:v>
                </c:pt>
                <c:pt idx="464">
                  <c:v>5.7370000000000001</c:v>
                </c:pt>
                <c:pt idx="465">
                  <c:v>5.7430000000000003</c:v>
                </c:pt>
                <c:pt idx="466">
                  <c:v>5.7489999999999997</c:v>
                </c:pt>
                <c:pt idx="467">
                  <c:v>5.7539999999999996</c:v>
                </c:pt>
                <c:pt idx="468">
                  <c:v>5.76</c:v>
                </c:pt>
                <c:pt idx="469">
                  <c:v>5.766</c:v>
                </c:pt>
                <c:pt idx="470">
                  <c:v>5.7709999999999999</c:v>
                </c:pt>
                <c:pt idx="471">
                  <c:v>5.7770000000000001</c:v>
                </c:pt>
                <c:pt idx="472">
                  <c:v>5.7830000000000004</c:v>
                </c:pt>
                <c:pt idx="473">
                  <c:v>5.7889999999999997</c:v>
                </c:pt>
                <c:pt idx="474">
                  <c:v>5.7939999999999996</c:v>
                </c:pt>
                <c:pt idx="475">
                  <c:v>5.8</c:v>
                </c:pt>
                <c:pt idx="476">
                  <c:v>5.806</c:v>
                </c:pt>
                <c:pt idx="477">
                  <c:v>5.8109999999999991</c:v>
                </c:pt>
                <c:pt idx="478">
                  <c:v>5.8169999999999993</c:v>
                </c:pt>
                <c:pt idx="479">
                  <c:v>5.8229999999999995</c:v>
                </c:pt>
                <c:pt idx="480">
                  <c:v>5.8289999999999988</c:v>
                </c:pt>
                <c:pt idx="481">
                  <c:v>5.8339999999999996</c:v>
                </c:pt>
                <c:pt idx="482">
                  <c:v>5.84</c:v>
                </c:pt>
                <c:pt idx="483">
                  <c:v>5.8460000000000001</c:v>
                </c:pt>
                <c:pt idx="484">
                  <c:v>5.851</c:v>
                </c:pt>
                <c:pt idx="485">
                  <c:v>5.8569999999999993</c:v>
                </c:pt>
                <c:pt idx="486">
                  <c:v>5.8629999999999995</c:v>
                </c:pt>
                <c:pt idx="487">
                  <c:v>5.8689999999999989</c:v>
                </c:pt>
                <c:pt idx="488">
                  <c:v>5.8739999999999997</c:v>
                </c:pt>
                <c:pt idx="489">
                  <c:v>5.88</c:v>
                </c:pt>
                <c:pt idx="490">
                  <c:v>5.8860000000000001</c:v>
                </c:pt>
                <c:pt idx="491">
                  <c:v>5.891</c:v>
                </c:pt>
                <c:pt idx="492">
                  <c:v>5.8969999999999994</c:v>
                </c:pt>
                <c:pt idx="493">
                  <c:v>5.9029999999999996</c:v>
                </c:pt>
                <c:pt idx="494">
                  <c:v>5.9089999999999998</c:v>
                </c:pt>
                <c:pt idx="495">
                  <c:v>5.9139999999999997</c:v>
                </c:pt>
                <c:pt idx="496">
                  <c:v>5.92</c:v>
                </c:pt>
                <c:pt idx="497">
                  <c:v>5.9260000000000002</c:v>
                </c:pt>
                <c:pt idx="498">
                  <c:v>5.9310000000000009</c:v>
                </c:pt>
                <c:pt idx="499">
                  <c:v>5.9370000000000003</c:v>
                </c:pt>
                <c:pt idx="500">
                  <c:v>5.9429999999999996</c:v>
                </c:pt>
                <c:pt idx="501">
                  <c:v>5.9489999999999998</c:v>
                </c:pt>
                <c:pt idx="502">
                  <c:v>5.9539999999999997</c:v>
                </c:pt>
                <c:pt idx="503">
                  <c:v>5.96</c:v>
                </c:pt>
                <c:pt idx="504">
                  <c:v>5.9660000000000002</c:v>
                </c:pt>
                <c:pt idx="505">
                  <c:v>5.971000000000001</c:v>
                </c:pt>
                <c:pt idx="506">
                  <c:v>5.9770000000000003</c:v>
                </c:pt>
                <c:pt idx="507">
                  <c:v>5.9829999999999997</c:v>
                </c:pt>
                <c:pt idx="508">
                  <c:v>5.9889999999999999</c:v>
                </c:pt>
                <c:pt idx="509">
                  <c:v>5.9939999999999998</c:v>
                </c:pt>
                <c:pt idx="510">
                  <c:v>6</c:v>
                </c:pt>
                <c:pt idx="511">
                  <c:v>6.0060000000000002</c:v>
                </c:pt>
                <c:pt idx="512">
                  <c:v>6.0110000000000001</c:v>
                </c:pt>
                <c:pt idx="513">
                  <c:v>6.0169999999999995</c:v>
                </c:pt>
                <c:pt idx="514">
                  <c:v>6.0229999999999988</c:v>
                </c:pt>
                <c:pt idx="515">
                  <c:v>6.028999999999999</c:v>
                </c:pt>
                <c:pt idx="516">
                  <c:v>6.0339999999999998</c:v>
                </c:pt>
                <c:pt idx="517">
                  <c:v>6.04</c:v>
                </c:pt>
                <c:pt idx="518">
                  <c:v>6.0460000000000003</c:v>
                </c:pt>
                <c:pt idx="519">
                  <c:v>6.0510000000000002</c:v>
                </c:pt>
                <c:pt idx="520">
                  <c:v>6.0569999999999995</c:v>
                </c:pt>
                <c:pt idx="521">
                  <c:v>6.0629999999999988</c:v>
                </c:pt>
                <c:pt idx="522">
                  <c:v>6.069</c:v>
                </c:pt>
                <c:pt idx="523">
                  <c:v>6.0739999999999998</c:v>
                </c:pt>
                <c:pt idx="524">
                  <c:v>6.08</c:v>
                </c:pt>
                <c:pt idx="525">
                  <c:v>6.0860000000000003</c:v>
                </c:pt>
                <c:pt idx="526">
                  <c:v>6.0910000000000002</c:v>
                </c:pt>
                <c:pt idx="527">
                  <c:v>6.0969999999999995</c:v>
                </c:pt>
                <c:pt idx="528">
                  <c:v>6.1029999999999989</c:v>
                </c:pt>
                <c:pt idx="529">
                  <c:v>6.109</c:v>
                </c:pt>
                <c:pt idx="530">
                  <c:v>6.113999999999999</c:v>
                </c:pt>
                <c:pt idx="531">
                  <c:v>6.1199999999999992</c:v>
                </c:pt>
                <c:pt idx="532">
                  <c:v>6.1259999999999994</c:v>
                </c:pt>
                <c:pt idx="533">
                  <c:v>6.1310000000000002</c:v>
                </c:pt>
                <c:pt idx="534">
                  <c:v>6.1369999999999996</c:v>
                </c:pt>
                <c:pt idx="535">
                  <c:v>6.1429999999999989</c:v>
                </c:pt>
                <c:pt idx="536">
                  <c:v>6.149</c:v>
                </c:pt>
                <c:pt idx="537">
                  <c:v>6.153999999999999</c:v>
                </c:pt>
                <c:pt idx="538">
                  <c:v>6.1599999999999993</c:v>
                </c:pt>
                <c:pt idx="539">
                  <c:v>6.1659999999999995</c:v>
                </c:pt>
                <c:pt idx="540">
                  <c:v>6.1710000000000003</c:v>
                </c:pt>
                <c:pt idx="541">
                  <c:v>6.1769999999999996</c:v>
                </c:pt>
                <c:pt idx="542">
                  <c:v>6.1829999999999989</c:v>
                </c:pt>
                <c:pt idx="543">
                  <c:v>6.1890000000000001</c:v>
                </c:pt>
                <c:pt idx="544">
                  <c:v>6.1939999999999991</c:v>
                </c:pt>
                <c:pt idx="545">
                  <c:v>6.2</c:v>
                </c:pt>
                <c:pt idx="546">
                  <c:v>6.2060000000000004</c:v>
                </c:pt>
                <c:pt idx="547">
                  <c:v>6.2110000000000003</c:v>
                </c:pt>
                <c:pt idx="548">
                  <c:v>6.2169999999999996</c:v>
                </c:pt>
                <c:pt idx="549">
                  <c:v>6.222999999999999</c:v>
                </c:pt>
                <c:pt idx="550">
                  <c:v>6.2290000000000001</c:v>
                </c:pt>
                <c:pt idx="551">
                  <c:v>6.234</c:v>
                </c:pt>
                <c:pt idx="552">
                  <c:v>6.24</c:v>
                </c:pt>
                <c:pt idx="553">
                  <c:v>6.2460000000000004</c:v>
                </c:pt>
                <c:pt idx="554">
                  <c:v>6.2510000000000003</c:v>
                </c:pt>
                <c:pt idx="555">
                  <c:v>6.2569999999999997</c:v>
                </c:pt>
                <c:pt idx="556">
                  <c:v>6.262999999999999</c:v>
                </c:pt>
                <c:pt idx="557">
                  <c:v>6.2690000000000001</c:v>
                </c:pt>
                <c:pt idx="558">
                  <c:v>6.274</c:v>
                </c:pt>
                <c:pt idx="559">
                  <c:v>6.28</c:v>
                </c:pt>
                <c:pt idx="560">
                  <c:v>6.2859999999999996</c:v>
                </c:pt>
                <c:pt idx="561">
                  <c:v>6.2919999999999998</c:v>
                </c:pt>
                <c:pt idx="562">
                  <c:v>6.2969999999999997</c:v>
                </c:pt>
                <c:pt idx="563">
                  <c:v>6.302999999999999</c:v>
                </c:pt>
                <c:pt idx="564">
                  <c:v>6.3090000000000002</c:v>
                </c:pt>
                <c:pt idx="565">
                  <c:v>6.3139999999999992</c:v>
                </c:pt>
                <c:pt idx="566">
                  <c:v>6.3199999999999994</c:v>
                </c:pt>
                <c:pt idx="567">
                  <c:v>6.3259999999999987</c:v>
                </c:pt>
                <c:pt idx="568">
                  <c:v>6.3319999999999999</c:v>
                </c:pt>
                <c:pt idx="569">
                  <c:v>6.3369999999999997</c:v>
                </c:pt>
                <c:pt idx="570">
                  <c:v>6.343</c:v>
                </c:pt>
                <c:pt idx="571">
                  <c:v>6.3490000000000002</c:v>
                </c:pt>
                <c:pt idx="572">
                  <c:v>6.3539999999999992</c:v>
                </c:pt>
                <c:pt idx="573">
                  <c:v>6.3599999999999994</c:v>
                </c:pt>
                <c:pt idx="574">
                  <c:v>6.3659999999999988</c:v>
                </c:pt>
                <c:pt idx="575">
                  <c:v>6.3719999999999999</c:v>
                </c:pt>
                <c:pt idx="576">
                  <c:v>6.3769999999999998</c:v>
                </c:pt>
                <c:pt idx="577">
                  <c:v>6.383</c:v>
                </c:pt>
                <c:pt idx="578">
                  <c:v>6.3890000000000002</c:v>
                </c:pt>
                <c:pt idx="579">
                  <c:v>6.3939999999999992</c:v>
                </c:pt>
                <c:pt idx="580">
                  <c:v>6.4</c:v>
                </c:pt>
                <c:pt idx="581">
                  <c:v>6.4059999999999997</c:v>
                </c:pt>
                <c:pt idx="582">
                  <c:v>6.4119999999999999</c:v>
                </c:pt>
                <c:pt idx="583">
                  <c:v>6.4169999999999998</c:v>
                </c:pt>
                <c:pt idx="584">
                  <c:v>6.423</c:v>
                </c:pt>
                <c:pt idx="585">
                  <c:v>6.4290000000000003</c:v>
                </c:pt>
                <c:pt idx="586">
                  <c:v>6.4340000000000002</c:v>
                </c:pt>
                <c:pt idx="587">
                  <c:v>6.44</c:v>
                </c:pt>
                <c:pt idx="588">
                  <c:v>6.4459999999999997</c:v>
                </c:pt>
                <c:pt idx="589">
                  <c:v>6.452</c:v>
                </c:pt>
                <c:pt idx="590">
                  <c:v>6.4569999999999999</c:v>
                </c:pt>
                <c:pt idx="591">
                  <c:v>6.4630000000000001</c:v>
                </c:pt>
                <c:pt idx="592">
                  <c:v>6.4690000000000003</c:v>
                </c:pt>
                <c:pt idx="593">
                  <c:v>6.4740000000000002</c:v>
                </c:pt>
                <c:pt idx="594">
                  <c:v>6.48</c:v>
                </c:pt>
                <c:pt idx="595">
                  <c:v>6.4859999999999998</c:v>
                </c:pt>
                <c:pt idx="596">
                  <c:v>6.492</c:v>
                </c:pt>
                <c:pt idx="597">
                  <c:v>6.4969999999999999</c:v>
                </c:pt>
                <c:pt idx="598">
                  <c:v>6.5030000000000001</c:v>
                </c:pt>
                <c:pt idx="599">
                  <c:v>6.5090000000000003</c:v>
                </c:pt>
                <c:pt idx="600">
                  <c:v>6.5139999999999993</c:v>
                </c:pt>
                <c:pt idx="601">
                  <c:v>6.52</c:v>
                </c:pt>
                <c:pt idx="602">
                  <c:v>6.5259999999999989</c:v>
                </c:pt>
                <c:pt idx="603">
                  <c:v>6.532</c:v>
                </c:pt>
                <c:pt idx="604">
                  <c:v>6.5369999999999999</c:v>
                </c:pt>
                <c:pt idx="605">
                  <c:v>6.5430000000000001</c:v>
                </c:pt>
                <c:pt idx="606">
                  <c:v>6.5490000000000004</c:v>
                </c:pt>
                <c:pt idx="607">
                  <c:v>6.5539999999999994</c:v>
                </c:pt>
                <c:pt idx="608">
                  <c:v>6.56</c:v>
                </c:pt>
                <c:pt idx="609">
                  <c:v>6.5659999999999989</c:v>
                </c:pt>
                <c:pt idx="610">
                  <c:v>6.5720000000000001</c:v>
                </c:pt>
                <c:pt idx="611">
                  <c:v>6.577</c:v>
                </c:pt>
                <c:pt idx="612">
                  <c:v>6.5830000000000002</c:v>
                </c:pt>
                <c:pt idx="613">
                  <c:v>6.5890000000000004</c:v>
                </c:pt>
                <c:pt idx="614">
                  <c:v>6.5939999999999994</c:v>
                </c:pt>
                <c:pt idx="615">
                  <c:v>6.6</c:v>
                </c:pt>
                <c:pt idx="616">
                  <c:v>6.605999999999999</c:v>
                </c:pt>
                <c:pt idx="617">
                  <c:v>6.6119999999999992</c:v>
                </c:pt>
                <c:pt idx="618">
                  <c:v>6.6169999999999991</c:v>
                </c:pt>
                <c:pt idx="619">
                  <c:v>6.6229999999999993</c:v>
                </c:pt>
                <c:pt idx="620">
                  <c:v>6.6289999999999987</c:v>
                </c:pt>
                <c:pt idx="621">
                  <c:v>6.6339999999999995</c:v>
                </c:pt>
                <c:pt idx="622">
                  <c:v>6.64</c:v>
                </c:pt>
                <c:pt idx="623">
                  <c:v>6.645999999999999</c:v>
                </c:pt>
                <c:pt idx="624">
                  <c:v>6.6519999999999992</c:v>
                </c:pt>
                <c:pt idx="625">
                  <c:v>6.6569999999999991</c:v>
                </c:pt>
                <c:pt idx="626">
                  <c:v>6.6629999999999994</c:v>
                </c:pt>
                <c:pt idx="627">
                  <c:v>6.6689999999999987</c:v>
                </c:pt>
                <c:pt idx="628">
                  <c:v>6.6739999999999995</c:v>
                </c:pt>
                <c:pt idx="629">
                  <c:v>6.68</c:v>
                </c:pt>
                <c:pt idx="630">
                  <c:v>6.6859999999999991</c:v>
                </c:pt>
                <c:pt idx="631">
                  <c:v>6.6919999999999993</c:v>
                </c:pt>
                <c:pt idx="632">
                  <c:v>6.6969999999999992</c:v>
                </c:pt>
                <c:pt idx="633">
                  <c:v>6.7030000000000003</c:v>
                </c:pt>
                <c:pt idx="634">
                  <c:v>6.7089999999999996</c:v>
                </c:pt>
                <c:pt idx="635">
                  <c:v>6.7139999999999995</c:v>
                </c:pt>
                <c:pt idx="636">
                  <c:v>6.72</c:v>
                </c:pt>
                <c:pt idx="637">
                  <c:v>6.726</c:v>
                </c:pt>
                <c:pt idx="638">
                  <c:v>6.7320000000000002</c:v>
                </c:pt>
                <c:pt idx="639">
                  <c:v>6.7370000000000001</c:v>
                </c:pt>
                <c:pt idx="640">
                  <c:v>6.7430000000000003</c:v>
                </c:pt>
                <c:pt idx="641">
                  <c:v>6.7489999999999997</c:v>
                </c:pt>
                <c:pt idx="642">
                  <c:v>6.7539999999999996</c:v>
                </c:pt>
                <c:pt idx="643">
                  <c:v>6.76</c:v>
                </c:pt>
                <c:pt idx="644">
                  <c:v>6.766</c:v>
                </c:pt>
                <c:pt idx="645">
                  <c:v>6.7720000000000002</c:v>
                </c:pt>
                <c:pt idx="646">
                  <c:v>6.7770000000000001</c:v>
                </c:pt>
                <c:pt idx="647">
                  <c:v>6.7830000000000004</c:v>
                </c:pt>
                <c:pt idx="648">
                  <c:v>6.7889999999999997</c:v>
                </c:pt>
                <c:pt idx="649">
                  <c:v>6.7939999999999996</c:v>
                </c:pt>
                <c:pt idx="650">
                  <c:v>6.8</c:v>
                </c:pt>
                <c:pt idx="651">
                  <c:v>6.806</c:v>
                </c:pt>
                <c:pt idx="652">
                  <c:v>6.8119999999999994</c:v>
                </c:pt>
                <c:pt idx="653">
                  <c:v>6.8169999999999993</c:v>
                </c:pt>
                <c:pt idx="654">
                  <c:v>6.8229999999999995</c:v>
                </c:pt>
                <c:pt idx="655">
                  <c:v>6.8289999999999988</c:v>
                </c:pt>
                <c:pt idx="656">
                  <c:v>6.8339999999999996</c:v>
                </c:pt>
                <c:pt idx="657">
                  <c:v>6.84</c:v>
                </c:pt>
                <c:pt idx="658">
                  <c:v>6.8460000000000001</c:v>
                </c:pt>
                <c:pt idx="659">
                  <c:v>6.8519999999999994</c:v>
                </c:pt>
                <c:pt idx="660">
                  <c:v>6.8569999999999993</c:v>
                </c:pt>
                <c:pt idx="661">
                  <c:v>6.8629999999999995</c:v>
                </c:pt>
                <c:pt idx="662">
                  <c:v>6.8689999999999989</c:v>
                </c:pt>
                <c:pt idx="663">
                  <c:v>6.8739999999999997</c:v>
                </c:pt>
                <c:pt idx="664">
                  <c:v>6.88</c:v>
                </c:pt>
                <c:pt idx="665">
                  <c:v>6.8860000000000001</c:v>
                </c:pt>
                <c:pt idx="666">
                  <c:v>6.8919999999999995</c:v>
                </c:pt>
                <c:pt idx="667">
                  <c:v>6.8969999999999994</c:v>
                </c:pt>
                <c:pt idx="668">
                  <c:v>6.9029999999999996</c:v>
                </c:pt>
                <c:pt idx="669">
                  <c:v>6.9089999999999998</c:v>
                </c:pt>
                <c:pt idx="670">
                  <c:v>6.9139999999999997</c:v>
                </c:pt>
                <c:pt idx="671">
                  <c:v>6.92</c:v>
                </c:pt>
                <c:pt idx="672">
                  <c:v>6.9260000000000002</c:v>
                </c:pt>
                <c:pt idx="673">
                  <c:v>6.9320000000000004</c:v>
                </c:pt>
                <c:pt idx="674">
                  <c:v>6.9370000000000003</c:v>
                </c:pt>
                <c:pt idx="675">
                  <c:v>6.9429999999999996</c:v>
                </c:pt>
                <c:pt idx="676">
                  <c:v>6.9489999999999998</c:v>
                </c:pt>
                <c:pt idx="677">
                  <c:v>6.9539999999999997</c:v>
                </c:pt>
                <c:pt idx="678">
                  <c:v>6.96</c:v>
                </c:pt>
                <c:pt idx="679">
                  <c:v>6.9660000000000002</c:v>
                </c:pt>
                <c:pt idx="680">
                  <c:v>6.9720000000000004</c:v>
                </c:pt>
                <c:pt idx="681">
                  <c:v>6.9770000000000003</c:v>
                </c:pt>
                <c:pt idx="682">
                  <c:v>6.9829999999999997</c:v>
                </c:pt>
                <c:pt idx="683">
                  <c:v>6.9889999999999999</c:v>
                </c:pt>
                <c:pt idx="684">
                  <c:v>6.9939999999999998</c:v>
                </c:pt>
                <c:pt idx="685">
                  <c:v>7</c:v>
                </c:pt>
                <c:pt idx="686">
                  <c:v>7.0060000000000002</c:v>
                </c:pt>
                <c:pt idx="687">
                  <c:v>7.0119999999999996</c:v>
                </c:pt>
                <c:pt idx="688">
                  <c:v>7.0169999999999995</c:v>
                </c:pt>
                <c:pt idx="689">
                  <c:v>7.0229999999999988</c:v>
                </c:pt>
                <c:pt idx="690">
                  <c:v>7.028999999999999</c:v>
                </c:pt>
                <c:pt idx="691">
                  <c:v>7.0339999999999998</c:v>
                </c:pt>
                <c:pt idx="692">
                  <c:v>7.04</c:v>
                </c:pt>
                <c:pt idx="693">
                  <c:v>7.0460000000000003</c:v>
                </c:pt>
                <c:pt idx="694">
                  <c:v>7.0519999999999996</c:v>
                </c:pt>
                <c:pt idx="695">
                  <c:v>7.0569999999999995</c:v>
                </c:pt>
                <c:pt idx="696">
                  <c:v>7.0629999999999988</c:v>
                </c:pt>
                <c:pt idx="697">
                  <c:v>7.069</c:v>
                </c:pt>
                <c:pt idx="698">
                  <c:v>7.0750000000000002</c:v>
                </c:pt>
                <c:pt idx="699">
                  <c:v>7.08</c:v>
                </c:pt>
                <c:pt idx="700">
                  <c:v>7.0860000000000003</c:v>
                </c:pt>
                <c:pt idx="701">
                  <c:v>7.0919999999999996</c:v>
                </c:pt>
                <c:pt idx="702">
                  <c:v>7.0969999999999995</c:v>
                </c:pt>
                <c:pt idx="703">
                  <c:v>7.1029999999999989</c:v>
                </c:pt>
                <c:pt idx="704">
                  <c:v>7.109</c:v>
                </c:pt>
                <c:pt idx="705">
                  <c:v>7.1149999999999993</c:v>
                </c:pt>
                <c:pt idx="706">
                  <c:v>7.1199999999999992</c:v>
                </c:pt>
                <c:pt idx="707">
                  <c:v>7.1259999999999994</c:v>
                </c:pt>
                <c:pt idx="708">
                  <c:v>7.1319999999999997</c:v>
                </c:pt>
                <c:pt idx="709">
                  <c:v>7.1369999999999996</c:v>
                </c:pt>
                <c:pt idx="710">
                  <c:v>7.1429999999999989</c:v>
                </c:pt>
                <c:pt idx="711">
                  <c:v>7.149</c:v>
                </c:pt>
                <c:pt idx="712">
                  <c:v>7.1549999999999994</c:v>
                </c:pt>
                <c:pt idx="713">
                  <c:v>7.1599999999999993</c:v>
                </c:pt>
                <c:pt idx="714">
                  <c:v>7.1659999999999995</c:v>
                </c:pt>
                <c:pt idx="715">
                  <c:v>7.1719999999999997</c:v>
                </c:pt>
                <c:pt idx="716">
                  <c:v>7.1769999999999996</c:v>
                </c:pt>
                <c:pt idx="717">
                  <c:v>7.1829999999999989</c:v>
                </c:pt>
                <c:pt idx="718">
                  <c:v>7.1890000000000001</c:v>
                </c:pt>
                <c:pt idx="719">
                  <c:v>7.1949999999999994</c:v>
                </c:pt>
                <c:pt idx="720">
                  <c:v>7.2</c:v>
                </c:pt>
                <c:pt idx="721">
                  <c:v>7.2060000000000004</c:v>
                </c:pt>
                <c:pt idx="722">
                  <c:v>7.2119999999999997</c:v>
                </c:pt>
                <c:pt idx="723">
                  <c:v>7.2169999999999996</c:v>
                </c:pt>
                <c:pt idx="724">
                  <c:v>7.222999999999999</c:v>
                </c:pt>
                <c:pt idx="725">
                  <c:v>7.2290000000000001</c:v>
                </c:pt>
                <c:pt idx="726">
                  <c:v>7.2350000000000003</c:v>
                </c:pt>
                <c:pt idx="727">
                  <c:v>7.24</c:v>
                </c:pt>
                <c:pt idx="728">
                  <c:v>7.2460000000000004</c:v>
                </c:pt>
                <c:pt idx="729">
                  <c:v>7.2519999999999998</c:v>
                </c:pt>
                <c:pt idx="730">
                  <c:v>7.2569999999999997</c:v>
                </c:pt>
                <c:pt idx="731">
                  <c:v>7.262999999999999</c:v>
                </c:pt>
                <c:pt idx="732">
                  <c:v>7.2690000000000001</c:v>
                </c:pt>
                <c:pt idx="733">
                  <c:v>7.2750000000000004</c:v>
                </c:pt>
                <c:pt idx="734">
                  <c:v>7.28</c:v>
                </c:pt>
                <c:pt idx="735">
                  <c:v>7.2859999999999996</c:v>
                </c:pt>
                <c:pt idx="736">
                  <c:v>7.2919999999999998</c:v>
                </c:pt>
                <c:pt idx="737">
                  <c:v>7.2969999999999997</c:v>
                </c:pt>
                <c:pt idx="738">
                  <c:v>7.302999999999999</c:v>
                </c:pt>
                <c:pt idx="739">
                  <c:v>7.3090000000000002</c:v>
                </c:pt>
                <c:pt idx="740">
                  <c:v>7.3149999999999995</c:v>
                </c:pt>
                <c:pt idx="741">
                  <c:v>7.3199999999999994</c:v>
                </c:pt>
                <c:pt idx="742">
                  <c:v>7.3259999999999987</c:v>
                </c:pt>
                <c:pt idx="743">
                  <c:v>7.3319999999999999</c:v>
                </c:pt>
                <c:pt idx="744">
                  <c:v>7.3369999999999997</c:v>
                </c:pt>
                <c:pt idx="745">
                  <c:v>7.343</c:v>
                </c:pt>
                <c:pt idx="746">
                  <c:v>7.3490000000000002</c:v>
                </c:pt>
                <c:pt idx="747">
                  <c:v>7.3549999999999995</c:v>
                </c:pt>
                <c:pt idx="748">
                  <c:v>7.3599999999999994</c:v>
                </c:pt>
                <c:pt idx="749">
                  <c:v>7.3659999999999988</c:v>
                </c:pt>
                <c:pt idx="750">
                  <c:v>7.3719999999999999</c:v>
                </c:pt>
                <c:pt idx="751">
                  <c:v>7.3769999999999998</c:v>
                </c:pt>
                <c:pt idx="752">
                  <c:v>7.383</c:v>
                </c:pt>
                <c:pt idx="753">
                  <c:v>7.3890000000000002</c:v>
                </c:pt>
                <c:pt idx="754">
                  <c:v>7.3949999999999987</c:v>
                </c:pt>
                <c:pt idx="755">
                  <c:v>7.4</c:v>
                </c:pt>
                <c:pt idx="756">
                  <c:v>7.4059999999999997</c:v>
                </c:pt>
                <c:pt idx="757">
                  <c:v>7.4119999999999999</c:v>
                </c:pt>
                <c:pt idx="758">
                  <c:v>7.4169999999999998</c:v>
                </c:pt>
                <c:pt idx="759">
                  <c:v>7.423</c:v>
                </c:pt>
                <c:pt idx="760">
                  <c:v>7.4290000000000003</c:v>
                </c:pt>
                <c:pt idx="761">
                  <c:v>7.4349999999999996</c:v>
                </c:pt>
                <c:pt idx="762">
                  <c:v>7.44</c:v>
                </c:pt>
                <c:pt idx="763">
                  <c:v>7.4459999999999997</c:v>
                </c:pt>
                <c:pt idx="764">
                  <c:v>7.452</c:v>
                </c:pt>
                <c:pt idx="765">
                  <c:v>7.4569999999999999</c:v>
                </c:pt>
                <c:pt idx="766">
                  <c:v>7.4630000000000001</c:v>
                </c:pt>
                <c:pt idx="767">
                  <c:v>7.4690000000000003</c:v>
                </c:pt>
                <c:pt idx="768">
                  <c:v>7.4749999999999996</c:v>
                </c:pt>
                <c:pt idx="769">
                  <c:v>7.48</c:v>
                </c:pt>
                <c:pt idx="770">
                  <c:v>7.4859999999999998</c:v>
                </c:pt>
                <c:pt idx="771">
                  <c:v>7.492</c:v>
                </c:pt>
                <c:pt idx="772">
                  <c:v>7.4969999999999999</c:v>
                </c:pt>
                <c:pt idx="773">
                  <c:v>7.5030000000000001</c:v>
                </c:pt>
                <c:pt idx="774">
                  <c:v>7.5090000000000003</c:v>
                </c:pt>
                <c:pt idx="775">
                  <c:v>7.5149999999999988</c:v>
                </c:pt>
                <c:pt idx="776">
                  <c:v>7.52</c:v>
                </c:pt>
                <c:pt idx="777">
                  <c:v>7.5259999999999989</c:v>
                </c:pt>
                <c:pt idx="778">
                  <c:v>7.532</c:v>
                </c:pt>
                <c:pt idx="779">
                  <c:v>7.5369999999999999</c:v>
                </c:pt>
                <c:pt idx="780">
                  <c:v>7.5430000000000001</c:v>
                </c:pt>
                <c:pt idx="781">
                  <c:v>7.5490000000000004</c:v>
                </c:pt>
                <c:pt idx="782">
                  <c:v>7.5549999999999988</c:v>
                </c:pt>
                <c:pt idx="783">
                  <c:v>7.56</c:v>
                </c:pt>
                <c:pt idx="784">
                  <c:v>7.5659999999999989</c:v>
                </c:pt>
                <c:pt idx="785">
                  <c:v>7.5720000000000001</c:v>
                </c:pt>
                <c:pt idx="786">
                  <c:v>7.577</c:v>
                </c:pt>
                <c:pt idx="787">
                  <c:v>7.5830000000000002</c:v>
                </c:pt>
                <c:pt idx="788">
                  <c:v>7.5890000000000004</c:v>
                </c:pt>
                <c:pt idx="789">
                  <c:v>7.5949999999999989</c:v>
                </c:pt>
                <c:pt idx="790">
                  <c:v>7.6</c:v>
                </c:pt>
                <c:pt idx="791">
                  <c:v>7.605999999999999</c:v>
                </c:pt>
                <c:pt idx="792">
                  <c:v>7.6119999999999992</c:v>
                </c:pt>
                <c:pt idx="793">
                  <c:v>7.6169999999999991</c:v>
                </c:pt>
                <c:pt idx="794">
                  <c:v>7.6229999999999993</c:v>
                </c:pt>
                <c:pt idx="795">
                  <c:v>7.6289999999999987</c:v>
                </c:pt>
                <c:pt idx="796">
                  <c:v>7.6349999999999989</c:v>
                </c:pt>
                <c:pt idx="797">
                  <c:v>7.64</c:v>
                </c:pt>
                <c:pt idx="798">
                  <c:v>7.645999999999999</c:v>
                </c:pt>
                <c:pt idx="799">
                  <c:v>7.6519999999999992</c:v>
                </c:pt>
                <c:pt idx="800">
                  <c:v>7.6569999999999991</c:v>
                </c:pt>
                <c:pt idx="801">
                  <c:v>7.6629999999999994</c:v>
                </c:pt>
                <c:pt idx="802">
                  <c:v>7.6689999999999987</c:v>
                </c:pt>
                <c:pt idx="803">
                  <c:v>7.6749999999999989</c:v>
                </c:pt>
                <c:pt idx="804">
                  <c:v>7.68</c:v>
                </c:pt>
                <c:pt idx="805">
                  <c:v>7.6859999999999991</c:v>
                </c:pt>
                <c:pt idx="806">
                  <c:v>7.6919999999999993</c:v>
                </c:pt>
                <c:pt idx="807">
                  <c:v>7.6969999999999992</c:v>
                </c:pt>
                <c:pt idx="808">
                  <c:v>7.7030000000000003</c:v>
                </c:pt>
                <c:pt idx="809">
                  <c:v>7.7089999999999996</c:v>
                </c:pt>
                <c:pt idx="810">
                  <c:v>7.714999999999999</c:v>
                </c:pt>
                <c:pt idx="811">
                  <c:v>7.72</c:v>
                </c:pt>
                <c:pt idx="812">
                  <c:v>7.726</c:v>
                </c:pt>
                <c:pt idx="813">
                  <c:v>7.7320000000000002</c:v>
                </c:pt>
                <c:pt idx="814">
                  <c:v>7.7370000000000001</c:v>
                </c:pt>
                <c:pt idx="815">
                  <c:v>7.7430000000000003</c:v>
                </c:pt>
                <c:pt idx="816">
                  <c:v>7.7489999999999997</c:v>
                </c:pt>
                <c:pt idx="817">
                  <c:v>7.754999999999999</c:v>
                </c:pt>
                <c:pt idx="818">
                  <c:v>7.76</c:v>
                </c:pt>
                <c:pt idx="819">
                  <c:v>7.766</c:v>
                </c:pt>
                <c:pt idx="820">
                  <c:v>7.7720000000000002</c:v>
                </c:pt>
                <c:pt idx="821">
                  <c:v>7.7770000000000001</c:v>
                </c:pt>
                <c:pt idx="822">
                  <c:v>7.7830000000000004</c:v>
                </c:pt>
                <c:pt idx="823">
                  <c:v>7.7889999999999997</c:v>
                </c:pt>
                <c:pt idx="824">
                  <c:v>7.794999999999999</c:v>
                </c:pt>
                <c:pt idx="825">
                  <c:v>7.8</c:v>
                </c:pt>
                <c:pt idx="826">
                  <c:v>7.806</c:v>
                </c:pt>
                <c:pt idx="827">
                  <c:v>7.8119999999999994</c:v>
                </c:pt>
                <c:pt idx="828">
                  <c:v>7.8169999999999993</c:v>
                </c:pt>
                <c:pt idx="829">
                  <c:v>7.8229999999999995</c:v>
                </c:pt>
                <c:pt idx="830">
                  <c:v>7.8289999999999988</c:v>
                </c:pt>
                <c:pt idx="831">
                  <c:v>7.835</c:v>
                </c:pt>
                <c:pt idx="832">
                  <c:v>7.84</c:v>
                </c:pt>
                <c:pt idx="833">
                  <c:v>7.8460000000000001</c:v>
                </c:pt>
                <c:pt idx="834">
                  <c:v>7.8519999999999994</c:v>
                </c:pt>
                <c:pt idx="835">
                  <c:v>7.8579999999999988</c:v>
                </c:pt>
                <c:pt idx="836">
                  <c:v>7.8629999999999995</c:v>
                </c:pt>
                <c:pt idx="837">
                  <c:v>7.8689999999999989</c:v>
                </c:pt>
                <c:pt idx="838">
                  <c:v>7.875</c:v>
                </c:pt>
                <c:pt idx="839">
                  <c:v>7.88</c:v>
                </c:pt>
                <c:pt idx="840">
                  <c:v>7.8860000000000001</c:v>
                </c:pt>
                <c:pt idx="841">
                  <c:v>7.8919999999999995</c:v>
                </c:pt>
                <c:pt idx="842">
                  <c:v>7.8979999999999988</c:v>
                </c:pt>
                <c:pt idx="843">
                  <c:v>7.9029999999999996</c:v>
                </c:pt>
                <c:pt idx="844">
                  <c:v>7.9089999999999998</c:v>
                </c:pt>
                <c:pt idx="845">
                  <c:v>7.915</c:v>
                </c:pt>
                <c:pt idx="846">
                  <c:v>7.92</c:v>
                </c:pt>
                <c:pt idx="847">
                  <c:v>7.9260000000000002</c:v>
                </c:pt>
                <c:pt idx="848">
                  <c:v>7.9320000000000004</c:v>
                </c:pt>
                <c:pt idx="849">
                  <c:v>7.9379999999999997</c:v>
                </c:pt>
                <c:pt idx="850">
                  <c:v>7.9429999999999996</c:v>
                </c:pt>
                <c:pt idx="851">
                  <c:v>7.9489999999999998</c:v>
                </c:pt>
                <c:pt idx="852">
                  <c:v>7.9550000000000001</c:v>
                </c:pt>
                <c:pt idx="853">
                  <c:v>7.96</c:v>
                </c:pt>
                <c:pt idx="854">
                  <c:v>7.9660000000000002</c:v>
                </c:pt>
                <c:pt idx="855">
                  <c:v>7.9720000000000004</c:v>
                </c:pt>
                <c:pt idx="856">
                  <c:v>7.9779999999999998</c:v>
                </c:pt>
                <c:pt idx="857">
                  <c:v>7.9829999999999997</c:v>
                </c:pt>
                <c:pt idx="858">
                  <c:v>7.9889999999999999</c:v>
                </c:pt>
                <c:pt idx="859">
                  <c:v>7.9950000000000001</c:v>
                </c:pt>
                <c:pt idx="860">
                  <c:v>8</c:v>
                </c:pt>
                <c:pt idx="861">
                  <c:v>8.0060000000000002</c:v>
                </c:pt>
                <c:pt idx="862">
                  <c:v>8.0120000000000005</c:v>
                </c:pt>
                <c:pt idx="863">
                  <c:v>8.0179999999999989</c:v>
                </c:pt>
                <c:pt idx="864">
                  <c:v>8.0230000000000015</c:v>
                </c:pt>
                <c:pt idx="865">
                  <c:v>8.0290000000000017</c:v>
                </c:pt>
                <c:pt idx="866">
                  <c:v>8.0350000000000001</c:v>
                </c:pt>
                <c:pt idx="867">
                  <c:v>8.0400000000000009</c:v>
                </c:pt>
                <c:pt idx="868">
                  <c:v>8.0460000000000012</c:v>
                </c:pt>
                <c:pt idx="869">
                  <c:v>8.0520000000000014</c:v>
                </c:pt>
                <c:pt idx="870">
                  <c:v>8.0580000000000016</c:v>
                </c:pt>
                <c:pt idx="871">
                  <c:v>8.0630000000000006</c:v>
                </c:pt>
                <c:pt idx="872">
                  <c:v>8.0690000000000008</c:v>
                </c:pt>
                <c:pt idx="873">
                  <c:v>8.0750000000000011</c:v>
                </c:pt>
                <c:pt idx="874">
                  <c:v>8.08</c:v>
                </c:pt>
                <c:pt idx="875">
                  <c:v>8.0860000000000003</c:v>
                </c:pt>
                <c:pt idx="876">
                  <c:v>8.0920000000000005</c:v>
                </c:pt>
                <c:pt idx="877">
                  <c:v>8.097999999999999</c:v>
                </c:pt>
                <c:pt idx="878">
                  <c:v>8.1030000000000015</c:v>
                </c:pt>
                <c:pt idx="879">
                  <c:v>8.109</c:v>
                </c:pt>
                <c:pt idx="880">
                  <c:v>8.1150000000000002</c:v>
                </c:pt>
                <c:pt idx="881">
                  <c:v>8.120000000000001</c:v>
                </c:pt>
                <c:pt idx="882">
                  <c:v>8.1260000000000012</c:v>
                </c:pt>
                <c:pt idx="883">
                  <c:v>8.1319999999999997</c:v>
                </c:pt>
                <c:pt idx="884">
                  <c:v>8.1380000000000017</c:v>
                </c:pt>
                <c:pt idx="885">
                  <c:v>8.1429999999999989</c:v>
                </c:pt>
                <c:pt idx="886">
                  <c:v>8.1489999999999991</c:v>
                </c:pt>
                <c:pt idx="887">
                  <c:v>8.1550000000000011</c:v>
                </c:pt>
                <c:pt idx="888">
                  <c:v>8.16</c:v>
                </c:pt>
                <c:pt idx="889">
                  <c:v>8.1660000000000004</c:v>
                </c:pt>
                <c:pt idx="890">
                  <c:v>8.1720000000000006</c:v>
                </c:pt>
                <c:pt idx="891">
                  <c:v>8.177999999999999</c:v>
                </c:pt>
                <c:pt idx="892">
                  <c:v>8.1830000000000016</c:v>
                </c:pt>
                <c:pt idx="893">
                  <c:v>8.1890000000000001</c:v>
                </c:pt>
                <c:pt idx="894">
                  <c:v>8.1950000000000003</c:v>
                </c:pt>
                <c:pt idx="895">
                  <c:v>8.2000000000000011</c:v>
                </c:pt>
                <c:pt idx="896">
                  <c:v>8.2060000000000013</c:v>
                </c:pt>
                <c:pt idx="897">
                  <c:v>8.2119999999999997</c:v>
                </c:pt>
                <c:pt idx="898">
                  <c:v>8.2179999999999982</c:v>
                </c:pt>
                <c:pt idx="899">
                  <c:v>8.222999999999999</c:v>
                </c:pt>
                <c:pt idx="900">
                  <c:v>8.2289999999999992</c:v>
                </c:pt>
                <c:pt idx="901">
                  <c:v>8.2349999999999994</c:v>
                </c:pt>
                <c:pt idx="902">
                  <c:v>8.2399999999999984</c:v>
                </c:pt>
                <c:pt idx="903">
                  <c:v>8.2459999999999987</c:v>
                </c:pt>
                <c:pt idx="904">
                  <c:v>8.2520000000000007</c:v>
                </c:pt>
                <c:pt idx="905">
                  <c:v>8.2580000000000009</c:v>
                </c:pt>
                <c:pt idx="906">
                  <c:v>8.2630000000000035</c:v>
                </c:pt>
                <c:pt idx="907">
                  <c:v>8.2690000000000001</c:v>
                </c:pt>
                <c:pt idx="908">
                  <c:v>8.2750000000000004</c:v>
                </c:pt>
                <c:pt idx="909">
                  <c:v>8.2800000000000011</c:v>
                </c:pt>
                <c:pt idx="910">
                  <c:v>8.2860000000000014</c:v>
                </c:pt>
                <c:pt idx="911">
                  <c:v>8.2919999999999998</c:v>
                </c:pt>
                <c:pt idx="912">
                  <c:v>8.2979999999999983</c:v>
                </c:pt>
                <c:pt idx="913">
                  <c:v>8.3030000000000008</c:v>
                </c:pt>
                <c:pt idx="914">
                  <c:v>8.3090000000000011</c:v>
                </c:pt>
                <c:pt idx="915">
                  <c:v>8.3150000000000013</c:v>
                </c:pt>
                <c:pt idx="916">
                  <c:v>8.32</c:v>
                </c:pt>
                <c:pt idx="917">
                  <c:v>8.3260000000000005</c:v>
                </c:pt>
                <c:pt idx="918">
                  <c:v>8.3320000000000007</c:v>
                </c:pt>
                <c:pt idx="919">
                  <c:v>8.338000000000001</c:v>
                </c:pt>
                <c:pt idx="920">
                  <c:v>8.343</c:v>
                </c:pt>
                <c:pt idx="921">
                  <c:v>8.3490000000000002</c:v>
                </c:pt>
                <c:pt idx="922">
                  <c:v>8.3550000000000022</c:v>
                </c:pt>
                <c:pt idx="923">
                  <c:v>8.3600000000000012</c:v>
                </c:pt>
                <c:pt idx="924">
                  <c:v>8.3660000000000032</c:v>
                </c:pt>
                <c:pt idx="925">
                  <c:v>8.3720000000000034</c:v>
                </c:pt>
                <c:pt idx="926">
                  <c:v>8.3780000000000001</c:v>
                </c:pt>
                <c:pt idx="927">
                  <c:v>8.3830000000000027</c:v>
                </c:pt>
                <c:pt idx="928">
                  <c:v>8.3890000000000011</c:v>
                </c:pt>
                <c:pt idx="929">
                  <c:v>8.3950000000000014</c:v>
                </c:pt>
                <c:pt idx="930">
                  <c:v>8.4</c:v>
                </c:pt>
                <c:pt idx="931">
                  <c:v>8.4060000000000006</c:v>
                </c:pt>
                <c:pt idx="932">
                  <c:v>8.4120000000000008</c:v>
                </c:pt>
                <c:pt idx="933">
                  <c:v>8.418000000000001</c:v>
                </c:pt>
                <c:pt idx="934">
                  <c:v>8.423</c:v>
                </c:pt>
                <c:pt idx="935">
                  <c:v>8.4290000000000003</c:v>
                </c:pt>
                <c:pt idx="936">
                  <c:v>8.4350000000000005</c:v>
                </c:pt>
                <c:pt idx="937">
                  <c:v>8.44</c:v>
                </c:pt>
                <c:pt idx="938">
                  <c:v>8.4460000000000015</c:v>
                </c:pt>
                <c:pt idx="939">
                  <c:v>8.4520000000000017</c:v>
                </c:pt>
                <c:pt idx="940">
                  <c:v>8.4580000000000002</c:v>
                </c:pt>
                <c:pt idx="941">
                  <c:v>8.4630000000000027</c:v>
                </c:pt>
                <c:pt idx="942">
                  <c:v>8.4690000000000012</c:v>
                </c:pt>
                <c:pt idx="943">
                  <c:v>8.4750000000000014</c:v>
                </c:pt>
                <c:pt idx="944">
                  <c:v>8.48</c:v>
                </c:pt>
                <c:pt idx="945">
                  <c:v>8.4860000000000007</c:v>
                </c:pt>
                <c:pt idx="946">
                  <c:v>8.4920000000000027</c:v>
                </c:pt>
                <c:pt idx="947">
                  <c:v>8.4980000000000011</c:v>
                </c:pt>
                <c:pt idx="948">
                  <c:v>8.5030000000000001</c:v>
                </c:pt>
                <c:pt idx="949">
                  <c:v>8.5090000000000003</c:v>
                </c:pt>
                <c:pt idx="950">
                  <c:v>8.5150000000000006</c:v>
                </c:pt>
                <c:pt idx="951">
                  <c:v>8.52</c:v>
                </c:pt>
                <c:pt idx="952">
                  <c:v>8.5260000000000016</c:v>
                </c:pt>
                <c:pt idx="953">
                  <c:v>8.532</c:v>
                </c:pt>
                <c:pt idx="954">
                  <c:v>8.5379999999999985</c:v>
                </c:pt>
                <c:pt idx="955">
                  <c:v>8.543000000000001</c:v>
                </c:pt>
                <c:pt idx="956">
                  <c:v>8.5489999999999995</c:v>
                </c:pt>
                <c:pt idx="957">
                  <c:v>8.5550000000000015</c:v>
                </c:pt>
                <c:pt idx="958">
                  <c:v>8.56</c:v>
                </c:pt>
                <c:pt idx="959">
                  <c:v>8.5660000000000007</c:v>
                </c:pt>
                <c:pt idx="960">
                  <c:v>8.572000000000001</c:v>
                </c:pt>
                <c:pt idx="961">
                  <c:v>8.5780000000000012</c:v>
                </c:pt>
                <c:pt idx="962">
                  <c:v>8.5830000000000002</c:v>
                </c:pt>
                <c:pt idx="963">
                  <c:v>8.5890000000000004</c:v>
                </c:pt>
                <c:pt idx="964">
                  <c:v>8.5950000000000006</c:v>
                </c:pt>
                <c:pt idx="965">
                  <c:v>8.6</c:v>
                </c:pt>
                <c:pt idx="966">
                  <c:v>8.6060000000000034</c:v>
                </c:pt>
                <c:pt idx="967">
                  <c:v>8.6120000000000001</c:v>
                </c:pt>
                <c:pt idx="968">
                  <c:v>8.6179999999999986</c:v>
                </c:pt>
                <c:pt idx="969">
                  <c:v>8.6230000000000011</c:v>
                </c:pt>
                <c:pt idx="970">
                  <c:v>8.6289999999999996</c:v>
                </c:pt>
                <c:pt idx="971">
                  <c:v>8.6349999999999998</c:v>
                </c:pt>
                <c:pt idx="972">
                  <c:v>8.6399999999999988</c:v>
                </c:pt>
                <c:pt idx="973">
                  <c:v>8.645999999999999</c:v>
                </c:pt>
                <c:pt idx="974">
                  <c:v>8.652000000000001</c:v>
                </c:pt>
                <c:pt idx="975">
                  <c:v>8.6580000000000013</c:v>
                </c:pt>
                <c:pt idx="976">
                  <c:v>8.6630000000000003</c:v>
                </c:pt>
                <c:pt idx="977">
                  <c:v>8.6690000000000005</c:v>
                </c:pt>
                <c:pt idx="978">
                  <c:v>8.6750000000000007</c:v>
                </c:pt>
                <c:pt idx="979">
                  <c:v>8.6810000000000009</c:v>
                </c:pt>
                <c:pt idx="980">
                  <c:v>8.6860000000000035</c:v>
                </c:pt>
                <c:pt idx="981">
                  <c:v>8.6920000000000002</c:v>
                </c:pt>
                <c:pt idx="982">
                  <c:v>8.6979999999999986</c:v>
                </c:pt>
                <c:pt idx="983">
                  <c:v>8.7030000000000012</c:v>
                </c:pt>
                <c:pt idx="984">
                  <c:v>8.7089999999999996</c:v>
                </c:pt>
                <c:pt idx="985">
                  <c:v>8.7150000000000016</c:v>
                </c:pt>
                <c:pt idx="986">
                  <c:v>8.7209999999999983</c:v>
                </c:pt>
                <c:pt idx="987">
                  <c:v>8.7260000000000009</c:v>
                </c:pt>
                <c:pt idx="988">
                  <c:v>8.7319999999999993</c:v>
                </c:pt>
                <c:pt idx="989">
                  <c:v>8.7379999999999995</c:v>
                </c:pt>
                <c:pt idx="990">
                  <c:v>8.7429999999999986</c:v>
                </c:pt>
                <c:pt idx="991">
                  <c:v>8.7489999999999988</c:v>
                </c:pt>
                <c:pt idx="992">
                  <c:v>8.7550000000000008</c:v>
                </c:pt>
                <c:pt idx="993">
                  <c:v>8.761000000000001</c:v>
                </c:pt>
                <c:pt idx="994">
                  <c:v>8.766</c:v>
                </c:pt>
                <c:pt idx="995">
                  <c:v>8.7720000000000002</c:v>
                </c:pt>
                <c:pt idx="996">
                  <c:v>8.7779999999999987</c:v>
                </c:pt>
                <c:pt idx="997">
                  <c:v>8.7830000000000013</c:v>
                </c:pt>
                <c:pt idx="998">
                  <c:v>8.7889999999999997</c:v>
                </c:pt>
                <c:pt idx="999">
                  <c:v>8.7950000000000017</c:v>
                </c:pt>
                <c:pt idx="1000">
                  <c:v>8.8010000000000002</c:v>
                </c:pt>
                <c:pt idx="1001">
                  <c:v>8.8060000000000027</c:v>
                </c:pt>
                <c:pt idx="1002">
                  <c:v>8.8120000000000012</c:v>
                </c:pt>
                <c:pt idx="1003">
                  <c:v>8.8180000000000014</c:v>
                </c:pt>
                <c:pt idx="1004">
                  <c:v>8.8230000000000004</c:v>
                </c:pt>
                <c:pt idx="1005">
                  <c:v>8.8290000000000006</c:v>
                </c:pt>
                <c:pt idx="1006">
                  <c:v>8.8350000000000026</c:v>
                </c:pt>
                <c:pt idx="1007">
                  <c:v>8.8410000000000011</c:v>
                </c:pt>
                <c:pt idx="1008">
                  <c:v>8.8460000000000001</c:v>
                </c:pt>
                <c:pt idx="1009">
                  <c:v>8.8520000000000021</c:v>
                </c:pt>
                <c:pt idx="1010">
                  <c:v>8.8580000000000005</c:v>
                </c:pt>
                <c:pt idx="1011">
                  <c:v>8.8630000000000031</c:v>
                </c:pt>
                <c:pt idx="1012">
                  <c:v>8.8690000000000015</c:v>
                </c:pt>
                <c:pt idx="1013">
                  <c:v>8.8750000000000018</c:v>
                </c:pt>
                <c:pt idx="1014">
                  <c:v>8.8810000000000002</c:v>
                </c:pt>
                <c:pt idx="1015">
                  <c:v>8.8860000000000028</c:v>
                </c:pt>
                <c:pt idx="1016">
                  <c:v>8.8920000000000012</c:v>
                </c:pt>
                <c:pt idx="1017">
                  <c:v>8.8980000000000015</c:v>
                </c:pt>
                <c:pt idx="1018">
                  <c:v>8.9030000000000005</c:v>
                </c:pt>
                <c:pt idx="1019">
                  <c:v>8.9090000000000007</c:v>
                </c:pt>
                <c:pt idx="1020">
                  <c:v>8.9150000000000009</c:v>
                </c:pt>
                <c:pt idx="1021">
                  <c:v>8.9210000000000012</c:v>
                </c:pt>
                <c:pt idx="1022">
                  <c:v>8.9260000000000002</c:v>
                </c:pt>
                <c:pt idx="1023">
                  <c:v>8.9320000000000004</c:v>
                </c:pt>
                <c:pt idx="1024">
                  <c:v>8.9379999999999988</c:v>
                </c:pt>
                <c:pt idx="1025">
                  <c:v>8.9430000000000014</c:v>
                </c:pt>
                <c:pt idx="1026">
                  <c:v>8.9489999999999998</c:v>
                </c:pt>
                <c:pt idx="1027">
                  <c:v>8.9550000000000018</c:v>
                </c:pt>
                <c:pt idx="1028">
                  <c:v>8.9610000000000003</c:v>
                </c:pt>
                <c:pt idx="1029">
                  <c:v>8.9660000000000029</c:v>
                </c:pt>
                <c:pt idx="1030">
                  <c:v>8.9720000000000013</c:v>
                </c:pt>
                <c:pt idx="1031">
                  <c:v>8.9780000000000015</c:v>
                </c:pt>
                <c:pt idx="1032">
                  <c:v>8.9830000000000005</c:v>
                </c:pt>
                <c:pt idx="1033">
                  <c:v>8.9890000000000008</c:v>
                </c:pt>
                <c:pt idx="1034">
                  <c:v>8.995000000000001</c:v>
                </c:pt>
                <c:pt idx="1035">
                  <c:v>9.0010000000000012</c:v>
                </c:pt>
                <c:pt idx="1036">
                  <c:v>9.0060000000000002</c:v>
                </c:pt>
                <c:pt idx="1037">
                  <c:v>9.0120000000000005</c:v>
                </c:pt>
                <c:pt idx="1038">
                  <c:v>9.0179999999999989</c:v>
                </c:pt>
                <c:pt idx="1039">
                  <c:v>9.0230000000000015</c:v>
                </c:pt>
                <c:pt idx="1040">
                  <c:v>9.0290000000000017</c:v>
                </c:pt>
                <c:pt idx="1041">
                  <c:v>9.0350000000000001</c:v>
                </c:pt>
                <c:pt idx="1042">
                  <c:v>9.0409999999999986</c:v>
                </c:pt>
                <c:pt idx="1043">
                  <c:v>9.0460000000000012</c:v>
                </c:pt>
                <c:pt idx="1044">
                  <c:v>9.0520000000000014</c:v>
                </c:pt>
                <c:pt idx="1045">
                  <c:v>9.0580000000000016</c:v>
                </c:pt>
                <c:pt idx="1046">
                  <c:v>9.0630000000000006</c:v>
                </c:pt>
                <c:pt idx="1047">
                  <c:v>9.0690000000000008</c:v>
                </c:pt>
                <c:pt idx="1048">
                  <c:v>9.0750000000000011</c:v>
                </c:pt>
                <c:pt idx="1049">
                  <c:v>9.0810000000000013</c:v>
                </c:pt>
                <c:pt idx="1050">
                  <c:v>9.0860000000000003</c:v>
                </c:pt>
                <c:pt idx="1051">
                  <c:v>9.0920000000000005</c:v>
                </c:pt>
                <c:pt idx="1052">
                  <c:v>9.097999999999999</c:v>
                </c:pt>
                <c:pt idx="1053">
                  <c:v>9.1030000000000015</c:v>
                </c:pt>
                <c:pt idx="1054">
                  <c:v>9.109</c:v>
                </c:pt>
                <c:pt idx="1055">
                  <c:v>9.1150000000000002</c:v>
                </c:pt>
                <c:pt idx="1056">
                  <c:v>9.1209999999999987</c:v>
                </c:pt>
                <c:pt idx="1057">
                  <c:v>9.1260000000000012</c:v>
                </c:pt>
                <c:pt idx="1058">
                  <c:v>9.1319999999999997</c:v>
                </c:pt>
                <c:pt idx="1059">
                  <c:v>9.1380000000000017</c:v>
                </c:pt>
                <c:pt idx="1060">
                  <c:v>9.1429999999999989</c:v>
                </c:pt>
                <c:pt idx="1061">
                  <c:v>9.1489999999999991</c:v>
                </c:pt>
                <c:pt idx="1062">
                  <c:v>9.1550000000000011</c:v>
                </c:pt>
                <c:pt idx="1063">
                  <c:v>9.1610000000000014</c:v>
                </c:pt>
                <c:pt idx="1064">
                  <c:v>9.1660000000000004</c:v>
                </c:pt>
                <c:pt idx="1065">
                  <c:v>9.1720000000000006</c:v>
                </c:pt>
                <c:pt idx="1066">
                  <c:v>9.177999999999999</c:v>
                </c:pt>
                <c:pt idx="1067">
                  <c:v>9.1830000000000016</c:v>
                </c:pt>
                <c:pt idx="1068">
                  <c:v>9.1890000000000001</c:v>
                </c:pt>
                <c:pt idx="1069">
                  <c:v>9.1950000000000003</c:v>
                </c:pt>
                <c:pt idx="1070">
                  <c:v>9.2009999999999987</c:v>
                </c:pt>
                <c:pt idx="1071">
                  <c:v>9.2060000000000013</c:v>
                </c:pt>
                <c:pt idx="1072">
                  <c:v>9.2119999999999997</c:v>
                </c:pt>
                <c:pt idx="1073">
                  <c:v>9.2179999999999982</c:v>
                </c:pt>
                <c:pt idx="1074">
                  <c:v>9.222999999999999</c:v>
                </c:pt>
                <c:pt idx="1075">
                  <c:v>9.2289999999999992</c:v>
                </c:pt>
                <c:pt idx="1076">
                  <c:v>9.2349999999999994</c:v>
                </c:pt>
                <c:pt idx="1077">
                  <c:v>9.2409999999999997</c:v>
                </c:pt>
                <c:pt idx="1078">
                  <c:v>9.2459999999999987</c:v>
                </c:pt>
                <c:pt idx="1079">
                  <c:v>9.2520000000000007</c:v>
                </c:pt>
                <c:pt idx="1080">
                  <c:v>9.2580000000000009</c:v>
                </c:pt>
                <c:pt idx="1081">
                  <c:v>9.2630000000000035</c:v>
                </c:pt>
                <c:pt idx="1082">
                  <c:v>9.2690000000000001</c:v>
                </c:pt>
                <c:pt idx="1083">
                  <c:v>9.2750000000000004</c:v>
                </c:pt>
                <c:pt idx="1084">
                  <c:v>9.2809999999999988</c:v>
                </c:pt>
                <c:pt idx="1085">
                  <c:v>9.2860000000000014</c:v>
                </c:pt>
                <c:pt idx="1086">
                  <c:v>9.2919999999999998</c:v>
                </c:pt>
                <c:pt idx="1087">
                  <c:v>9.2979999999999983</c:v>
                </c:pt>
                <c:pt idx="1088">
                  <c:v>9.3030000000000008</c:v>
                </c:pt>
                <c:pt idx="1089">
                  <c:v>9.3090000000000011</c:v>
                </c:pt>
                <c:pt idx="1090">
                  <c:v>9.3150000000000013</c:v>
                </c:pt>
                <c:pt idx="1091">
                  <c:v>9.3210000000000015</c:v>
                </c:pt>
                <c:pt idx="1092">
                  <c:v>9.3260000000000005</c:v>
                </c:pt>
                <c:pt idx="1093">
                  <c:v>9.3320000000000007</c:v>
                </c:pt>
                <c:pt idx="1094">
                  <c:v>9.338000000000001</c:v>
                </c:pt>
                <c:pt idx="1095">
                  <c:v>9.343</c:v>
                </c:pt>
                <c:pt idx="1096">
                  <c:v>9.3490000000000002</c:v>
                </c:pt>
                <c:pt idx="1097">
                  <c:v>9.3550000000000022</c:v>
                </c:pt>
                <c:pt idx="1098">
                  <c:v>9.3610000000000007</c:v>
                </c:pt>
                <c:pt idx="1099">
                  <c:v>9.3660000000000032</c:v>
                </c:pt>
                <c:pt idx="1100">
                  <c:v>9.3720000000000034</c:v>
                </c:pt>
                <c:pt idx="1101">
                  <c:v>9.3780000000000001</c:v>
                </c:pt>
                <c:pt idx="1102">
                  <c:v>9.3830000000000027</c:v>
                </c:pt>
                <c:pt idx="1103">
                  <c:v>9.3890000000000011</c:v>
                </c:pt>
                <c:pt idx="1104">
                  <c:v>9.3950000000000014</c:v>
                </c:pt>
                <c:pt idx="1105">
                  <c:v>9.4010000000000016</c:v>
                </c:pt>
                <c:pt idx="1106">
                  <c:v>9.4060000000000006</c:v>
                </c:pt>
                <c:pt idx="1107">
                  <c:v>9.4120000000000008</c:v>
                </c:pt>
                <c:pt idx="1108">
                  <c:v>9.418000000000001</c:v>
                </c:pt>
                <c:pt idx="1109">
                  <c:v>9.423</c:v>
                </c:pt>
                <c:pt idx="1110">
                  <c:v>9.4290000000000003</c:v>
                </c:pt>
                <c:pt idx="1111">
                  <c:v>9.4350000000000005</c:v>
                </c:pt>
                <c:pt idx="1112">
                  <c:v>9.4409999999999989</c:v>
                </c:pt>
                <c:pt idx="1113">
                  <c:v>9.4460000000000015</c:v>
                </c:pt>
                <c:pt idx="1114">
                  <c:v>9.4520000000000017</c:v>
                </c:pt>
                <c:pt idx="1115">
                  <c:v>9.4580000000000002</c:v>
                </c:pt>
                <c:pt idx="1116">
                  <c:v>9.4630000000000027</c:v>
                </c:pt>
                <c:pt idx="1117">
                  <c:v>9.4690000000000012</c:v>
                </c:pt>
                <c:pt idx="1118">
                  <c:v>9.4750000000000014</c:v>
                </c:pt>
                <c:pt idx="1119">
                  <c:v>9.4810000000000034</c:v>
                </c:pt>
                <c:pt idx="1120">
                  <c:v>9.4860000000000007</c:v>
                </c:pt>
                <c:pt idx="1121">
                  <c:v>9.4920000000000027</c:v>
                </c:pt>
                <c:pt idx="1122">
                  <c:v>9.4980000000000011</c:v>
                </c:pt>
                <c:pt idx="1123">
                  <c:v>9.5040000000000013</c:v>
                </c:pt>
                <c:pt idx="1124">
                  <c:v>9.5090000000000003</c:v>
                </c:pt>
                <c:pt idx="1125">
                  <c:v>9.5150000000000006</c:v>
                </c:pt>
                <c:pt idx="1126">
                  <c:v>9.520999999999999</c:v>
                </c:pt>
                <c:pt idx="1127">
                  <c:v>9.5260000000000016</c:v>
                </c:pt>
                <c:pt idx="1128">
                  <c:v>9.532</c:v>
                </c:pt>
                <c:pt idx="1129">
                  <c:v>9.5379999999999985</c:v>
                </c:pt>
                <c:pt idx="1130">
                  <c:v>9.5439999999999987</c:v>
                </c:pt>
                <c:pt idx="1131">
                  <c:v>9.5489999999999995</c:v>
                </c:pt>
                <c:pt idx="1132">
                  <c:v>9.5550000000000015</c:v>
                </c:pt>
                <c:pt idx="1133">
                  <c:v>9.5610000000000035</c:v>
                </c:pt>
                <c:pt idx="1134">
                  <c:v>9.5660000000000007</c:v>
                </c:pt>
                <c:pt idx="1135">
                  <c:v>9.572000000000001</c:v>
                </c:pt>
                <c:pt idx="1136">
                  <c:v>9.5780000000000012</c:v>
                </c:pt>
                <c:pt idx="1137">
                  <c:v>9.5840000000000014</c:v>
                </c:pt>
                <c:pt idx="1138">
                  <c:v>9.5890000000000004</c:v>
                </c:pt>
                <c:pt idx="1139">
                  <c:v>9.5950000000000006</c:v>
                </c:pt>
                <c:pt idx="1140">
                  <c:v>9.6010000000000009</c:v>
                </c:pt>
                <c:pt idx="1141">
                  <c:v>9.6060000000000034</c:v>
                </c:pt>
                <c:pt idx="1142">
                  <c:v>9.6120000000000001</c:v>
                </c:pt>
                <c:pt idx="1143">
                  <c:v>9.6179999999999986</c:v>
                </c:pt>
                <c:pt idx="1144">
                  <c:v>9.6239999999999988</c:v>
                </c:pt>
                <c:pt idx="1145">
                  <c:v>9.6289999999999996</c:v>
                </c:pt>
                <c:pt idx="1146">
                  <c:v>9.6349999999999998</c:v>
                </c:pt>
                <c:pt idx="1147">
                  <c:v>9.6409999999999982</c:v>
                </c:pt>
                <c:pt idx="1148">
                  <c:v>9.645999999999999</c:v>
                </c:pt>
                <c:pt idx="1149">
                  <c:v>9.652000000000001</c:v>
                </c:pt>
                <c:pt idx="1150">
                  <c:v>9.6580000000000013</c:v>
                </c:pt>
                <c:pt idx="1151">
                  <c:v>9.6640000000000015</c:v>
                </c:pt>
                <c:pt idx="1152">
                  <c:v>9.6690000000000005</c:v>
                </c:pt>
                <c:pt idx="1153">
                  <c:v>9.6750000000000007</c:v>
                </c:pt>
                <c:pt idx="1154">
                  <c:v>9.6810000000000009</c:v>
                </c:pt>
                <c:pt idx="1155">
                  <c:v>9.6860000000000035</c:v>
                </c:pt>
                <c:pt idx="1156">
                  <c:v>9.6920000000000002</c:v>
                </c:pt>
                <c:pt idx="1157">
                  <c:v>9.6979999999999986</c:v>
                </c:pt>
                <c:pt idx="1158">
                  <c:v>9.7039999999999988</c:v>
                </c:pt>
                <c:pt idx="1159">
                  <c:v>9.7089999999999996</c:v>
                </c:pt>
                <c:pt idx="1160">
                  <c:v>9.7150000000000016</c:v>
                </c:pt>
                <c:pt idx="1161">
                  <c:v>9.7209999999999983</c:v>
                </c:pt>
                <c:pt idx="1162">
                  <c:v>9.7260000000000009</c:v>
                </c:pt>
                <c:pt idx="1163">
                  <c:v>9.7319999999999993</c:v>
                </c:pt>
                <c:pt idx="1164">
                  <c:v>9.7379999999999995</c:v>
                </c:pt>
                <c:pt idx="1165">
                  <c:v>9.7439999999999998</c:v>
                </c:pt>
                <c:pt idx="1166">
                  <c:v>9.7489999999999988</c:v>
                </c:pt>
                <c:pt idx="1167">
                  <c:v>9.7550000000000008</c:v>
                </c:pt>
                <c:pt idx="1168">
                  <c:v>9.761000000000001</c:v>
                </c:pt>
                <c:pt idx="1169">
                  <c:v>9.766</c:v>
                </c:pt>
                <c:pt idx="1170">
                  <c:v>9.7720000000000002</c:v>
                </c:pt>
                <c:pt idx="1171">
                  <c:v>9.7779999999999987</c:v>
                </c:pt>
                <c:pt idx="1172">
                  <c:v>9.7839999999999989</c:v>
                </c:pt>
                <c:pt idx="1173">
                  <c:v>9.7889999999999997</c:v>
                </c:pt>
                <c:pt idx="1174">
                  <c:v>9.7950000000000017</c:v>
                </c:pt>
                <c:pt idx="1175">
                  <c:v>9.8010000000000002</c:v>
                </c:pt>
                <c:pt idx="1176">
                  <c:v>9.8060000000000027</c:v>
                </c:pt>
                <c:pt idx="1177">
                  <c:v>9.8120000000000012</c:v>
                </c:pt>
                <c:pt idx="1178">
                  <c:v>9.8180000000000014</c:v>
                </c:pt>
                <c:pt idx="1179">
                  <c:v>9.8240000000000016</c:v>
                </c:pt>
                <c:pt idx="1180">
                  <c:v>9.8290000000000006</c:v>
                </c:pt>
                <c:pt idx="1181">
                  <c:v>9.8350000000000026</c:v>
                </c:pt>
                <c:pt idx="1182">
                  <c:v>9.8410000000000011</c:v>
                </c:pt>
                <c:pt idx="1183">
                  <c:v>9.8460000000000001</c:v>
                </c:pt>
                <c:pt idx="1184">
                  <c:v>9.8520000000000021</c:v>
                </c:pt>
                <c:pt idx="1185">
                  <c:v>9.8580000000000005</c:v>
                </c:pt>
                <c:pt idx="1186">
                  <c:v>9.8640000000000008</c:v>
                </c:pt>
                <c:pt idx="1187">
                  <c:v>9.8690000000000015</c:v>
                </c:pt>
                <c:pt idx="1188">
                  <c:v>9.8750000000000018</c:v>
                </c:pt>
                <c:pt idx="1189">
                  <c:v>9.8810000000000002</c:v>
                </c:pt>
                <c:pt idx="1190">
                  <c:v>9.8860000000000028</c:v>
                </c:pt>
                <c:pt idx="1191">
                  <c:v>9.8920000000000012</c:v>
                </c:pt>
                <c:pt idx="1192">
                  <c:v>9.8980000000000015</c:v>
                </c:pt>
                <c:pt idx="1193">
                  <c:v>9.9040000000000035</c:v>
                </c:pt>
                <c:pt idx="1194">
                  <c:v>9.9090000000000007</c:v>
                </c:pt>
                <c:pt idx="1195">
                  <c:v>9.9150000000000009</c:v>
                </c:pt>
                <c:pt idx="1196">
                  <c:v>9.9210000000000012</c:v>
                </c:pt>
                <c:pt idx="1197">
                  <c:v>9.9260000000000002</c:v>
                </c:pt>
                <c:pt idx="1198">
                  <c:v>9.9320000000000004</c:v>
                </c:pt>
                <c:pt idx="1199">
                  <c:v>9.9379999999999988</c:v>
                </c:pt>
                <c:pt idx="1200">
                  <c:v>9.9439999999999991</c:v>
                </c:pt>
                <c:pt idx="1201">
                  <c:v>9.9489999999999998</c:v>
                </c:pt>
                <c:pt idx="1202">
                  <c:v>9.9550000000000018</c:v>
                </c:pt>
                <c:pt idx="1203">
                  <c:v>9.9610000000000003</c:v>
                </c:pt>
                <c:pt idx="1204">
                  <c:v>9.9660000000000029</c:v>
                </c:pt>
                <c:pt idx="1205">
                  <c:v>9.9720000000000013</c:v>
                </c:pt>
                <c:pt idx="1206">
                  <c:v>9.9780000000000015</c:v>
                </c:pt>
                <c:pt idx="1207">
                  <c:v>9.984</c:v>
                </c:pt>
                <c:pt idx="1208">
                  <c:v>9.9890000000000008</c:v>
                </c:pt>
                <c:pt idx="1209">
                  <c:v>9.995000000000001</c:v>
                </c:pt>
                <c:pt idx="1210">
                  <c:v>10.001000000000001</c:v>
                </c:pt>
                <c:pt idx="1211">
                  <c:v>10.006</c:v>
                </c:pt>
                <c:pt idx="1212">
                  <c:v>10.012</c:v>
                </c:pt>
                <c:pt idx="1213">
                  <c:v>10.018000000000001</c:v>
                </c:pt>
                <c:pt idx="1214">
                  <c:v>10.024000000000001</c:v>
                </c:pt>
                <c:pt idx="1215">
                  <c:v>10.029</c:v>
                </c:pt>
                <c:pt idx="1216">
                  <c:v>10.035</c:v>
                </c:pt>
                <c:pt idx="1217">
                  <c:v>10.040999999999999</c:v>
                </c:pt>
                <c:pt idx="1218">
                  <c:v>10.046000000000001</c:v>
                </c:pt>
                <c:pt idx="1219">
                  <c:v>10.052000000000001</c:v>
                </c:pt>
                <c:pt idx="1220">
                  <c:v>10.058</c:v>
                </c:pt>
                <c:pt idx="1221">
                  <c:v>10.064</c:v>
                </c:pt>
                <c:pt idx="1222">
                  <c:v>10.069000000000003</c:v>
                </c:pt>
                <c:pt idx="1223">
                  <c:v>10.075000000000001</c:v>
                </c:pt>
                <c:pt idx="1224">
                  <c:v>10.081</c:v>
                </c:pt>
                <c:pt idx="1225">
                  <c:v>10.086</c:v>
                </c:pt>
                <c:pt idx="1226">
                  <c:v>10.092000000000002</c:v>
                </c:pt>
                <c:pt idx="1227">
                  <c:v>10.098000000000001</c:v>
                </c:pt>
                <c:pt idx="1228">
                  <c:v>10.104000000000001</c:v>
                </c:pt>
                <c:pt idx="1229">
                  <c:v>10.109</c:v>
                </c:pt>
                <c:pt idx="1230">
                  <c:v>10.115</c:v>
                </c:pt>
                <c:pt idx="1231">
                  <c:v>10.120999999999999</c:v>
                </c:pt>
                <c:pt idx="1232">
                  <c:v>10.126000000000001</c:v>
                </c:pt>
                <c:pt idx="1233">
                  <c:v>10.132</c:v>
                </c:pt>
                <c:pt idx="1234">
                  <c:v>10.137999999999998</c:v>
                </c:pt>
                <c:pt idx="1235">
                  <c:v>10.143999999999998</c:v>
                </c:pt>
                <c:pt idx="1236">
                  <c:v>10.148999999999999</c:v>
                </c:pt>
                <c:pt idx="1237">
                  <c:v>10.155000000000001</c:v>
                </c:pt>
                <c:pt idx="1238">
                  <c:v>10.161</c:v>
                </c:pt>
                <c:pt idx="1239">
                  <c:v>10.166</c:v>
                </c:pt>
                <c:pt idx="1240">
                  <c:v>10.172000000000002</c:v>
                </c:pt>
                <c:pt idx="1241">
                  <c:v>10.178000000000001</c:v>
                </c:pt>
                <c:pt idx="1242">
                  <c:v>10.184000000000001</c:v>
                </c:pt>
                <c:pt idx="1243">
                  <c:v>10.189</c:v>
                </c:pt>
                <c:pt idx="1244">
                  <c:v>10.195</c:v>
                </c:pt>
                <c:pt idx="1245">
                  <c:v>10.201000000000001</c:v>
                </c:pt>
                <c:pt idx="1246">
                  <c:v>10.206</c:v>
                </c:pt>
                <c:pt idx="1247">
                  <c:v>10.212</c:v>
                </c:pt>
                <c:pt idx="1248">
                  <c:v>10.217999999999998</c:v>
                </c:pt>
                <c:pt idx="1249">
                  <c:v>10.223999999999998</c:v>
                </c:pt>
                <c:pt idx="1250">
                  <c:v>10.228999999999999</c:v>
                </c:pt>
                <c:pt idx="1251">
                  <c:v>10.234999999999999</c:v>
                </c:pt>
                <c:pt idx="1252">
                  <c:v>10.240999999999998</c:v>
                </c:pt>
                <c:pt idx="1253">
                  <c:v>10.246999999999998</c:v>
                </c:pt>
                <c:pt idx="1254">
                  <c:v>10.252000000000002</c:v>
                </c:pt>
                <c:pt idx="1255">
                  <c:v>10.258000000000001</c:v>
                </c:pt>
                <c:pt idx="1256">
                  <c:v>10.264000000000001</c:v>
                </c:pt>
                <c:pt idx="1257">
                  <c:v>10.269</c:v>
                </c:pt>
                <c:pt idx="1258">
                  <c:v>10.275</c:v>
                </c:pt>
                <c:pt idx="1259">
                  <c:v>10.281000000000001</c:v>
                </c:pt>
                <c:pt idx="1260">
                  <c:v>10.287000000000001</c:v>
                </c:pt>
                <c:pt idx="1261">
                  <c:v>10.292</c:v>
                </c:pt>
                <c:pt idx="1262">
                  <c:v>10.297999999999998</c:v>
                </c:pt>
                <c:pt idx="1263">
                  <c:v>10.304</c:v>
                </c:pt>
                <c:pt idx="1264">
                  <c:v>10.309000000000001</c:v>
                </c:pt>
                <c:pt idx="1265">
                  <c:v>10.315000000000001</c:v>
                </c:pt>
                <c:pt idx="1266">
                  <c:v>10.321</c:v>
                </c:pt>
                <c:pt idx="1267">
                  <c:v>10.327</c:v>
                </c:pt>
                <c:pt idx="1268">
                  <c:v>10.332000000000003</c:v>
                </c:pt>
                <c:pt idx="1269">
                  <c:v>10.338000000000001</c:v>
                </c:pt>
                <c:pt idx="1270">
                  <c:v>10.344000000000001</c:v>
                </c:pt>
                <c:pt idx="1271">
                  <c:v>10.349</c:v>
                </c:pt>
                <c:pt idx="1272">
                  <c:v>10.355000000000002</c:v>
                </c:pt>
                <c:pt idx="1273">
                  <c:v>10.361000000000002</c:v>
                </c:pt>
                <c:pt idx="1274">
                  <c:v>10.367000000000003</c:v>
                </c:pt>
                <c:pt idx="1275">
                  <c:v>10.372000000000002</c:v>
                </c:pt>
                <c:pt idx="1276">
                  <c:v>10.378</c:v>
                </c:pt>
                <c:pt idx="1277">
                  <c:v>10.384</c:v>
                </c:pt>
                <c:pt idx="1278">
                  <c:v>10.389000000000001</c:v>
                </c:pt>
                <c:pt idx="1279">
                  <c:v>10.395000000000001</c:v>
                </c:pt>
                <c:pt idx="1280">
                  <c:v>10.401</c:v>
                </c:pt>
                <c:pt idx="1281">
                  <c:v>10.407</c:v>
                </c:pt>
                <c:pt idx="1282">
                  <c:v>10.412000000000003</c:v>
                </c:pt>
                <c:pt idx="1283">
                  <c:v>10.418000000000001</c:v>
                </c:pt>
                <c:pt idx="1284">
                  <c:v>10.424000000000001</c:v>
                </c:pt>
                <c:pt idx="1285">
                  <c:v>10.429</c:v>
                </c:pt>
                <c:pt idx="1286">
                  <c:v>10.435</c:v>
                </c:pt>
                <c:pt idx="1287">
                  <c:v>10.441000000000001</c:v>
                </c:pt>
                <c:pt idx="1288">
                  <c:v>10.447000000000001</c:v>
                </c:pt>
                <c:pt idx="1289">
                  <c:v>10.452000000000002</c:v>
                </c:pt>
                <c:pt idx="1290">
                  <c:v>10.458</c:v>
                </c:pt>
                <c:pt idx="1291">
                  <c:v>10.464</c:v>
                </c:pt>
                <c:pt idx="1292">
                  <c:v>10.469000000000001</c:v>
                </c:pt>
                <c:pt idx="1293">
                  <c:v>10.475000000000001</c:v>
                </c:pt>
                <c:pt idx="1294">
                  <c:v>10.481</c:v>
                </c:pt>
                <c:pt idx="1295">
                  <c:v>10.487</c:v>
                </c:pt>
                <c:pt idx="1296">
                  <c:v>10.492000000000003</c:v>
                </c:pt>
                <c:pt idx="1297">
                  <c:v>10.498000000000001</c:v>
                </c:pt>
                <c:pt idx="1298">
                  <c:v>10.504</c:v>
                </c:pt>
                <c:pt idx="1299">
                  <c:v>10.509</c:v>
                </c:pt>
                <c:pt idx="1300">
                  <c:v>10.515000000000002</c:v>
                </c:pt>
                <c:pt idx="1301">
                  <c:v>10.521000000000001</c:v>
                </c:pt>
                <c:pt idx="1302">
                  <c:v>10.527000000000001</c:v>
                </c:pt>
                <c:pt idx="1303">
                  <c:v>10.532</c:v>
                </c:pt>
                <c:pt idx="1304">
                  <c:v>10.537999999999998</c:v>
                </c:pt>
                <c:pt idx="1305">
                  <c:v>10.543999999999999</c:v>
                </c:pt>
                <c:pt idx="1306">
                  <c:v>10.548999999999999</c:v>
                </c:pt>
                <c:pt idx="1307">
                  <c:v>10.555000000000001</c:v>
                </c:pt>
                <c:pt idx="1308">
                  <c:v>10.561</c:v>
                </c:pt>
                <c:pt idx="1309">
                  <c:v>10.567</c:v>
                </c:pt>
                <c:pt idx="1310">
                  <c:v>10.572000000000001</c:v>
                </c:pt>
                <c:pt idx="1311">
                  <c:v>10.578000000000001</c:v>
                </c:pt>
                <c:pt idx="1312">
                  <c:v>10.584</c:v>
                </c:pt>
                <c:pt idx="1313">
                  <c:v>10.589</c:v>
                </c:pt>
                <c:pt idx="1314">
                  <c:v>10.595000000000002</c:v>
                </c:pt>
                <c:pt idx="1315">
                  <c:v>10.601000000000001</c:v>
                </c:pt>
                <c:pt idx="1316">
                  <c:v>10.607000000000001</c:v>
                </c:pt>
                <c:pt idx="1317">
                  <c:v>10.612</c:v>
                </c:pt>
                <c:pt idx="1318">
                  <c:v>10.617999999999999</c:v>
                </c:pt>
                <c:pt idx="1319">
                  <c:v>10.624000000000001</c:v>
                </c:pt>
                <c:pt idx="1320">
                  <c:v>10.629</c:v>
                </c:pt>
                <c:pt idx="1321">
                  <c:v>10.635</c:v>
                </c:pt>
                <c:pt idx="1322">
                  <c:v>10.640999999999998</c:v>
                </c:pt>
                <c:pt idx="1323">
                  <c:v>10.646999999999998</c:v>
                </c:pt>
                <c:pt idx="1324">
                  <c:v>10.652000000000001</c:v>
                </c:pt>
                <c:pt idx="1325">
                  <c:v>10.658000000000001</c:v>
                </c:pt>
                <c:pt idx="1326">
                  <c:v>10.664</c:v>
                </c:pt>
                <c:pt idx="1327">
                  <c:v>10.669</c:v>
                </c:pt>
                <c:pt idx="1328">
                  <c:v>10.675000000000002</c:v>
                </c:pt>
                <c:pt idx="1329">
                  <c:v>10.681000000000001</c:v>
                </c:pt>
                <c:pt idx="1330">
                  <c:v>10.687000000000001</c:v>
                </c:pt>
                <c:pt idx="1331">
                  <c:v>10.692</c:v>
                </c:pt>
                <c:pt idx="1332">
                  <c:v>10.697999999999999</c:v>
                </c:pt>
                <c:pt idx="1333">
                  <c:v>10.704000000000001</c:v>
                </c:pt>
                <c:pt idx="1334">
                  <c:v>10.709</c:v>
                </c:pt>
                <c:pt idx="1335">
                  <c:v>10.715</c:v>
                </c:pt>
                <c:pt idx="1336">
                  <c:v>10.720999999999998</c:v>
                </c:pt>
                <c:pt idx="1337">
                  <c:v>10.726999999999999</c:v>
                </c:pt>
                <c:pt idx="1338">
                  <c:v>10.731999999999999</c:v>
                </c:pt>
                <c:pt idx="1339">
                  <c:v>10.737999999999998</c:v>
                </c:pt>
                <c:pt idx="1340">
                  <c:v>10.743999999999998</c:v>
                </c:pt>
                <c:pt idx="1341">
                  <c:v>10.749000000000001</c:v>
                </c:pt>
                <c:pt idx="1342">
                  <c:v>10.755000000000003</c:v>
                </c:pt>
                <c:pt idx="1343">
                  <c:v>10.761000000000001</c:v>
                </c:pt>
                <c:pt idx="1344">
                  <c:v>10.767000000000001</c:v>
                </c:pt>
                <c:pt idx="1345">
                  <c:v>10.772</c:v>
                </c:pt>
                <c:pt idx="1346">
                  <c:v>10.777999999999999</c:v>
                </c:pt>
                <c:pt idx="1347">
                  <c:v>10.784000000000001</c:v>
                </c:pt>
                <c:pt idx="1348">
                  <c:v>10.789</c:v>
                </c:pt>
                <c:pt idx="1349">
                  <c:v>10.795</c:v>
                </c:pt>
                <c:pt idx="1350">
                  <c:v>10.801</c:v>
                </c:pt>
                <c:pt idx="1351">
                  <c:v>10.807</c:v>
                </c:pt>
                <c:pt idx="1352">
                  <c:v>10.812000000000001</c:v>
                </c:pt>
                <c:pt idx="1353">
                  <c:v>10.818</c:v>
                </c:pt>
                <c:pt idx="1354">
                  <c:v>10.824</c:v>
                </c:pt>
                <c:pt idx="1355">
                  <c:v>10.829000000000002</c:v>
                </c:pt>
                <c:pt idx="1356">
                  <c:v>10.835000000000003</c:v>
                </c:pt>
                <c:pt idx="1357">
                  <c:v>10.841000000000001</c:v>
                </c:pt>
                <c:pt idx="1358">
                  <c:v>10.847</c:v>
                </c:pt>
                <c:pt idx="1359">
                  <c:v>10.852000000000002</c:v>
                </c:pt>
                <c:pt idx="1360">
                  <c:v>10.858000000000002</c:v>
                </c:pt>
                <c:pt idx="1361">
                  <c:v>10.864000000000003</c:v>
                </c:pt>
                <c:pt idx="1362">
                  <c:v>10.869000000000002</c:v>
                </c:pt>
                <c:pt idx="1363">
                  <c:v>10.875000000000002</c:v>
                </c:pt>
                <c:pt idx="1364">
                  <c:v>10.881</c:v>
                </c:pt>
                <c:pt idx="1365">
                  <c:v>10.887</c:v>
                </c:pt>
                <c:pt idx="1366">
                  <c:v>10.892000000000001</c:v>
                </c:pt>
                <c:pt idx="1367">
                  <c:v>10.898</c:v>
                </c:pt>
                <c:pt idx="1368">
                  <c:v>10.904</c:v>
                </c:pt>
                <c:pt idx="1369">
                  <c:v>10.909000000000002</c:v>
                </c:pt>
                <c:pt idx="1370">
                  <c:v>10.915000000000001</c:v>
                </c:pt>
                <c:pt idx="1371">
                  <c:v>10.921000000000001</c:v>
                </c:pt>
                <c:pt idx="1372">
                  <c:v>10.927</c:v>
                </c:pt>
                <c:pt idx="1373">
                  <c:v>10.932</c:v>
                </c:pt>
                <c:pt idx="1374">
                  <c:v>10.938000000000001</c:v>
                </c:pt>
                <c:pt idx="1375">
                  <c:v>10.944000000000001</c:v>
                </c:pt>
                <c:pt idx="1376">
                  <c:v>10.949</c:v>
                </c:pt>
                <c:pt idx="1377">
                  <c:v>10.955000000000002</c:v>
                </c:pt>
                <c:pt idx="1378">
                  <c:v>10.961</c:v>
                </c:pt>
                <c:pt idx="1379">
                  <c:v>10.967000000000002</c:v>
                </c:pt>
                <c:pt idx="1380">
                  <c:v>10.972000000000001</c:v>
                </c:pt>
                <c:pt idx="1381">
                  <c:v>10.978</c:v>
                </c:pt>
                <c:pt idx="1382">
                  <c:v>10.984</c:v>
                </c:pt>
                <c:pt idx="1383">
                  <c:v>10.989000000000003</c:v>
                </c:pt>
                <c:pt idx="1384">
                  <c:v>10.995000000000001</c:v>
                </c:pt>
                <c:pt idx="1385">
                  <c:v>11.001000000000001</c:v>
                </c:pt>
                <c:pt idx="1386">
                  <c:v>11.007</c:v>
                </c:pt>
                <c:pt idx="1387">
                  <c:v>11.012</c:v>
                </c:pt>
                <c:pt idx="1388">
                  <c:v>11.018000000000001</c:v>
                </c:pt>
                <c:pt idx="1389">
                  <c:v>11.024000000000001</c:v>
                </c:pt>
                <c:pt idx="1390">
                  <c:v>11.029</c:v>
                </c:pt>
                <c:pt idx="1391">
                  <c:v>11.035</c:v>
                </c:pt>
                <c:pt idx="1392">
                  <c:v>11.040999999999999</c:v>
                </c:pt>
                <c:pt idx="1393">
                  <c:v>11.047000000000001</c:v>
                </c:pt>
                <c:pt idx="1394">
                  <c:v>11.052000000000001</c:v>
                </c:pt>
                <c:pt idx="1395">
                  <c:v>11.058</c:v>
                </c:pt>
                <c:pt idx="1396">
                  <c:v>11.064</c:v>
                </c:pt>
                <c:pt idx="1397">
                  <c:v>11.07</c:v>
                </c:pt>
                <c:pt idx="1398">
                  <c:v>11.075000000000001</c:v>
                </c:pt>
                <c:pt idx="1399">
                  <c:v>11.081</c:v>
                </c:pt>
                <c:pt idx="1400">
                  <c:v>11.087</c:v>
                </c:pt>
                <c:pt idx="1401">
                  <c:v>11.092000000000002</c:v>
                </c:pt>
                <c:pt idx="1402">
                  <c:v>11.098000000000001</c:v>
                </c:pt>
                <c:pt idx="1403">
                  <c:v>11.104000000000001</c:v>
                </c:pt>
                <c:pt idx="1404">
                  <c:v>11.11</c:v>
                </c:pt>
                <c:pt idx="1405">
                  <c:v>11.115</c:v>
                </c:pt>
                <c:pt idx="1406">
                  <c:v>11.120999999999999</c:v>
                </c:pt>
                <c:pt idx="1407">
                  <c:v>11.127000000000001</c:v>
                </c:pt>
                <c:pt idx="1408">
                  <c:v>11.132</c:v>
                </c:pt>
                <c:pt idx="1409">
                  <c:v>11.137999999999998</c:v>
                </c:pt>
                <c:pt idx="1410">
                  <c:v>11.143999999999998</c:v>
                </c:pt>
                <c:pt idx="1411">
                  <c:v>11.15</c:v>
                </c:pt>
                <c:pt idx="1412">
                  <c:v>11.155000000000001</c:v>
                </c:pt>
                <c:pt idx="1413">
                  <c:v>11.161</c:v>
                </c:pt>
                <c:pt idx="1414">
                  <c:v>11.167</c:v>
                </c:pt>
                <c:pt idx="1415">
                  <c:v>11.172000000000002</c:v>
                </c:pt>
                <c:pt idx="1416">
                  <c:v>11.178000000000001</c:v>
                </c:pt>
                <c:pt idx="1417">
                  <c:v>11.184000000000001</c:v>
                </c:pt>
                <c:pt idx="1418">
                  <c:v>11.19</c:v>
                </c:pt>
                <c:pt idx="1419">
                  <c:v>11.195</c:v>
                </c:pt>
                <c:pt idx="1420">
                  <c:v>11.201000000000001</c:v>
                </c:pt>
                <c:pt idx="1421">
                  <c:v>11.207000000000001</c:v>
                </c:pt>
                <c:pt idx="1422">
                  <c:v>11.212</c:v>
                </c:pt>
                <c:pt idx="1423">
                  <c:v>11.217999999999998</c:v>
                </c:pt>
                <c:pt idx="1424">
                  <c:v>11.223999999999998</c:v>
                </c:pt>
                <c:pt idx="1425">
                  <c:v>11.229999999999999</c:v>
                </c:pt>
                <c:pt idx="1426">
                  <c:v>11.234999999999999</c:v>
                </c:pt>
                <c:pt idx="1427">
                  <c:v>11.240999999999998</c:v>
                </c:pt>
                <c:pt idx="1428">
                  <c:v>11.246999999999998</c:v>
                </c:pt>
                <c:pt idx="1429">
                  <c:v>11.252000000000002</c:v>
                </c:pt>
                <c:pt idx="1430">
                  <c:v>11.258000000000001</c:v>
                </c:pt>
                <c:pt idx="1431">
                  <c:v>11.264000000000001</c:v>
                </c:pt>
                <c:pt idx="1432">
                  <c:v>11.27</c:v>
                </c:pt>
                <c:pt idx="1433">
                  <c:v>11.275</c:v>
                </c:pt>
                <c:pt idx="1434">
                  <c:v>11.281000000000001</c:v>
                </c:pt>
                <c:pt idx="1435">
                  <c:v>11.287000000000001</c:v>
                </c:pt>
                <c:pt idx="1436">
                  <c:v>11.292</c:v>
                </c:pt>
                <c:pt idx="1437">
                  <c:v>11.297999999999998</c:v>
                </c:pt>
                <c:pt idx="1438">
                  <c:v>11.304</c:v>
                </c:pt>
                <c:pt idx="1439">
                  <c:v>11.31</c:v>
                </c:pt>
                <c:pt idx="1440">
                  <c:v>11.315000000000001</c:v>
                </c:pt>
                <c:pt idx="1441">
                  <c:v>11.321</c:v>
                </c:pt>
                <c:pt idx="1442">
                  <c:v>11.327</c:v>
                </c:pt>
                <c:pt idx="1443">
                  <c:v>11.332000000000003</c:v>
                </c:pt>
                <c:pt idx="1444">
                  <c:v>11.338000000000001</c:v>
                </c:pt>
                <c:pt idx="1445">
                  <c:v>11.344000000000001</c:v>
                </c:pt>
                <c:pt idx="1446">
                  <c:v>11.350000000000001</c:v>
                </c:pt>
                <c:pt idx="1447">
                  <c:v>11.355000000000002</c:v>
                </c:pt>
                <c:pt idx="1448">
                  <c:v>11.361000000000002</c:v>
                </c:pt>
                <c:pt idx="1449">
                  <c:v>11.367000000000003</c:v>
                </c:pt>
                <c:pt idx="1450">
                  <c:v>11.372000000000002</c:v>
                </c:pt>
                <c:pt idx="1451">
                  <c:v>11.378</c:v>
                </c:pt>
                <c:pt idx="1452">
                  <c:v>11.384</c:v>
                </c:pt>
                <c:pt idx="1453">
                  <c:v>11.39</c:v>
                </c:pt>
                <c:pt idx="1454">
                  <c:v>11.395000000000001</c:v>
                </c:pt>
                <c:pt idx="1455">
                  <c:v>11.401</c:v>
                </c:pt>
                <c:pt idx="1456">
                  <c:v>11.407</c:v>
                </c:pt>
                <c:pt idx="1457">
                  <c:v>11.412000000000003</c:v>
                </c:pt>
                <c:pt idx="1458">
                  <c:v>11.418000000000001</c:v>
                </c:pt>
                <c:pt idx="1459">
                  <c:v>11.424000000000001</c:v>
                </c:pt>
                <c:pt idx="1460">
                  <c:v>11.43</c:v>
                </c:pt>
                <c:pt idx="1461">
                  <c:v>11.435</c:v>
                </c:pt>
                <c:pt idx="1462">
                  <c:v>11.441000000000001</c:v>
                </c:pt>
                <c:pt idx="1463">
                  <c:v>11.447000000000001</c:v>
                </c:pt>
                <c:pt idx="1464">
                  <c:v>11.452000000000002</c:v>
                </c:pt>
                <c:pt idx="1465">
                  <c:v>11.458</c:v>
                </c:pt>
                <c:pt idx="1466">
                  <c:v>11.464</c:v>
                </c:pt>
                <c:pt idx="1467">
                  <c:v>11.47</c:v>
                </c:pt>
                <c:pt idx="1468">
                  <c:v>11.475000000000001</c:v>
                </c:pt>
              </c:numCache>
            </c:numRef>
          </c:xVal>
          <c:yVal>
            <c:numRef>
              <c:f>'Spicellum roseum 8d YEPD'!$B$4:$B$1472</c:f>
              <c:numCache>
                <c:formatCode>General</c:formatCode>
                <c:ptCount val="1469"/>
                <c:pt idx="0">
                  <c:v>410</c:v>
                </c:pt>
                <c:pt idx="1">
                  <c:v>155</c:v>
                </c:pt>
                <c:pt idx="2">
                  <c:v>654</c:v>
                </c:pt>
                <c:pt idx="3">
                  <c:v>600</c:v>
                </c:pt>
                <c:pt idx="4">
                  <c:v>1017</c:v>
                </c:pt>
                <c:pt idx="5">
                  <c:v>840</c:v>
                </c:pt>
                <c:pt idx="6">
                  <c:v>1634</c:v>
                </c:pt>
                <c:pt idx="7">
                  <c:v>2622</c:v>
                </c:pt>
                <c:pt idx="8">
                  <c:v>2966</c:v>
                </c:pt>
                <c:pt idx="9">
                  <c:v>2727</c:v>
                </c:pt>
                <c:pt idx="10">
                  <c:v>4924</c:v>
                </c:pt>
                <c:pt idx="11">
                  <c:v>8933</c:v>
                </c:pt>
                <c:pt idx="12">
                  <c:v>14636</c:v>
                </c:pt>
                <c:pt idx="13">
                  <c:v>14958</c:v>
                </c:pt>
                <c:pt idx="14">
                  <c:v>10303</c:v>
                </c:pt>
                <c:pt idx="15">
                  <c:v>6953</c:v>
                </c:pt>
                <c:pt idx="16">
                  <c:v>6311</c:v>
                </c:pt>
                <c:pt idx="17">
                  <c:v>5006</c:v>
                </c:pt>
                <c:pt idx="18">
                  <c:v>3506</c:v>
                </c:pt>
                <c:pt idx="19">
                  <c:v>1371</c:v>
                </c:pt>
                <c:pt idx="20">
                  <c:v>961</c:v>
                </c:pt>
                <c:pt idx="21">
                  <c:v>1081</c:v>
                </c:pt>
                <c:pt idx="22">
                  <c:v>800</c:v>
                </c:pt>
                <c:pt idx="23">
                  <c:v>1404</c:v>
                </c:pt>
                <c:pt idx="24">
                  <c:v>5803</c:v>
                </c:pt>
                <c:pt idx="25">
                  <c:v>11854</c:v>
                </c:pt>
                <c:pt idx="26">
                  <c:v>11423</c:v>
                </c:pt>
                <c:pt idx="27">
                  <c:v>5941</c:v>
                </c:pt>
                <c:pt idx="28">
                  <c:v>2040</c:v>
                </c:pt>
                <c:pt idx="29">
                  <c:v>304</c:v>
                </c:pt>
                <c:pt idx="30">
                  <c:v>246</c:v>
                </c:pt>
                <c:pt idx="31">
                  <c:v>150</c:v>
                </c:pt>
                <c:pt idx="32">
                  <c:v>818</c:v>
                </c:pt>
                <c:pt idx="33">
                  <c:v>1721</c:v>
                </c:pt>
                <c:pt idx="34">
                  <c:v>2249</c:v>
                </c:pt>
                <c:pt idx="35">
                  <c:v>1851</c:v>
                </c:pt>
                <c:pt idx="36">
                  <c:v>3520</c:v>
                </c:pt>
                <c:pt idx="37">
                  <c:v>5628</c:v>
                </c:pt>
                <c:pt idx="38">
                  <c:v>4819</c:v>
                </c:pt>
                <c:pt idx="39">
                  <c:v>2469</c:v>
                </c:pt>
                <c:pt idx="40">
                  <c:v>1868</c:v>
                </c:pt>
                <c:pt idx="41">
                  <c:v>1525</c:v>
                </c:pt>
                <c:pt idx="42">
                  <c:v>1853</c:v>
                </c:pt>
                <c:pt idx="43">
                  <c:v>1197</c:v>
                </c:pt>
                <c:pt idx="44">
                  <c:v>1923</c:v>
                </c:pt>
                <c:pt idx="45">
                  <c:v>2461</c:v>
                </c:pt>
                <c:pt idx="46">
                  <c:v>1433</c:v>
                </c:pt>
                <c:pt idx="47">
                  <c:v>351</c:v>
                </c:pt>
                <c:pt idx="48">
                  <c:v>180</c:v>
                </c:pt>
                <c:pt idx="49">
                  <c:v>177</c:v>
                </c:pt>
                <c:pt idx="50">
                  <c:v>252</c:v>
                </c:pt>
                <c:pt idx="51">
                  <c:v>620</c:v>
                </c:pt>
                <c:pt idx="52">
                  <c:v>337</c:v>
                </c:pt>
                <c:pt idx="53">
                  <c:v>197</c:v>
                </c:pt>
                <c:pt idx="54">
                  <c:v>182</c:v>
                </c:pt>
                <c:pt idx="55">
                  <c:v>210</c:v>
                </c:pt>
                <c:pt idx="56">
                  <c:v>679</c:v>
                </c:pt>
                <c:pt idx="57">
                  <c:v>748</c:v>
                </c:pt>
                <c:pt idx="58">
                  <c:v>169</c:v>
                </c:pt>
                <c:pt idx="59">
                  <c:v>374</c:v>
                </c:pt>
                <c:pt idx="60">
                  <c:v>1001</c:v>
                </c:pt>
                <c:pt idx="61">
                  <c:v>1798</c:v>
                </c:pt>
                <c:pt idx="62">
                  <c:v>1334</c:v>
                </c:pt>
                <c:pt idx="63">
                  <c:v>1928</c:v>
                </c:pt>
                <c:pt idx="64">
                  <c:v>1778</c:v>
                </c:pt>
                <c:pt idx="65">
                  <c:v>793</c:v>
                </c:pt>
                <c:pt idx="66">
                  <c:v>153</c:v>
                </c:pt>
                <c:pt idx="67">
                  <c:v>1475</c:v>
                </c:pt>
                <c:pt idx="68">
                  <c:v>2506</c:v>
                </c:pt>
                <c:pt idx="69">
                  <c:v>5737</c:v>
                </c:pt>
                <c:pt idx="70">
                  <c:v>7016</c:v>
                </c:pt>
                <c:pt idx="71">
                  <c:v>5342</c:v>
                </c:pt>
                <c:pt idx="72">
                  <c:v>3769</c:v>
                </c:pt>
                <c:pt idx="73">
                  <c:v>2278</c:v>
                </c:pt>
                <c:pt idx="74">
                  <c:v>1756</c:v>
                </c:pt>
                <c:pt idx="75">
                  <c:v>3345</c:v>
                </c:pt>
                <c:pt idx="76">
                  <c:v>3862</c:v>
                </c:pt>
                <c:pt idx="77">
                  <c:v>1759</c:v>
                </c:pt>
                <c:pt idx="78">
                  <c:v>1024</c:v>
                </c:pt>
                <c:pt idx="79">
                  <c:v>605</c:v>
                </c:pt>
                <c:pt idx="80">
                  <c:v>1107</c:v>
                </c:pt>
                <c:pt idx="81">
                  <c:v>906</c:v>
                </c:pt>
                <c:pt idx="82">
                  <c:v>661</c:v>
                </c:pt>
                <c:pt idx="83">
                  <c:v>857</c:v>
                </c:pt>
                <c:pt idx="84">
                  <c:v>544</c:v>
                </c:pt>
                <c:pt idx="85">
                  <c:v>204</c:v>
                </c:pt>
                <c:pt idx="86">
                  <c:v>1192</c:v>
                </c:pt>
                <c:pt idx="87">
                  <c:v>1188</c:v>
                </c:pt>
                <c:pt idx="88">
                  <c:v>1439</c:v>
                </c:pt>
                <c:pt idx="89">
                  <c:v>1646</c:v>
                </c:pt>
                <c:pt idx="90">
                  <c:v>1496</c:v>
                </c:pt>
                <c:pt idx="91">
                  <c:v>1262</c:v>
                </c:pt>
                <c:pt idx="92">
                  <c:v>1535</c:v>
                </c:pt>
                <c:pt idx="93">
                  <c:v>1032</c:v>
                </c:pt>
                <c:pt idx="94">
                  <c:v>881</c:v>
                </c:pt>
                <c:pt idx="95">
                  <c:v>1378</c:v>
                </c:pt>
                <c:pt idx="96">
                  <c:v>1853</c:v>
                </c:pt>
                <c:pt idx="97">
                  <c:v>1349</c:v>
                </c:pt>
                <c:pt idx="98">
                  <c:v>1093</c:v>
                </c:pt>
                <c:pt idx="99">
                  <c:v>900</c:v>
                </c:pt>
                <c:pt idx="100">
                  <c:v>1069</c:v>
                </c:pt>
                <c:pt idx="101">
                  <c:v>505</c:v>
                </c:pt>
                <c:pt idx="102">
                  <c:v>1068</c:v>
                </c:pt>
                <c:pt idx="103">
                  <c:v>2188</c:v>
                </c:pt>
                <c:pt idx="104">
                  <c:v>2410</c:v>
                </c:pt>
                <c:pt idx="105">
                  <c:v>1508</c:v>
                </c:pt>
                <c:pt idx="106">
                  <c:v>1109</c:v>
                </c:pt>
                <c:pt idx="107">
                  <c:v>1154</c:v>
                </c:pt>
                <c:pt idx="108">
                  <c:v>194</c:v>
                </c:pt>
                <c:pt idx="109">
                  <c:v>692</c:v>
                </c:pt>
                <c:pt idx="110">
                  <c:v>2038</c:v>
                </c:pt>
                <c:pt idx="111">
                  <c:v>7893</c:v>
                </c:pt>
                <c:pt idx="112">
                  <c:v>12803</c:v>
                </c:pt>
                <c:pt idx="113">
                  <c:v>10093</c:v>
                </c:pt>
                <c:pt idx="114">
                  <c:v>4222</c:v>
                </c:pt>
                <c:pt idx="115">
                  <c:v>2213</c:v>
                </c:pt>
                <c:pt idx="116">
                  <c:v>3792</c:v>
                </c:pt>
                <c:pt idx="117">
                  <c:v>18190</c:v>
                </c:pt>
                <c:pt idx="118">
                  <c:v>39703</c:v>
                </c:pt>
                <c:pt idx="119">
                  <c:v>35652</c:v>
                </c:pt>
                <c:pt idx="120">
                  <c:v>13700</c:v>
                </c:pt>
                <c:pt idx="121">
                  <c:v>2499</c:v>
                </c:pt>
                <c:pt idx="122">
                  <c:v>1532</c:v>
                </c:pt>
                <c:pt idx="123">
                  <c:v>1885</c:v>
                </c:pt>
                <c:pt idx="124">
                  <c:v>2445</c:v>
                </c:pt>
                <c:pt idx="125">
                  <c:v>2500</c:v>
                </c:pt>
                <c:pt idx="126">
                  <c:v>1031</c:v>
                </c:pt>
                <c:pt idx="127">
                  <c:v>575</c:v>
                </c:pt>
                <c:pt idx="128">
                  <c:v>176</c:v>
                </c:pt>
                <c:pt idx="129">
                  <c:v>0</c:v>
                </c:pt>
                <c:pt idx="130">
                  <c:v>323</c:v>
                </c:pt>
                <c:pt idx="131">
                  <c:v>208</c:v>
                </c:pt>
                <c:pt idx="132">
                  <c:v>326</c:v>
                </c:pt>
                <c:pt idx="133">
                  <c:v>348</c:v>
                </c:pt>
                <c:pt idx="134">
                  <c:v>332</c:v>
                </c:pt>
                <c:pt idx="135">
                  <c:v>1665</c:v>
                </c:pt>
                <c:pt idx="136">
                  <c:v>2841</c:v>
                </c:pt>
                <c:pt idx="137">
                  <c:v>2892</c:v>
                </c:pt>
                <c:pt idx="138">
                  <c:v>1107</c:v>
                </c:pt>
                <c:pt idx="139">
                  <c:v>925</c:v>
                </c:pt>
                <c:pt idx="140">
                  <c:v>554</c:v>
                </c:pt>
                <c:pt idx="141">
                  <c:v>731</c:v>
                </c:pt>
                <c:pt idx="142">
                  <c:v>1235</c:v>
                </c:pt>
                <c:pt idx="143">
                  <c:v>549</c:v>
                </c:pt>
                <c:pt idx="144">
                  <c:v>195</c:v>
                </c:pt>
                <c:pt idx="145">
                  <c:v>1482</c:v>
                </c:pt>
                <c:pt idx="146">
                  <c:v>4981</c:v>
                </c:pt>
                <c:pt idx="147">
                  <c:v>6852</c:v>
                </c:pt>
                <c:pt idx="148">
                  <c:v>4268</c:v>
                </c:pt>
                <c:pt idx="149">
                  <c:v>1560</c:v>
                </c:pt>
                <c:pt idx="150">
                  <c:v>477</c:v>
                </c:pt>
                <c:pt idx="151">
                  <c:v>660</c:v>
                </c:pt>
                <c:pt idx="152">
                  <c:v>341</c:v>
                </c:pt>
                <c:pt idx="153">
                  <c:v>619</c:v>
                </c:pt>
                <c:pt idx="154">
                  <c:v>3279</c:v>
                </c:pt>
                <c:pt idx="155">
                  <c:v>11039</c:v>
                </c:pt>
                <c:pt idx="156">
                  <c:v>14883</c:v>
                </c:pt>
                <c:pt idx="157">
                  <c:v>8726</c:v>
                </c:pt>
                <c:pt idx="158">
                  <c:v>1585</c:v>
                </c:pt>
                <c:pt idx="159">
                  <c:v>816</c:v>
                </c:pt>
                <c:pt idx="160">
                  <c:v>1271</c:v>
                </c:pt>
                <c:pt idx="161">
                  <c:v>1278</c:v>
                </c:pt>
                <c:pt idx="162">
                  <c:v>1087</c:v>
                </c:pt>
                <c:pt idx="163">
                  <c:v>753</c:v>
                </c:pt>
                <c:pt idx="164">
                  <c:v>1259</c:v>
                </c:pt>
                <c:pt idx="165">
                  <c:v>1332</c:v>
                </c:pt>
                <c:pt idx="166">
                  <c:v>1031</c:v>
                </c:pt>
                <c:pt idx="167">
                  <c:v>1479</c:v>
                </c:pt>
                <c:pt idx="168">
                  <c:v>2056</c:v>
                </c:pt>
                <c:pt idx="169">
                  <c:v>2424</c:v>
                </c:pt>
                <c:pt idx="170">
                  <c:v>1388</c:v>
                </c:pt>
                <c:pt idx="171">
                  <c:v>673</c:v>
                </c:pt>
                <c:pt idx="172">
                  <c:v>363</c:v>
                </c:pt>
                <c:pt idx="173">
                  <c:v>544</c:v>
                </c:pt>
                <c:pt idx="174">
                  <c:v>929</c:v>
                </c:pt>
                <c:pt idx="175">
                  <c:v>3252</c:v>
                </c:pt>
                <c:pt idx="176">
                  <c:v>5244</c:v>
                </c:pt>
                <c:pt idx="177">
                  <c:v>4097</c:v>
                </c:pt>
                <c:pt idx="178">
                  <c:v>1723</c:v>
                </c:pt>
                <c:pt idx="179">
                  <c:v>653</c:v>
                </c:pt>
                <c:pt idx="180">
                  <c:v>159</c:v>
                </c:pt>
                <c:pt idx="181">
                  <c:v>766</c:v>
                </c:pt>
                <c:pt idx="182">
                  <c:v>1111</c:v>
                </c:pt>
                <c:pt idx="183">
                  <c:v>932</c:v>
                </c:pt>
                <c:pt idx="184">
                  <c:v>510</c:v>
                </c:pt>
                <c:pt idx="185">
                  <c:v>240</c:v>
                </c:pt>
                <c:pt idx="186">
                  <c:v>167</c:v>
                </c:pt>
                <c:pt idx="187">
                  <c:v>670</c:v>
                </c:pt>
                <c:pt idx="188">
                  <c:v>332</c:v>
                </c:pt>
                <c:pt idx="189">
                  <c:v>411</c:v>
                </c:pt>
                <c:pt idx="190">
                  <c:v>767</c:v>
                </c:pt>
                <c:pt idx="191">
                  <c:v>996</c:v>
                </c:pt>
                <c:pt idx="192">
                  <c:v>586</c:v>
                </c:pt>
                <c:pt idx="193">
                  <c:v>947</c:v>
                </c:pt>
                <c:pt idx="194">
                  <c:v>1214</c:v>
                </c:pt>
                <c:pt idx="195">
                  <c:v>1497</c:v>
                </c:pt>
                <c:pt idx="196">
                  <c:v>3472</c:v>
                </c:pt>
                <c:pt idx="197">
                  <c:v>9604</c:v>
                </c:pt>
                <c:pt idx="198">
                  <c:v>11356</c:v>
                </c:pt>
                <c:pt idx="199">
                  <c:v>5553</c:v>
                </c:pt>
                <c:pt idx="200">
                  <c:v>1321</c:v>
                </c:pt>
                <c:pt idx="201">
                  <c:v>1436</c:v>
                </c:pt>
                <c:pt idx="202">
                  <c:v>1599</c:v>
                </c:pt>
                <c:pt idx="203">
                  <c:v>820</c:v>
                </c:pt>
                <c:pt idx="204">
                  <c:v>659</c:v>
                </c:pt>
                <c:pt idx="205">
                  <c:v>612</c:v>
                </c:pt>
                <c:pt idx="206">
                  <c:v>860</c:v>
                </c:pt>
                <c:pt idx="207">
                  <c:v>1397</c:v>
                </c:pt>
                <c:pt idx="208">
                  <c:v>895</c:v>
                </c:pt>
                <c:pt idx="209">
                  <c:v>801</c:v>
                </c:pt>
                <c:pt idx="210">
                  <c:v>600</c:v>
                </c:pt>
                <c:pt idx="211">
                  <c:v>553</c:v>
                </c:pt>
                <c:pt idx="212">
                  <c:v>415</c:v>
                </c:pt>
                <c:pt idx="213">
                  <c:v>157</c:v>
                </c:pt>
                <c:pt idx="214">
                  <c:v>413</c:v>
                </c:pt>
                <c:pt idx="215">
                  <c:v>746</c:v>
                </c:pt>
                <c:pt idx="216">
                  <c:v>867</c:v>
                </c:pt>
                <c:pt idx="217">
                  <c:v>750</c:v>
                </c:pt>
                <c:pt idx="218">
                  <c:v>945</c:v>
                </c:pt>
                <c:pt idx="219">
                  <c:v>378</c:v>
                </c:pt>
                <c:pt idx="220">
                  <c:v>439</c:v>
                </c:pt>
                <c:pt idx="221">
                  <c:v>920</c:v>
                </c:pt>
                <c:pt idx="222">
                  <c:v>950</c:v>
                </c:pt>
                <c:pt idx="223">
                  <c:v>1167</c:v>
                </c:pt>
                <c:pt idx="224">
                  <c:v>1050</c:v>
                </c:pt>
                <c:pt idx="225">
                  <c:v>769</c:v>
                </c:pt>
                <c:pt idx="226">
                  <c:v>646</c:v>
                </c:pt>
                <c:pt idx="227">
                  <c:v>586</c:v>
                </c:pt>
                <c:pt idx="228">
                  <c:v>397</c:v>
                </c:pt>
                <c:pt idx="229">
                  <c:v>211</c:v>
                </c:pt>
                <c:pt idx="230">
                  <c:v>1267</c:v>
                </c:pt>
                <c:pt idx="231">
                  <c:v>1417</c:v>
                </c:pt>
                <c:pt idx="232">
                  <c:v>1484</c:v>
                </c:pt>
                <c:pt idx="233">
                  <c:v>1675</c:v>
                </c:pt>
                <c:pt idx="234">
                  <c:v>2422</c:v>
                </c:pt>
                <c:pt idx="235">
                  <c:v>1520</c:v>
                </c:pt>
                <c:pt idx="236">
                  <c:v>1278</c:v>
                </c:pt>
                <c:pt idx="237">
                  <c:v>810</c:v>
                </c:pt>
                <c:pt idx="238">
                  <c:v>1111</c:v>
                </c:pt>
                <c:pt idx="239">
                  <c:v>695</c:v>
                </c:pt>
                <c:pt idx="240">
                  <c:v>1046</c:v>
                </c:pt>
                <c:pt idx="241">
                  <c:v>322</c:v>
                </c:pt>
                <c:pt idx="242">
                  <c:v>212</c:v>
                </c:pt>
                <c:pt idx="243">
                  <c:v>362</c:v>
                </c:pt>
                <c:pt idx="244">
                  <c:v>874</c:v>
                </c:pt>
                <c:pt idx="245">
                  <c:v>182</c:v>
                </c:pt>
                <c:pt idx="246">
                  <c:v>362</c:v>
                </c:pt>
                <c:pt idx="247">
                  <c:v>392</c:v>
                </c:pt>
                <c:pt idx="248">
                  <c:v>561</c:v>
                </c:pt>
                <c:pt idx="249">
                  <c:v>1123</c:v>
                </c:pt>
                <c:pt idx="250">
                  <c:v>620</c:v>
                </c:pt>
                <c:pt idx="251">
                  <c:v>1330</c:v>
                </c:pt>
                <c:pt idx="252">
                  <c:v>1203</c:v>
                </c:pt>
                <c:pt idx="253">
                  <c:v>960</c:v>
                </c:pt>
                <c:pt idx="254">
                  <c:v>495</c:v>
                </c:pt>
                <c:pt idx="255">
                  <c:v>1012</c:v>
                </c:pt>
                <c:pt idx="256">
                  <c:v>565</c:v>
                </c:pt>
                <c:pt idx="257">
                  <c:v>575</c:v>
                </c:pt>
                <c:pt idx="258">
                  <c:v>967</c:v>
                </c:pt>
                <c:pt idx="259">
                  <c:v>746</c:v>
                </c:pt>
                <c:pt idx="260">
                  <c:v>699</c:v>
                </c:pt>
                <c:pt idx="261">
                  <c:v>755</c:v>
                </c:pt>
                <c:pt idx="262">
                  <c:v>551</c:v>
                </c:pt>
                <c:pt idx="263">
                  <c:v>942</c:v>
                </c:pt>
                <c:pt idx="264">
                  <c:v>1086</c:v>
                </c:pt>
                <c:pt idx="265">
                  <c:v>1174</c:v>
                </c:pt>
                <c:pt idx="266">
                  <c:v>1388</c:v>
                </c:pt>
                <c:pt idx="267">
                  <c:v>917</c:v>
                </c:pt>
                <c:pt idx="268">
                  <c:v>1054</c:v>
                </c:pt>
                <c:pt idx="269">
                  <c:v>593</c:v>
                </c:pt>
                <c:pt idx="270">
                  <c:v>604</c:v>
                </c:pt>
                <c:pt idx="271">
                  <c:v>2061</c:v>
                </c:pt>
                <c:pt idx="272">
                  <c:v>3102</c:v>
                </c:pt>
                <c:pt idx="273">
                  <c:v>2164</c:v>
                </c:pt>
                <c:pt idx="274">
                  <c:v>1592</c:v>
                </c:pt>
                <c:pt idx="275">
                  <c:v>811</c:v>
                </c:pt>
                <c:pt idx="276">
                  <c:v>573</c:v>
                </c:pt>
                <c:pt idx="277">
                  <c:v>1228</c:v>
                </c:pt>
                <c:pt idx="278">
                  <c:v>1908</c:v>
                </c:pt>
                <c:pt idx="279">
                  <c:v>2679</c:v>
                </c:pt>
                <c:pt idx="280">
                  <c:v>2182</c:v>
                </c:pt>
                <c:pt idx="281">
                  <c:v>1449</c:v>
                </c:pt>
                <c:pt idx="282">
                  <c:v>1278</c:v>
                </c:pt>
                <c:pt idx="283">
                  <c:v>2315</c:v>
                </c:pt>
                <c:pt idx="284">
                  <c:v>4748</c:v>
                </c:pt>
                <c:pt idx="285">
                  <c:v>14881</c:v>
                </c:pt>
                <c:pt idx="286">
                  <c:v>24274</c:v>
                </c:pt>
                <c:pt idx="287">
                  <c:v>18910</c:v>
                </c:pt>
                <c:pt idx="288">
                  <c:v>7970</c:v>
                </c:pt>
                <c:pt idx="289">
                  <c:v>3467</c:v>
                </c:pt>
                <c:pt idx="290">
                  <c:v>2498</c:v>
                </c:pt>
                <c:pt idx="291">
                  <c:v>2192</c:v>
                </c:pt>
                <c:pt idx="292">
                  <c:v>2340</c:v>
                </c:pt>
                <c:pt idx="293">
                  <c:v>2612</c:v>
                </c:pt>
                <c:pt idx="294">
                  <c:v>4489</c:v>
                </c:pt>
                <c:pt idx="295">
                  <c:v>4651</c:v>
                </c:pt>
                <c:pt idx="296">
                  <c:v>3910</c:v>
                </c:pt>
                <c:pt idx="297">
                  <c:v>2831</c:v>
                </c:pt>
                <c:pt idx="298">
                  <c:v>2870</c:v>
                </c:pt>
                <c:pt idx="299">
                  <c:v>1520</c:v>
                </c:pt>
                <c:pt idx="300">
                  <c:v>1400</c:v>
                </c:pt>
                <c:pt idx="301">
                  <c:v>872</c:v>
                </c:pt>
                <c:pt idx="302">
                  <c:v>767</c:v>
                </c:pt>
                <c:pt idx="303">
                  <c:v>1962</c:v>
                </c:pt>
                <c:pt idx="304">
                  <c:v>3469</c:v>
                </c:pt>
                <c:pt idx="305">
                  <c:v>12878</c:v>
                </c:pt>
                <c:pt idx="306">
                  <c:v>28870</c:v>
                </c:pt>
                <c:pt idx="307">
                  <c:v>30038</c:v>
                </c:pt>
                <c:pt idx="308">
                  <c:v>17155</c:v>
                </c:pt>
                <c:pt idx="309">
                  <c:v>7500</c:v>
                </c:pt>
                <c:pt idx="310">
                  <c:v>3695</c:v>
                </c:pt>
                <c:pt idx="311">
                  <c:v>1561</c:v>
                </c:pt>
                <c:pt idx="312">
                  <c:v>2156</c:v>
                </c:pt>
                <c:pt idx="313">
                  <c:v>2442</c:v>
                </c:pt>
                <c:pt idx="314">
                  <c:v>7539</c:v>
                </c:pt>
                <c:pt idx="315">
                  <c:v>11575</c:v>
                </c:pt>
                <c:pt idx="316">
                  <c:v>8479</c:v>
                </c:pt>
                <c:pt idx="317">
                  <c:v>4397</c:v>
                </c:pt>
                <c:pt idx="318">
                  <c:v>3399</c:v>
                </c:pt>
                <c:pt idx="319">
                  <c:v>3183</c:v>
                </c:pt>
                <c:pt idx="320">
                  <c:v>4301</c:v>
                </c:pt>
                <c:pt idx="321">
                  <c:v>4577</c:v>
                </c:pt>
                <c:pt idx="322">
                  <c:v>3875</c:v>
                </c:pt>
                <c:pt idx="323">
                  <c:v>1892</c:v>
                </c:pt>
                <c:pt idx="324">
                  <c:v>1712</c:v>
                </c:pt>
                <c:pt idx="325">
                  <c:v>1589</c:v>
                </c:pt>
                <c:pt idx="326">
                  <c:v>2927</c:v>
                </c:pt>
                <c:pt idx="327">
                  <c:v>3692</c:v>
                </c:pt>
                <c:pt idx="328">
                  <c:v>5458</c:v>
                </c:pt>
                <c:pt idx="329">
                  <c:v>26599</c:v>
                </c:pt>
                <c:pt idx="330">
                  <c:v>117672</c:v>
                </c:pt>
                <c:pt idx="331">
                  <c:v>215538</c:v>
                </c:pt>
                <c:pt idx="332">
                  <c:v>146518</c:v>
                </c:pt>
                <c:pt idx="333">
                  <c:v>41402</c:v>
                </c:pt>
                <c:pt idx="334">
                  <c:v>11637</c:v>
                </c:pt>
                <c:pt idx="335">
                  <c:v>8925</c:v>
                </c:pt>
                <c:pt idx="336">
                  <c:v>6571</c:v>
                </c:pt>
                <c:pt idx="337">
                  <c:v>4508</c:v>
                </c:pt>
                <c:pt idx="338">
                  <c:v>5011</c:v>
                </c:pt>
                <c:pt idx="339">
                  <c:v>7001</c:v>
                </c:pt>
                <c:pt idx="340">
                  <c:v>10393</c:v>
                </c:pt>
                <c:pt idx="341">
                  <c:v>10760</c:v>
                </c:pt>
                <c:pt idx="342">
                  <c:v>9788</c:v>
                </c:pt>
                <c:pt idx="343">
                  <c:v>7328</c:v>
                </c:pt>
                <c:pt idx="344">
                  <c:v>5370</c:v>
                </c:pt>
                <c:pt idx="345">
                  <c:v>5665</c:v>
                </c:pt>
                <c:pt idx="346">
                  <c:v>4247</c:v>
                </c:pt>
                <c:pt idx="347">
                  <c:v>4579</c:v>
                </c:pt>
                <c:pt idx="348">
                  <c:v>2721</c:v>
                </c:pt>
                <c:pt idx="349">
                  <c:v>4003</c:v>
                </c:pt>
                <c:pt idx="350">
                  <c:v>4999</c:v>
                </c:pt>
                <c:pt idx="351">
                  <c:v>6175</c:v>
                </c:pt>
                <c:pt idx="352">
                  <c:v>8122</c:v>
                </c:pt>
                <c:pt idx="353">
                  <c:v>7223</c:v>
                </c:pt>
                <c:pt idx="354">
                  <c:v>7219</c:v>
                </c:pt>
                <c:pt idx="355">
                  <c:v>5517</c:v>
                </c:pt>
                <c:pt idx="356">
                  <c:v>4517</c:v>
                </c:pt>
                <c:pt idx="357">
                  <c:v>5372</c:v>
                </c:pt>
                <c:pt idx="358">
                  <c:v>9153</c:v>
                </c:pt>
                <c:pt idx="359">
                  <c:v>12346</c:v>
                </c:pt>
                <c:pt idx="360">
                  <c:v>17206</c:v>
                </c:pt>
                <c:pt idx="361">
                  <c:v>24232</c:v>
                </c:pt>
                <c:pt idx="362">
                  <c:v>29018</c:v>
                </c:pt>
                <c:pt idx="363">
                  <c:v>23055</c:v>
                </c:pt>
                <c:pt idx="364">
                  <c:v>19836</c:v>
                </c:pt>
                <c:pt idx="365">
                  <c:v>20674</c:v>
                </c:pt>
                <c:pt idx="366">
                  <c:v>14191</c:v>
                </c:pt>
                <c:pt idx="367">
                  <c:v>10588</c:v>
                </c:pt>
                <c:pt idx="368">
                  <c:v>7832</c:v>
                </c:pt>
                <c:pt idx="369">
                  <c:v>10136</c:v>
                </c:pt>
                <c:pt idx="370">
                  <c:v>9843</c:v>
                </c:pt>
                <c:pt idx="371">
                  <c:v>6605</c:v>
                </c:pt>
                <c:pt idx="372">
                  <c:v>5191</c:v>
                </c:pt>
                <c:pt idx="373">
                  <c:v>5669</c:v>
                </c:pt>
                <c:pt idx="374">
                  <c:v>5030</c:v>
                </c:pt>
                <c:pt idx="375">
                  <c:v>4360</c:v>
                </c:pt>
                <c:pt idx="376">
                  <c:v>4746</c:v>
                </c:pt>
                <c:pt idx="377">
                  <c:v>4197</c:v>
                </c:pt>
                <c:pt idx="378">
                  <c:v>4815</c:v>
                </c:pt>
                <c:pt idx="379">
                  <c:v>3405</c:v>
                </c:pt>
                <c:pt idx="380">
                  <c:v>8134</c:v>
                </c:pt>
                <c:pt idx="381">
                  <c:v>21148</c:v>
                </c:pt>
                <c:pt idx="382">
                  <c:v>29673</c:v>
                </c:pt>
                <c:pt idx="383">
                  <c:v>18037</c:v>
                </c:pt>
                <c:pt idx="384">
                  <c:v>7170</c:v>
                </c:pt>
                <c:pt idx="385">
                  <c:v>3441</c:v>
                </c:pt>
                <c:pt idx="386">
                  <c:v>3991</c:v>
                </c:pt>
                <c:pt idx="387">
                  <c:v>4415</c:v>
                </c:pt>
                <c:pt idx="388">
                  <c:v>4446</c:v>
                </c:pt>
                <c:pt idx="389">
                  <c:v>5670</c:v>
                </c:pt>
                <c:pt idx="390">
                  <c:v>7852</c:v>
                </c:pt>
                <c:pt idx="391">
                  <c:v>9418</c:v>
                </c:pt>
                <c:pt idx="392">
                  <c:v>10721</c:v>
                </c:pt>
                <c:pt idx="393">
                  <c:v>9006</c:v>
                </c:pt>
                <c:pt idx="394">
                  <c:v>9300</c:v>
                </c:pt>
                <c:pt idx="395">
                  <c:v>8680</c:v>
                </c:pt>
                <c:pt idx="396">
                  <c:v>7253</c:v>
                </c:pt>
                <c:pt idx="397">
                  <c:v>6352</c:v>
                </c:pt>
                <c:pt idx="398">
                  <c:v>4772</c:v>
                </c:pt>
                <c:pt idx="399">
                  <c:v>4925</c:v>
                </c:pt>
                <c:pt idx="400">
                  <c:v>4124</c:v>
                </c:pt>
                <c:pt idx="401">
                  <c:v>4939</c:v>
                </c:pt>
                <c:pt idx="402">
                  <c:v>5160</c:v>
                </c:pt>
                <c:pt idx="403">
                  <c:v>4807</c:v>
                </c:pt>
                <c:pt idx="404">
                  <c:v>5248</c:v>
                </c:pt>
                <c:pt idx="405">
                  <c:v>5217</c:v>
                </c:pt>
                <c:pt idx="406">
                  <c:v>5719</c:v>
                </c:pt>
                <c:pt idx="407">
                  <c:v>7360</c:v>
                </c:pt>
                <c:pt idx="408">
                  <c:v>6261</c:v>
                </c:pt>
                <c:pt idx="409">
                  <c:v>7841</c:v>
                </c:pt>
                <c:pt idx="410">
                  <c:v>8694</c:v>
                </c:pt>
                <c:pt idx="411">
                  <c:v>7947</c:v>
                </c:pt>
                <c:pt idx="412">
                  <c:v>6783</c:v>
                </c:pt>
                <c:pt idx="413">
                  <c:v>6915</c:v>
                </c:pt>
                <c:pt idx="414">
                  <c:v>5987</c:v>
                </c:pt>
                <c:pt idx="415">
                  <c:v>5733</c:v>
                </c:pt>
                <c:pt idx="416">
                  <c:v>5653</c:v>
                </c:pt>
                <c:pt idx="417">
                  <c:v>5790</c:v>
                </c:pt>
                <c:pt idx="418">
                  <c:v>6898</c:v>
                </c:pt>
                <c:pt idx="419">
                  <c:v>5738</c:v>
                </c:pt>
                <c:pt idx="420">
                  <c:v>7474</c:v>
                </c:pt>
                <c:pt idx="421">
                  <c:v>7115</c:v>
                </c:pt>
                <c:pt idx="422">
                  <c:v>7063</c:v>
                </c:pt>
                <c:pt idx="423">
                  <c:v>6871</c:v>
                </c:pt>
                <c:pt idx="424">
                  <c:v>6218</c:v>
                </c:pt>
                <c:pt idx="425">
                  <c:v>6982</c:v>
                </c:pt>
                <c:pt idx="426">
                  <c:v>7179</c:v>
                </c:pt>
                <c:pt idx="427">
                  <c:v>8033</c:v>
                </c:pt>
                <c:pt idx="428">
                  <c:v>7902</c:v>
                </c:pt>
                <c:pt idx="429">
                  <c:v>7684</c:v>
                </c:pt>
                <c:pt idx="430">
                  <c:v>8929</c:v>
                </c:pt>
                <c:pt idx="431">
                  <c:v>8728</c:v>
                </c:pt>
                <c:pt idx="432">
                  <c:v>9783</c:v>
                </c:pt>
                <c:pt idx="433">
                  <c:v>8272</c:v>
                </c:pt>
                <c:pt idx="434">
                  <c:v>7177</c:v>
                </c:pt>
                <c:pt idx="435">
                  <c:v>6868</c:v>
                </c:pt>
                <c:pt idx="436">
                  <c:v>7301</c:v>
                </c:pt>
                <c:pt idx="437">
                  <c:v>8210</c:v>
                </c:pt>
                <c:pt idx="438">
                  <c:v>7085</c:v>
                </c:pt>
                <c:pt idx="439">
                  <c:v>8829</c:v>
                </c:pt>
                <c:pt idx="440">
                  <c:v>10003</c:v>
                </c:pt>
                <c:pt idx="441">
                  <c:v>10157</c:v>
                </c:pt>
                <c:pt idx="442">
                  <c:v>7702</c:v>
                </c:pt>
                <c:pt idx="443">
                  <c:v>9263</c:v>
                </c:pt>
                <c:pt idx="444">
                  <c:v>10151</c:v>
                </c:pt>
                <c:pt idx="445">
                  <c:v>9585</c:v>
                </c:pt>
                <c:pt idx="446">
                  <c:v>9132</c:v>
                </c:pt>
                <c:pt idx="447">
                  <c:v>8562</c:v>
                </c:pt>
                <c:pt idx="448">
                  <c:v>8791</c:v>
                </c:pt>
                <c:pt idx="449">
                  <c:v>8192</c:v>
                </c:pt>
                <c:pt idx="450">
                  <c:v>7410</c:v>
                </c:pt>
                <c:pt idx="451">
                  <c:v>6782</c:v>
                </c:pt>
                <c:pt idx="452">
                  <c:v>7725</c:v>
                </c:pt>
                <c:pt idx="453">
                  <c:v>6677</c:v>
                </c:pt>
                <c:pt idx="454">
                  <c:v>6629</c:v>
                </c:pt>
                <c:pt idx="455">
                  <c:v>7301</c:v>
                </c:pt>
                <c:pt idx="456">
                  <c:v>8132</c:v>
                </c:pt>
                <c:pt idx="457">
                  <c:v>8098</c:v>
                </c:pt>
                <c:pt idx="458">
                  <c:v>11579</c:v>
                </c:pt>
                <c:pt idx="459">
                  <c:v>15426</c:v>
                </c:pt>
                <c:pt idx="460">
                  <c:v>16064</c:v>
                </c:pt>
                <c:pt idx="461">
                  <c:v>12008</c:v>
                </c:pt>
                <c:pt idx="462">
                  <c:v>7672</c:v>
                </c:pt>
                <c:pt idx="463">
                  <c:v>7320</c:v>
                </c:pt>
                <c:pt idx="464">
                  <c:v>5995</c:v>
                </c:pt>
                <c:pt idx="465">
                  <c:v>5818</c:v>
                </c:pt>
                <c:pt idx="466">
                  <c:v>6660</c:v>
                </c:pt>
                <c:pt idx="467">
                  <c:v>9760</c:v>
                </c:pt>
                <c:pt idx="468">
                  <c:v>10690</c:v>
                </c:pt>
                <c:pt idx="469">
                  <c:v>13591</c:v>
                </c:pt>
                <c:pt idx="470">
                  <c:v>19553</c:v>
                </c:pt>
                <c:pt idx="471">
                  <c:v>25735</c:v>
                </c:pt>
                <c:pt idx="472">
                  <c:v>18635</c:v>
                </c:pt>
                <c:pt idx="473">
                  <c:v>11353</c:v>
                </c:pt>
                <c:pt idx="474">
                  <c:v>8964</c:v>
                </c:pt>
                <c:pt idx="475">
                  <c:v>8044</c:v>
                </c:pt>
                <c:pt idx="476">
                  <c:v>9391</c:v>
                </c:pt>
                <c:pt idx="477">
                  <c:v>9507</c:v>
                </c:pt>
                <c:pt idx="478">
                  <c:v>8780</c:v>
                </c:pt>
                <c:pt idx="479">
                  <c:v>8801</c:v>
                </c:pt>
                <c:pt idx="480">
                  <c:v>10120</c:v>
                </c:pt>
                <c:pt idx="481">
                  <c:v>9224</c:v>
                </c:pt>
                <c:pt idx="482">
                  <c:v>9728</c:v>
                </c:pt>
                <c:pt idx="483">
                  <c:v>9026</c:v>
                </c:pt>
                <c:pt idx="484">
                  <c:v>8534</c:v>
                </c:pt>
                <c:pt idx="485">
                  <c:v>8991</c:v>
                </c:pt>
                <c:pt idx="486">
                  <c:v>8790</c:v>
                </c:pt>
                <c:pt idx="487">
                  <c:v>7968</c:v>
                </c:pt>
                <c:pt idx="488">
                  <c:v>7770</c:v>
                </c:pt>
                <c:pt idx="489">
                  <c:v>7590</c:v>
                </c:pt>
                <c:pt idx="490">
                  <c:v>8567</c:v>
                </c:pt>
                <c:pt idx="491">
                  <c:v>7186</c:v>
                </c:pt>
                <c:pt idx="492">
                  <c:v>6702</c:v>
                </c:pt>
                <c:pt idx="493">
                  <c:v>8002</c:v>
                </c:pt>
                <c:pt idx="494">
                  <c:v>8721</c:v>
                </c:pt>
                <c:pt idx="495">
                  <c:v>8976</c:v>
                </c:pt>
                <c:pt idx="496">
                  <c:v>10165</c:v>
                </c:pt>
                <c:pt idx="497">
                  <c:v>8799</c:v>
                </c:pt>
                <c:pt idx="498">
                  <c:v>8010</c:v>
                </c:pt>
                <c:pt idx="499">
                  <c:v>8016</c:v>
                </c:pt>
                <c:pt idx="500">
                  <c:v>8160</c:v>
                </c:pt>
                <c:pt idx="501">
                  <c:v>8639</c:v>
                </c:pt>
                <c:pt idx="502">
                  <c:v>7717</c:v>
                </c:pt>
                <c:pt idx="503">
                  <c:v>8573</c:v>
                </c:pt>
                <c:pt idx="504">
                  <c:v>7429</c:v>
                </c:pt>
                <c:pt idx="505">
                  <c:v>9090</c:v>
                </c:pt>
                <c:pt idx="506">
                  <c:v>8785</c:v>
                </c:pt>
                <c:pt idx="507">
                  <c:v>9312</c:v>
                </c:pt>
                <c:pt idx="508">
                  <c:v>10132</c:v>
                </c:pt>
                <c:pt idx="509">
                  <c:v>9275</c:v>
                </c:pt>
                <c:pt idx="510">
                  <c:v>8172</c:v>
                </c:pt>
                <c:pt idx="511">
                  <c:v>7918</c:v>
                </c:pt>
                <c:pt idx="512">
                  <c:v>6689</c:v>
                </c:pt>
                <c:pt idx="513">
                  <c:v>7746</c:v>
                </c:pt>
                <c:pt idx="514">
                  <c:v>7563</c:v>
                </c:pt>
                <c:pt idx="515">
                  <c:v>7677</c:v>
                </c:pt>
                <c:pt idx="516">
                  <c:v>8573</c:v>
                </c:pt>
                <c:pt idx="517">
                  <c:v>10403</c:v>
                </c:pt>
                <c:pt idx="518">
                  <c:v>32594</c:v>
                </c:pt>
                <c:pt idx="519">
                  <c:v>101182</c:v>
                </c:pt>
                <c:pt idx="520">
                  <c:v>183369</c:v>
                </c:pt>
                <c:pt idx="521">
                  <c:v>161825</c:v>
                </c:pt>
                <c:pt idx="522">
                  <c:v>84281</c:v>
                </c:pt>
                <c:pt idx="523">
                  <c:v>31289</c:v>
                </c:pt>
                <c:pt idx="524">
                  <c:v>17897</c:v>
                </c:pt>
                <c:pt idx="525">
                  <c:v>18319</c:v>
                </c:pt>
                <c:pt idx="526">
                  <c:v>54454</c:v>
                </c:pt>
                <c:pt idx="527">
                  <c:v>186371</c:v>
                </c:pt>
                <c:pt idx="528">
                  <c:v>422569</c:v>
                </c:pt>
                <c:pt idx="529">
                  <c:v>508724</c:v>
                </c:pt>
                <c:pt idx="530">
                  <c:v>336016</c:v>
                </c:pt>
                <c:pt idx="531">
                  <c:v>139480</c:v>
                </c:pt>
                <c:pt idx="532">
                  <c:v>58879</c:v>
                </c:pt>
                <c:pt idx="533">
                  <c:v>34138</c:v>
                </c:pt>
                <c:pt idx="534">
                  <c:v>26336</c:v>
                </c:pt>
                <c:pt idx="535">
                  <c:v>22036</c:v>
                </c:pt>
                <c:pt idx="536">
                  <c:v>18854</c:v>
                </c:pt>
                <c:pt idx="537">
                  <c:v>17413</c:v>
                </c:pt>
                <c:pt idx="538">
                  <c:v>15181</c:v>
                </c:pt>
                <c:pt idx="539">
                  <c:v>14298</c:v>
                </c:pt>
                <c:pt idx="540">
                  <c:v>13618</c:v>
                </c:pt>
                <c:pt idx="541">
                  <c:v>13205</c:v>
                </c:pt>
                <c:pt idx="542">
                  <c:v>12299</c:v>
                </c:pt>
                <c:pt idx="543">
                  <c:v>11969</c:v>
                </c:pt>
                <c:pt idx="544">
                  <c:v>11317</c:v>
                </c:pt>
                <c:pt idx="545">
                  <c:v>13315</c:v>
                </c:pt>
                <c:pt idx="546">
                  <c:v>14055</c:v>
                </c:pt>
                <c:pt idx="547">
                  <c:v>14709</c:v>
                </c:pt>
                <c:pt idx="548">
                  <c:v>15220</c:v>
                </c:pt>
                <c:pt idx="549">
                  <c:v>14205</c:v>
                </c:pt>
                <c:pt idx="550">
                  <c:v>13078</c:v>
                </c:pt>
                <c:pt idx="551">
                  <c:v>11012</c:v>
                </c:pt>
                <c:pt idx="552">
                  <c:v>10863</c:v>
                </c:pt>
                <c:pt idx="553">
                  <c:v>11336</c:v>
                </c:pt>
                <c:pt idx="554">
                  <c:v>11598</c:v>
                </c:pt>
                <c:pt idx="555">
                  <c:v>10831</c:v>
                </c:pt>
                <c:pt idx="556">
                  <c:v>9915</c:v>
                </c:pt>
                <c:pt idx="557">
                  <c:v>9517</c:v>
                </c:pt>
                <c:pt idx="558">
                  <c:v>10450</c:v>
                </c:pt>
                <c:pt idx="559">
                  <c:v>8425</c:v>
                </c:pt>
                <c:pt idx="560">
                  <c:v>9302</c:v>
                </c:pt>
                <c:pt idx="561">
                  <c:v>8842</c:v>
                </c:pt>
                <c:pt idx="562">
                  <c:v>9624</c:v>
                </c:pt>
                <c:pt idx="563">
                  <c:v>8045</c:v>
                </c:pt>
                <c:pt idx="564">
                  <c:v>10338</c:v>
                </c:pt>
                <c:pt idx="565">
                  <c:v>8957</c:v>
                </c:pt>
                <c:pt idx="566">
                  <c:v>10763</c:v>
                </c:pt>
                <c:pt idx="567">
                  <c:v>9717</c:v>
                </c:pt>
                <c:pt idx="568">
                  <c:v>11641</c:v>
                </c:pt>
                <c:pt idx="569">
                  <c:v>13034</c:v>
                </c:pt>
                <c:pt idx="570">
                  <c:v>14874</c:v>
                </c:pt>
                <c:pt idx="571">
                  <c:v>14226</c:v>
                </c:pt>
                <c:pt idx="572">
                  <c:v>13275</c:v>
                </c:pt>
                <c:pt idx="573">
                  <c:v>9995</c:v>
                </c:pt>
                <c:pt idx="574">
                  <c:v>11101</c:v>
                </c:pt>
                <c:pt idx="575">
                  <c:v>9928</c:v>
                </c:pt>
                <c:pt idx="576">
                  <c:v>8839</c:v>
                </c:pt>
                <c:pt idx="577">
                  <c:v>7796</c:v>
                </c:pt>
                <c:pt idx="578">
                  <c:v>8481</c:v>
                </c:pt>
                <c:pt idx="579">
                  <c:v>8278</c:v>
                </c:pt>
                <c:pt idx="580">
                  <c:v>8501</c:v>
                </c:pt>
                <c:pt idx="581">
                  <c:v>8842</c:v>
                </c:pt>
                <c:pt idx="582">
                  <c:v>8248</c:v>
                </c:pt>
                <c:pt idx="583">
                  <c:v>7529</c:v>
                </c:pt>
                <c:pt idx="584">
                  <c:v>9644</c:v>
                </c:pt>
                <c:pt idx="585">
                  <c:v>9198</c:v>
                </c:pt>
                <c:pt idx="586">
                  <c:v>9624</c:v>
                </c:pt>
                <c:pt idx="587">
                  <c:v>8915</c:v>
                </c:pt>
                <c:pt idx="588">
                  <c:v>8477</c:v>
                </c:pt>
                <c:pt idx="589">
                  <c:v>9406</c:v>
                </c:pt>
                <c:pt idx="590">
                  <c:v>8021</c:v>
                </c:pt>
                <c:pt idx="591">
                  <c:v>6848</c:v>
                </c:pt>
                <c:pt idx="592">
                  <c:v>8723</c:v>
                </c:pt>
                <c:pt idx="593">
                  <c:v>8395</c:v>
                </c:pt>
                <c:pt idx="594">
                  <c:v>8110</c:v>
                </c:pt>
                <c:pt idx="595">
                  <c:v>9310</c:v>
                </c:pt>
                <c:pt idx="596">
                  <c:v>9871</c:v>
                </c:pt>
                <c:pt idx="597">
                  <c:v>10680</c:v>
                </c:pt>
                <c:pt idx="598">
                  <c:v>12372</c:v>
                </c:pt>
                <c:pt idx="599">
                  <c:v>13234</c:v>
                </c:pt>
                <c:pt idx="600">
                  <c:v>11153</c:v>
                </c:pt>
                <c:pt idx="601">
                  <c:v>12728</c:v>
                </c:pt>
                <c:pt idx="602">
                  <c:v>12115</c:v>
                </c:pt>
                <c:pt idx="603">
                  <c:v>12639</c:v>
                </c:pt>
                <c:pt idx="604">
                  <c:v>13911</c:v>
                </c:pt>
                <c:pt idx="605">
                  <c:v>14213</c:v>
                </c:pt>
                <c:pt idx="606">
                  <c:v>17797</c:v>
                </c:pt>
                <c:pt idx="607">
                  <c:v>24212</c:v>
                </c:pt>
                <c:pt idx="608">
                  <c:v>28496</c:v>
                </c:pt>
                <c:pt idx="609">
                  <c:v>23441</c:v>
                </c:pt>
                <c:pt idx="610">
                  <c:v>17760</c:v>
                </c:pt>
                <c:pt idx="611">
                  <c:v>14181</c:v>
                </c:pt>
                <c:pt idx="612">
                  <c:v>12699</c:v>
                </c:pt>
                <c:pt idx="613">
                  <c:v>12904</c:v>
                </c:pt>
                <c:pt idx="614">
                  <c:v>11170</c:v>
                </c:pt>
                <c:pt idx="615">
                  <c:v>11258</c:v>
                </c:pt>
                <c:pt idx="616">
                  <c:v>11047</c:v>
                </c:pt>
                <c:pt idx="617">
                  <c:v>12057</c:v>
                </c:pt>
                <c:pt idx="618">
                  <c:v>10946</c:v>
                </c:pt>
                <c:pt idx="619">
                  <c:v>11685</c:v>
                </c:pt>
                <c:pt idx="620">
                  <c:v>11973</c:v>
                </c:pt>
                <c:pt idx="621">
                  <c:v>10555</c:v>
                </c:pt>
                <c:pt idx="622">
                  <c:v>12341</c:v>
                </c:pt>
                <c:pt idx="623">
                  <c:v>12422</c:v>
                </c:pt>
                <c:pt idx="624">
                  <c:v>11114</c:v>
                </c:pt>
                <c:pt idx="625">
                  <c:v>13015</c:v>
                </c:pt>
                <c:pt idx="626">
                  <c:v>13650</c:v>
                </c:pt>
                <c:pt idx="627">
                  <c:v>15470</c:v>
                </c:pt>
                <c:pt idx="628">
                  <c:v>15075</c:v>
                </c:pt>
                <c:pt idx="629">
                  <c:v>14077</c:v>
                </c:pt>
                <c:pt idx="630">
                  <c:v>12444</c:v>
                </c:pt>
                <c:pt idx="631">
                  <c:v>10360</c:v>
                </c:pt>
                <c:pt idx="632">
                  <c:v>10017</c:v>
                </c:pt>
                <c:pt idx="633">
                  <c:v>10785</c:v>
                </c:pt>
                <c:pt idx="634">
                  <c:v>10685</c:v>
                </c:pt>
                <c:pt idx="635">
                  <c:v>9925</c:v>
                </c:pt>
                <c:pt idx="636">
                  <c:v>9717</c:v>
                </c:pt>
                <c:pt idx="637">
                  <c:v>10026</c:v>
                </c:pt>
                <c:pt idx="638">
                  <c:v>10285</c:v>
                </c:pt>
                <c:pt idx="639">
                  <c:v>9451</c:v>
                </c:pt>
                <c:pt idx="640">
                  <c:v>8763</c:v>
                </c:pt>
                <c:pt idx="641">
                  <c:v>8353</c:v>
                </c:pt>
                <c:pt idx="642">
                  <c:v>8152</c:v>
                </c:pt>
                <c:pt idx="643">
                  <c:v>8311</c:v>
                </c:pt>
                <c:pt idx="644">
                  <c:v>8598</c:v>
                </c:pt>
                <c:pt idx="645">
                  <c:v>7351</c:v>
                </c:pt>
                <c:pt idx="646">
                  <c:v>7184</c:v>
                </c:pt>
                <c:pt idx="647">
                  <c:v>7345</c:v>
                </c:pt>
                <c:pt idx="648">
                  <c:v>8560</c:v>
                </c:pt>
                <c:pt idx="649">
                  <c:v>7341</c:v>
                </c:pt>
                <c:pt idx="650">
                  <c:v>6761</c:v>
                </c:pt>
                <c:pt idx="651">
                  <c:v>7505</c:v>
                </c:pt>
                <c:pt idx="652">
                  <c:v>7223</c:v>
                </c:pt>
                <c:pt idx="653">
                  <c:v>7756</c:v>
                </c:pt>
                <c:pt idx="654">
                  <c:v>7354</c:v>
                </c:pt>
                <c:pt idx="655">
                  <c:v>8189</c:v>
                </c:pt>
                <c:pt idx="656">
                  <c:v>8112</c:v>
                </c:pt>
                <c:pt idx="657">
                  <c:v>11033</c:v>
                </c:pt>
                <c:pt idx="658">
                  <c:v>14206</c:v>
                </c:pt>
                <c:pt idx="659">
                  <c:v>12392</c:v>
                </c:pt>
                <c:pt idx="660">
                  <c:v>11867</c:v>
                </c:pt>
                <c:pt idx="661">
                  <c:v>10124</c:v>
                </c:pt>
                <c:pt idx="662">
                  <c:v>9173</c:v>
                </c:pt>
                <c:pt idx="663">
                  <c:v>10227</c:v>
                </c:pt>
                <c:pt idx="664">
                  <c:v>9107</c:v>
                </c:pt>
                <c:pt idx="665">
                  <c:v>7846</c:v>
                </c:pt>
                <c:pt idx="666">
                  <c:v>7862</c:v>
                </c:pt>
                <c:pt idx="667">
                  <c:v>7475</c:v>
                </c:pt>
                <c:pt idx="668">
                  <c:v>7557</c:v>
                </c:pt>
                <c:pt idx="669">
                  <c:v>8230</c:v>
                </c:pt>
                <c:pt idx="670">
                  <c:v>6611</c:v>
                </c:pt>
                <c:pt idx="671">
                  <c:v>7575</c:v>
                </c:pt>
                <c:pt idx="672">
                  <c:v>8024</c:v>
                </c:pt>
                <c:pt idx="673">
                  <c:v>6665</c:v>
                </c:pt>
                <c:pt idx="674">
                  <c:v>6753</c:v>
                </c:pt>
                <c:pt idx="675">
                  <c:v>7291</c:v>
                </c:pt>
                <c:pt idx="676">
                  <c:v>6676</c:v>
                </c:pt>
                <c:pt idx="677">
                  <c:v>7170</c:v>
                </c:pt>
                <c:pt idx="678">
                  <c:v>6726</c:v>
                </c:pt>
                <c:pt idx="679">
                  <c:v>6170</c:v>
                </c:pt>
                <c:pt idx="680">
                  <c:v>6779</c:v>
                </c:pt>
                <c:pt idx="681">
                  <c:v>6368</c:v>
                </c:pt>
                <c:pt idx="682">
                  <c:v>6405</c:v>
                </c:pt>
                <c:pt idx="683">
                  <c:v>5726</c:v>
                </c:pt>
                <c:pt idx="684">
                  <c:v>6846</c:v>
                </c:pt>
                <c:pt idx="685">
                  <c:v>5985</c:v>
                </c:pt>
                <c:pt idx="686">
                  <c:v>5180</c:v>
                </c:pt>
                <c:pt idx="687">
                  <c:v>5679</c:v>
                </c:pt>
                <c:pt idx="688">
                  <c:v>5960</c:v>
                </c:pt>
                <c:pt idx="689">
                  <c:v>6425</c:v>
                </c:pt>
                <c:pt idx="690">
                  <c:v>6639</c:v>
                </c:pt>
                <c:pt idx="691">
                  <c:v>6008</c:v>
                </c:pt>
                <c:pt idx="692">
                  <c:v>5828</c:v>
                </c:pt>
                <c:pt idx="693">
                  <c:v>6157</c:v>
                </c:pt>
                <c:pt idx="694">
                  <c:v>5629</c:v>
                </c:pt>
                <c:pt idx="695">
                  <c:v>6127</c:v>
                </c:pt>
                <c:pt idx="696">
                  <c:v>6135</c:v>
                </c:pt>
                <c:pt idx="697">
                  <c:v>6138</c:v>
                </c:pt>
                <c:pt idx="698">
                  <c:v>5882</c:v>
                </c:pt>
                <c:pt idx="699">
                  <c:v>5496</c:v>
                </c:pt>
                <c:pt idx="700">
                  <c:v>4843</c:v>
                </c:pt>
                <c:pt idx="701">
                  <c:v>5541</c:v>
                </c:pt>
                <c:pt idx="702">
                  <c:v>5900</c:v>
                </c:pt>
                <c:pt idx="703">
                  <c:v>6169</c:v>
                </c:pt>
                <c:pt idx="704">
                  <c:v>6318</c:v>
                </c:pt>
                <c:pt idx="705">
                  <c:v>6425</c:v>
                </c:pt>
                <c:pt idx="706">
                  <c:v>5343</c:v>
                </c:pt>
                <c:pt idx="707">
                  <c:v>5579</c:v>
                </c:pt>
                <c:pt idx="708">
                  <c:v>6391</c:v>
                </c:pt>
                <c:pt idx="709">
                  <c:v>5724</c:v>
                </c:pt>
                <c:pt idx="710">
                  <c:v>6262</c:v>
                </c:pt>
                <c:pt idx="711">
                  <c:v>4331</c:v>
                </c:pt>
                <c:pt idx="712">
                  <c:v>5550</c:v>
                </c:pt>
                <c:pt idx="713">
                  <c:v>4813</c:v>
                </c:pt>
                <c:pt idx="714">
                  <c:v>5370</c:v>
                </c:pt>
                <c:pt idx="715">
                  <c:v>4983</c:v>
                </c:pt>
                <c:pt idx="716">
                  <c:v>4650</c:v>
                </c:pt>
                <c:pt idx="717">
                  <c:v>4811</c:v>
                </c:pt>
                <c:pt idx="718">
                  <c:v>5261</c:v>
                </c:pt>
                <c:pt idx="719">
                  <c:v>5232</c:v>
                </c:pt>
                <c:pt idx="720">
                  <c:v>5701</c:v>
                </c:pt>
                <c:pt idx="721">
                  <c:v>4813</c:v>
                </c:pt>
                <c:pt idx="722">
                  <c:v>4362</c:v>
                </c:pt>
                <c:pt idx="723">
                  <c:v>4715</c:v>
                </c:pt>
                <c:pt idx="724">
                  <c:v>5667</c:v>
                </c:pt>
                <c:pt idx="725">
                  <c:v>4370</c:v>
                </c:pt>
                <c:pt idx="726">
                  <c:v>5214</c:v>
                </c:pt>
                <c:pt idx="727">
                  <c:v>5547</c:v>
                </c:pt>
                <c:pt idx="728">
                  <c:v>5408</c:v>
                </c:pt>
                <c:pt idx="729">
                  <c:v>5115</c:v>
                </c:pt>
                <c:pt idx="730">
                  <c:v>5301</c:v>
                </c:pt>
                <c:pt idx="731">
                  <c:v>5673</c:v>
                </c:pt>
                <c:pt idx="732">
                  <c:v>5366</c:v>
                </c:pt>
                <c:pt idx="733">
                  <c:v>5409</c:v>
                </c:pt>
                <c:pt idx="734">
                  <c:v>5164</c:v>
                </c:pt>
                <c:pt idx="735">
                  <c:v>5088</c:v>
                </c:pt>
                <c:pt idx="736">
                  <c:v>4610</c:v>
                </c:pt>
                <c:pt idx="737">
                  <c:v>4759</c:v>
                </c:pt>
                <c:pt idx="738">
                  <c:v>5323</c:v>
                </c:pt>
                <c:pt idx="739">
                  <c:v>5385</c:v>
                </c:pt>
                <c:pt idx="740">
                  <c:v>4386</c:v>
                </c:pt>
                <c:pt idx="741">
                  <c:v>4973</c:v>
                </c:pt>
                <c:pt idx="742">
                  <c:v>4515</c:v>
                </c:pt>
                <c:pt idx="743">
                  <c:v>5924</c:v>
                </c:pt>
                <c:pt idx="744">
                  <c:v>5979</c:v>
                </c:pt>
                <c:pt idx="745">
                  <c:v>4586</c:v>
                </c:pt>
                <c:pt idx="746">
                  <c:v>5520</c:v>
                </c:pt>
                <c:pt idx="747">
                  <c:v>5692</c:v>
                </c:pt>
                <c:pt idx="748">
                  <c:v>5075</c:v>
                </c:pt>
                <c:pt idx="749">
                  <c:v>5288</c:v>
                </c:pt>
                <c:pt idx="750">
                  <c:v>4978</c:v>
                </c:pt>
                <c:pt idx="751">
                  <c:v>4837</c:v>
                </c:pt>
                <c:pt idx="752">
                  <c:v>4760</c:v>
                </c:pt>
                <c:pt idx="753">
                  <c:v>5166</c:v>
                </c:pt>
                <c:pt idx="754">
                  <c:v>4434</c:v>
                </c:pt>
                <c:pt idx="755">
                  <c:v>4456</c:v>
                </c:pt>
                <c:pt idx="756">
                  <c:v>4281</c:v>
                </c:pt>
                <c:pt idx="757">
                  <c:v>4923</c:v>
                </c:pt>
                <c:pt idx="758">
                  <c:v>5244</c:v>
                </c:pt>
                <c:pt idx="759">
                  <c:v>4853</c:v>
                </c:pt>
                <c:pt idx="760">
                  <c:v>5158</c:v>
                </c:pt>
                <c:pt idx="761">
                  <c:v>5006</c:v>
                </c:pt>
                <c:pt idx="762">
                  <c:v>4889</c:v>
                </c:pt>
                <c:pt idx="763">
                  <c:v>5246</c:v>
                </c:pt>
                <c:pt idx="764">
                  <c:v>5150</c:v>
                </c:pt>
                <c:pt idx="765">
                  <c:v>5479</c:v>
                </c:pt>
                <c:pt idx="766">
                  <c:v>5341</c:v>
                </c:pt>
                <c:pt idx="767">
                  <c:v>4339</c:v>
                </c:pt>
                <c:pt idx="768">
                  <c:v>4764</c:v>
                </c:pt>
                <c:pt idx="769">
                  <c:v>4856</c:v>
                </c:pt>
                <c:pt idx="770">
                  <c:v>4346</c:v>
                </c:pt>
                <c:pt idx="771">
                  <c:v>5153</c:v>
                </c:pt>
                <c:pt idx="772">
                  <c:v>5518</c:v>
                </c:pt>
                <c:pt idx="773">
                  <c:v>5095</c:v>
                </c:pt>
                <c:pt idx="774">
                  <c:v>5446</c:v>
                </c:pt>
                <c:pt idx="775">
                  <c:v>4685</c:v>
                </c:pt>
                <c:pt idx="776">
                  <c:v>3905</c:v>
                </c:pt>
                <c:pt idx="777">
                  <c:v>5612</c:v>
                </c:pt>
                <c:pt idx="778">
                  <c:v>4342</c:v>
                </c:pt>
                <c:pt idx="779">
                  <c:v>4290</c:v>
                </c:pt>
                <c:pt idx="780">
                  <c:v>4726</c:v>
                </c:pt>
                <c:pt idx="781">
                  <c:v>4068</c:v>
                </c:pt>
                <c:pt idx="782">
                  <c:v>4440</c:v>
                </c:pt>
                <c:pt idx="783">
                  <c:v>5223</c:v>
                </c:pt>
                <c:pt idx="784">
                  <c:v>3861</c:v>
                </c:pt>
                <c:pt idx="785">
                  <c:v>4199</c:v>
                </c:pt>
                <c:pt idx="786">
                  <c:v>4528</c:v>
                </c:pt>
                <c:pt idx="787">
                  <c:v>5840</c:v>
                </c:pt>
                <c:pt idx="788">
                  <c:v>5424</c:v>
                </c:pt>
                <c:pt idx="789">
                  <c:v>6236</c:v>
                </c:pt>
                <c:pt idx="790">
                  <c:v>3917</c:v>
                </c:pt>
                <c:pt idx="791">
                  <c:v>4762</c:v>
                </c:pt>
                <c:pt idx="792">
                  <c:v>5444</c:v>
                </c:pt>
                <c:pt idx="793">
                  <c:v>4429</c:v>
                </c:pt>
                <c:pt idx="794">
                  <c:v>4973</c:v>
                </c:pt>
                <c:pt idx="795">
                  <c:v>4447</c:v>
                </c:pt>
                <c:pt idx="796">
                  <c:v>4116</c:v>
                </c:pt>
                <c:pt idx="797">
                  <c:v>4929</c:v>
                </c:pt>
                <c:pt idx="798">
                  <c:v>4394</c:v>
                </c:pt>
                <c:pt idx="799">
                  <c:v>4313</c:v>
                </c:pt>
                <c:pt idx="800">
                  <c:v>5109</c:v>
                </c:pt>
                <c:pt idx="801">
                  <c:v>4623</c:v>
                </c:pt>
                <c:pt idx="802">
                  <c:v>4870</c:v>
                </c:pt>
                <c:pt idx="803">
                  <c:v>4607</c:v>
                </c:pt>
                <c:pt idx="804">
                  <c:v>4386</c:v>
                </c:pt>
                <c:pt idx="805">
                  <c:v>4401</c:v>
                </c:pt>
                <c:pt idx="806">
                  <c:v>4433</c:v>
                </c:pt>
                <c:pt idx="807">
                  <c:v>3491</c:v>
                </c:pt>
                <c:pt idx="808">
                  <c:v>4418</c:v>
                </c:pt>
                <c:pt idx="809">
                  <c:v>3167</c:v>
                </c:pt>
                <c:pt idx="810">
                  <c:v>6015</c:v>
                </c:pt>
                <c:pt idx="811">
                  <c:v>3809</c:v>
                </c:pt>
                <c:pt idx="812">
                  <c:v>4091</c:v>
                </c:pt>
                <c:pt idx="813">
                  <c:v>4536</c:v>
                </c:pt>
                <c:pt idx="814">
                  <c:v>4809</c:v>
                </c:pt>
                <c:pt idx="815">
                  <c:v>4696</c:v>
                </c:pt>
                <c:pt idx="816">
                  <c:v>4249</c:v>
                </c:pt>
                <c:pt idx="817">
                  <c:v>4720</c:v>
                </c:pt>
                <c:pt idx="818">
                  <c:v>4298</c:v>
                </c:pt>
                <c:pt idx="819">
                  <c:v>4352</c:v>
                </c:pt>
                <c:pt idx="820">
                  <c:v>4215</c:v>
                </c:pt>
                <c:pt idx="821">
                  <c:v>4715</c:v>
                </c:pt>
                <c:pt idx="822">
                  <c:v>4731</c:v>
                </c:pt>
                <c:pt idx="823">
                  <c:v>4950</c:v>
                </c:pt>
                <c:pt idx="824">
                  <c:v>4235</c:v>
                </c:pt>
                <c:pt idx="825">
                  <c:v>4212</c:v>
                </c:pt>
                <c:pt idx="826">
                  <c:v>4565</c:v>
                </c:pt>
                <c:pt idx="827">
                  <c:v>3872</c:v>
                </c:pt>
                <c:pt idx="828">
                  <c:v>3974</c:v>
                </c:pt>
                <c:pt idx="829">
                  <c:v>3941</c:v>
                </c:pt>
                <c:pt idx="830">
                  <c:v>4865</c:v>
                </c:pt>
                <c:pt idx="831">
                  <c:v>4610</c:v>
                </c:pt>
                <c:pt idx="832">
                  <c:v>4755</c:v>
                </c:pt>
                <c:pt idx="833">
                  <c:v>7087</c:v>
                </c:pt>
                <c:pt idx="834">
                  <c:v>19256</c:v>
                </c:pt>
                <c:pt idx="835">
                  <c:v>60671</c:v>
                </c:pt>
                <c:pt idx="836">
                  <c:v>140105</c:v>
                </c:pt>
                <c:pt idx="837">
                  <c:v>252250</c:v>
                </c:pt>
                <c:pt idx="838">
                  <c:v>340160</c:v>
                </c:pt>
                <c:pt idx="839">
                  <c:v>326578</c:v>
                </c:pt>
                <c:pt idx="840">
                  <c:v>231504</c:v>
                </c:pt>
                <c:pt idx="841">
                  <c:v>123801</c:v>
                </c:pt>
                <c:pt idx="842">
                  <c:v>48702</c:v>
                </c:pt>
                <c:pt idx="843">
                  <c:v>16109</c:v>
                </c:pt>
                <c:pt idx="844">
                  <c:v>7504</c:v>
                </c:pt>
                <c:pt idx="845">
                  <c:v>4992</c:v>
                </c:pt>
                <c:pt idx="846">
                  <c:v>4941</c:v>
                </c:pt>
                <c:pt idx="847">
                  <c:v>4189</c:v>
                </c:pt>
                <c:pt idx="848">
                  <c:v>4008</c:v>
                </c:pt>
                <c:pt idx="849">
                  <c:v>4331</c:v>
                </c:pt>
                <c:pt idx="850">
                  <c:v>3951</c:v>
                </c:pt>
                <c:pt idx="851">
                  <c:v>3635</c:v>
                </c:pt>
                <c:pt idx="852">
                  <c:v>5070</c:v>
                </c:pt>
                <c:pt idx="853">
                  <c:v>4392</c:v>
                </c:pt>
                <c:pt idx="854">
                  <c:v>4168</c:v>
                </c:pt>
                <c:pt idx="855">
                  <c:v>4488</c:v>
                </c:pt>
                <c:pt idx="856">
                  <c:v>3614</c:v>
                </c:pt>
                <c:pt idx="857">
                  <c:v>4386</c:v>
                </c:pt>
                <c:pt idx="858">
                  <c:v>4380</c:v>
                </c:pt>
                <c:pt idx="859">
                  <c:v>5585</c:v>
                </c:pt>
                <c:pt idx="860">
                  <c:v>4939</c:v>
                </c:pt>
                <c:pt idx="861">
                  <c:v>4833</c:v>
                </c:pt>
                <c:pt idx="862">
                  <c:v>5202</c:v>
                </c:pt>
                <c:pt idx="863">
                  <c:v>4576</c:v>
                </c:pt>
                <c:pt idx="864">
                  <c:v>4214</c:v>
                </c:pt>
                <c:pt idx="865">
                  <c:v>4096</c:v>
                </c:pt>
                <c:pt idx="866">
                  <c:v>4279</c:v>
                </c:pt>
                <c:pt idx="867">
                  <c:v>4022</c:v>
                </c:pt>
                <c:pt idx="868">
                  <c:v>3878</c:v>
                </c:pt>
                <c:pt idx="869">
                  <c:v>3538</c:v>
                </c:pt>
                <c:pt idx="870">
                  <c:v>4526</c:v>
                </c:pt>
                <c:pt idx="871">
                  <c:v>4085</c:v>
                </c:pt>
                <c:pt idx="872">
                  <c:v>3825</c:v>
                </c:pt>
                <c:pt idx="873">
                  <c:v>4169</c:v>
                </c:pt>
                <c:pt idx="874">
                  <c:v>3059</c:v>
                </c:pt>
                <c:pt idx="875">
                  <c:v>3600</c:v>
                </c:pt>
                <c:pt idx="876">
                  <c:v>3851</c:v>
                </c:pt>
                <c:pt idx="877">
                  <c:v>3375</c:v>
                </c:pt>
                <c:pt idx="878">
                  <c:v>3670</c:v>
                </c:pt>
                <c:pt idx="879">
                  <c:v>3416</c:v>
                </c:pt>
                <c:pt idx="880">
                  <c:v>3328</c:v>
                </c:pt>
                <c:pt idx="881">
                  <c:v>4279</c:v>
                </c:pt>
                <c:pt idx="882">
                  <c:v>3228</c:v>
                </c:pt>
                <c:pt idx="883">
                  <c:v>3312</c:v>
                </c:pt>
                <c:pt idx="884">
                  <c:v>3715</c:v>
                </c:pt>
                <c:pt idx="885">
                  <c:v>3895</c:v>
                </c:pt>
                <c:pt idx="886">
                  <c:v>3150</c:v>
                </c:pt>
                <c:pt idx="887">
                  <c:v>3574</c:v>
                </c:pt>
                <c:pt idx="888">
                  <c:v>3705</c:v>
                </c:pt>
                <c:pt idx="889">
                  <c:v>3898</c:v>
                </c:pt>
                <c:pt idx="890">
                  <c:v>2919</c:v>
                </c:pt>
                <c:pt idx="891">
                  <c:v>4012</c:v>
                </c:pt>
                <c:pt idx="892">
                  <c:v>3339</c:v>
                </c:pt>
                <c:pt idx="893">
                  <c:v>3976</c:v>
                </c:pt>
                <c:pt idx="894">
                  <c:v>3385</c:v>
                </c:pt>
                <c:pt idx="895">
                  <c:v>3479</c:v>
                </c:pt>
                <c:pt idx="896">
                  <c:v>3699</c:v>
                </c:pt>
                <c:pt idx="897">
                  <c:v>3261</c:v>
                </c:pt>
                <c:pt idx="898">
                  <c:v>3305</c:v>
                </c:pt>
                <c:pt idx="899">
                  <c:v>3478</c:v>
                </c:pt>
                <c:pt idx="900">
                  <c:v>3619</c:v>
                </c:pt>
                <c:pt idx="901">
                  <c:v>3940</c:v>
                </c:pt>
                <c:pt idx="902">
                  <c:v>3538</c:v>
                </c:pt>
                <c:pt idx="903">
                  <c:v>3362</c:v>
                </c:pt>
                <c:pt idx="904">
                  <c:v>3521</c:v>
                </c:pt>
                <c:pt idx="905">
                  <c:v>3227</c:v>
                </c:pt>
                <c:pt idx="906">
                  <c:v>3068</c:v>
                </c:pt>
                <c:pt idx="907">
                  <c:v>2801</c:v>
                </c:pt>
                <c:pt idx="908">
                  <c:v>3442</c:v>
                </c:pt>
                <c:pt idx="909">
                  <c:v>3850</c:v>
                </c:pt>
                <c:pt idx="910">
                  <c:v>3870</c:v>
                </c:pt>
                <c:pt idx="911">
                  <c:v>4413</c:v>
                </c:pt>
                <c:pt idx="912">
                  <c:v>5388</c:v>
                </c:pt>
                <c:pt idx="913">
                  <c:v>6094</c:v>
                </c:pt>
                <c:pt idx="914">
                  <c:v>7243</c:v>
                </c:pt>
                <c:pt idx="915">
                  <c:v>5336</c:v>
                </c:pt>
                <c:pt idx="916">
                  <c:v>5576</c:v>
                </c:pt>
                <c:pt idx="917">
                  <c:v>4270</c:v>
                </c:pt>
                <c:pt idx="918">
                  <c:v>4195</c:v>
                </c:pt>
                <c:pt idx="919">
                  <c:v>3309</c:v>
                </c:pt>
                <c:pt idx="920">
                  <c:v>3262</c:v>
                </c:pt>
                <c:pt idx="921">
                  <c:v>3340</c:v>
                </c:pt>
                <c:pt idx="922">
                  <c:v>3606</c:v>
                </c:pt>
                <c:pt idx="923">
                  <c:v>3498</c:v>
                </c:pt>
                <c:pt idx="924">
                  <c:v>3870</c:v>
                </c:pt>
                <c:pt idx="925">
                  <c:v>4131</c:v>
                </c:pt>
                <c:pt idx="926">
                  <c:v>3361</c:v>
                </c:pt>
                <c:pt idx="927">
                  <c:v>3570</c:v>
                </c:pt>
                <c:pt idx="928">
                  <c:v>4599</c:v>
                </c:pt>
                <c:pt idx="929">
                  <c:v>3371</c:v>
                </c:pt>
                <c:pt idx="930">
                  <c:v>3957</c:v>
                </c:pt>
                <c:pt idx="931">
                  <c:v>3564</c:v>
                </c:pt>
                <c:pt idx="932">
                  <c:v>4819</c:v>
                </c:pt>
                <c:pt idx="933">
                  <c:v>3679</c:v>
                </c:pt>
                <c:pt idx="934">
                  <c:v>3674</c:v>
                </c:pt>
                <c:pt idx="935">
                  <c:v>4007</c:v>
                </c:pt>
                <c:pt idx="936">
                  <c:v>3561</c:v>
                </c:pt>
                <c:pt idx="937">
                  <c:v>3948</c:v>
                </c:pt>
                <c:pt idx="938">
                  <c:v>2782</c:v>
                </c:pt>
                <c:pt idx="939">
                  <c:v>3225</c:v>
                </c:pt>
                <c:pt idx="940">
                  <c:v>2988</c:v>
                </c:pt>
                <c:pt idx="941">
                  <c:v>3650</c:v>
                </c:pt>
                <c:pt idx="942">
                  <c:v>3316</c:v>
                </c:pt>
                <c:pt idx="943">
                  <c:v>4005</c:v>
                </c:pt>
                <c:pt idx="944">
                  <c:v>3224</c:v>
                </c:pt>
                <c:pt idx="945">
                  <c:v>3006</c:v>
                </c:pt>
                <c:pt idx="946">
                  <c:v>3110</c:v>
                </c:pt>
                <c:pt idx="947">
                  <c:v>4215</c:v>
                </c:pt>
                <c:pt idx="948">
                  <c:v>3544</c:v>
                </c:pt>
                <c:pt idx="949">
                  <c:v>3379</c:v>
                </c:pt>
                <c:pt idx="950">
                  <c:v>3324</c:v>
                </c:pt>
                <c:pt idx="951">
                  <c:v>3178</c:v>
                </c:pt>
                <c:pt idx="952">
                  <c:v>2708</c:v>
                </c:pt>
                <c:pt idx="953">
                  <c:v>2864</c:v>
                </c:pt>
                <c:pt idx="954">
                  <c:v>4019</c:v>
                </c:pt>
                <c:pt idx="955">
                  <c:v>3108</c:v>
                </c:pt>
                <c:pt idx="956">
                  <c:v>2770</c:v>
                </c:pt>
                <c:pt idx="957">
                  <c:v>4456</c:v>
                </c:pt>
                <c:pt idx="958">
                  <c:v>5257</c:v>
                </c:pt>
                <c:pt idx="959">
                  <c:v>5897</c:v>
                </c:pt>
                <c:pt idx="960">
                  <c:v>7825</c:v>
                </c:pt>
                <c:pt idx="961">
                  <c:v>5897</c:v>
                </c:pt>
                <c:pt idx="962">
                  <c:v>5626</c:v>
                </c:pt>
                <c:pt idx="963">
                  <c:v>5725</c:v>
                </c:pt>
                <c:pt idx="964">
                  <c:v>4565</c:v>
                </c:pt>
                <c:pt idx="965">
                  <c:v>3983</c:v>
                </c:pt>
                <c:pt idx="966">
                  <c:v>4070</c:v>
                </c:pt>
                <c:pt idx="967">
                  <c:v>2901</c:v>
                </c:pt>
                <c:pt idx="968">
                  <c:v>3205</c:v>
                </c:pt>
                <c:pt idx="969">
                  <c:v>3030</c:v>
                </c:pt>
                <c:pt idx="970">
                  <c:v>3299</c:v>
                </c:pt>
                <c:pt idx="971">
                  <c:v>3782</c:v>
                </c:pt>
                <c:pt idx="972">
                  <c:v>3365</c:v>
                </c:pt>
                <c:pt idx="973">
                  <c:v>2880</c:v>
                </c:pt>
                <c:pt idx="974">
                  <c:v>3084</c:v>
                </c:pt>
                <c:pt idx="975">
                  <c:v>2672</c:v>
                </c:pt>
                <c:pt idx="976">
                  <c:v>3358</c:v>
                </c:pt>
                <c:pt idx="977">
                  <c:v>3333</c:v>
                </c:pt>
                <c:pt idx="978">
                  <c:v>2545</c:v>
                </c:pt>
                <c:pt idx="979">
                  <c:v>3560</c:v>
                </c:pt>
                <c:pt idx="980">
                  <c:v>3258</c:v>
                </c:pt>
                <c:pt idx="981">
                  <c:v>3247</c:v>
                </c:pt>
                <c:pt idx="982">
                  <c:v>3531</c:v>
                </c:pt>
                <c:pt idx="983">
                  <c:v>2551</c:v>
                </c:pt>
                <c:pt idx="984">
                  <c:v>3146</c:v>
                </c:pt>
                <c:pt idx="985">
                  <c:v>3242</c:v>
                </c:pt>
                <c:pt idx="986">
                  <c:v>2860</c:v>
                </c:pt>
                <c:pt idx="987">
                  <c:v>2973</c:v>
                </c:pt>
                <c:pt idx="988">
                  <c:v>3051</c:v>
                </c:pt>
                <c:pt idx="989">
                  <c:v>3030</c:v>
                </c:pt>
                <c:pt idx="990">
                  <c:v>2933</c:v>
                </c:pt>
                <c:pt idx="991">
                  <c:v>2859</c:v>
                </c:pt>
                <c:pt idx="992">
                  <c:v>2837</c:v>
                </c:pt>
                <c:pt idx="993">
                  <c:v>2903</c:v>
                </c:pt>
                <c:pt idx="994">
                  <c:v>3290</c:v>
                </c:pt>
                <c:pt idx="995">
                  <c:v>3342</c:v>
                </c:pt>
                <c:pt idx="996">
                  <c:v>3441</c:v>
                </c:pt>
                <c:pt idx="997">
                  <c:v>3516</c:v>
                </c:pt>
                <c:pt idx="998">
                  <c:v>2905</c:v>
                </c:pt>
                <c:pt idx="999">
                  <c:v>3024</c:v>
                </c:pt>
                <c:pt idx="1000">
                  <c:v>2761</c:v>
                </c:pt>
                <c:pt idx="1001">
                  <c:v>2917</c:v>
                </c:pt>
                <c:pt idx="1002">
                  <c:v>2961</c:v>
                </c:pt>
                <c:pt idx="1003">
                  <c:v>3012</c:v>
                </c:pt>
                <c:pt idx="1004">
                  <c:v>3106</c:v>
                </c:pt>
                <c:pt idx="1005">
                  <c:v>3335</c:v>
                </c:pt>
                <c:pt idx="1006">
                  <c:v>3139</c:v>
                </c:pt>
                <c:pt idx="1007">
                  <c:v>3391</c:v>
                </c:pt>
                <c:pt idx="1008">
                  <c:v>3279</c:v>
                </c:pt>
                <c:pt idx="1009">
                  <c:v>3257</c:v>
                </c:pt>
                <c:pt idx="1010">
                  <c:v>3632</c:v>
                </c:pt>
                <c:pt idx="1011">
                  <c:v>4151</c:v>
                </c:pt>
                <c:pt idx="1012">
                  <c:v>5227</c:v>
                </c:pt>
                <c:pt idx="1013">
                  <c:v>4432</c:v>
                </c:pt>
                <c:pt idx="1014">
                  <c:v>5115</c:v>
                </c:pt>
                <c:pt idx="1015">
                  <c:v>4405</c:v>
                </c:pt>
                <c:pt idx="1016">
                  <c:v>3701</c:v>
                </c:pt>
                <c:pt idx="1017">
                  <c:v>3964</c:v>
                </c:pt>
                <c:pt idx="1018">
                  <c:v>3270</c:v>
                </c:pt>
                <c:pt idx="1019">
                  <c:v>3458</c:v>
                </c:pt>
                <c:pt idx="1020">
                  <c:v>3085</c:v>
                </c:pt>
                <c:pt idx="1021">
                  <c:v>2246</c:v>
                </c:pt>
                <c:pt idx="1022">
                  <c:v>2243</c:v>
                </c:pt>
                <c:pt idx="1023">
                  <c:v>2899</c:v>
                </c:pt>
                <c:pt idx="1024">
                  <c:v>2961</c:v>
                </c:pt>
                <c:pt idx="1025">
                  <c:v>3016</c:v>
                </c:pt>
                <c:pt idx="1026">
                  <c:v>2698</c:v>
                </c:pt>
                <c:pt idx="1027">
                  <c:v>2743</c:v>
                </c:pt>
                <c:pt idx="1028">
                  <c:v>2866</c:v>
                </c:pt>
                <c:pt idx="1029">
                  <c:v>2577</c:v>
                </c:pt>
                <c:pt idx="1030">
                  <c:v>2924</c:v>
                </c:pt>
                <c:pt idx="1031">
                  <c:v>2699</c:v>
                </c:pt>
                <c:pt idx="1032">
                  <c:v>2620</c:v>
                </c:pt>
                <c:pt idx="1033">
                  <c:v>2802</c:v>
                </c:pt>
                <c:pt idx="1034">
                  <c:v>2782</c:v>
                </c:pt>
                <c:pt idx="1035">
                  <c:v>3248</c:v>
                </c:pt>
                <c:pt idx="1036">
                  <c:v>2772</c:v>
                </c:pt>
                <c:pt idx="1037">
                  <c:v>3383</c:v>
                </c:pt>
                <c:pt idx="1038">
                  <c:v>3464</c:v>
                </c:pt>
                <c:pt idx="1039">
                  <c:v>2740</c:v>
                </c:pt>
                <c:pt idx="1040">
                  <c:v>3115</c:v>
                </c:pt>
                <c:pt idx="1041">
                  <c:v>3154</c:v>
                </c:pt>
                <c:pt idx="1042">
                  <c:v>2997</c:v>
                </c:pt>
                <c:pt idx="1043">
                  <c:v>3298</c:v>
                </c:pt>
                <c:pt idx="1044">
                  <c:v>2805</c:v>
                </c:pt>
                <c:pt idx="1045">
                  <c:v>2954</c:v>
                </c:pt>
                <c:pt idx="1046">
                  <c:v>3123</c:v>
                </c:pt>
                <c:pt idx="1047">
                  <c:v>2965</c:v>
                </c:pt>
                <c:pt idx="1048">
                  <c:v>3484</c:v>
                </c:pt>
                <c:pt idx="1049">
                  <c:v>2264</c:v>
                </c:pt>
                <c:pt idx="1050">
                  <c:v>2643</c:v>
                </c:pt>
                <c:pt idx="1051">
                  <c:v>1980</c:v>
                </c:pt>
                <c:pt idx="1052">
                  <c:v>2703</c:v>
                </c:pt>
                <c:pt idx="1053">
                  <c:v>2671</c:v>
                </c:pt>
                <c:pt idx="1054">
                  <c:v>2624</c:v>
                </c:pt>
                <c:pt idx="1055">
                  <c:v>2675</c:v>
                </c:pt>
                <c:pt idx="1056">
                  <c:v>2577</c:v>
                </c:pt>
                <c:pt idx="1057">
                  <c:v>3347</c:v>
                </c:pt>
                <c:pt idx="1058">
                  <c:v>3339</c:v>
                </c:pt>
                <c:pt idx="1059">
                  <c:v>3055</c:v>
                </c:pt>
                <c:pt idx="1060">
                  <c:v>3188</c:v>
                </c:pt>
                <c:pt idx="1061">
                  <c:v>3746</c:v>
                </c:pt>
                <c:pt idx="1062">
                  <c:v>3614</c:v>
                </c:pt>
                <c:pt idx="1063">
                  <c:v>2471</c:v>
                </c:pt>
                <c:pt idx="1064">
                  <c:v>3012</c:v>
                </c:pt>
                <c:pt idx="1065">
                  <c:v>3752</c:v>
                </c:pt>
                <c:pt idx="1066">
                  <c:v>2853</c:v>
                </c:pt>
                <c:pt idx="1067">
                  <c:v>2483</c:v>
                </c:pt>
                <c:pt idx="1068">
                  <c:v>2231</c:v>
                </c:pt>
                <c:pt idx="1069">
                  <c:v>2415</c:v>
                </c:pt>
                <c:pt idx="1070">
                  <c:v>3041</c:v>
                </c:pt>
                <c:pt idx="1071">
                  <c:v>3092</c:v>
                </c:pt>
                <c:pt idx="1072">
                  <c:v>3075</c:v>
                </c:pt>
                <c:pt idx="1073">
                  <c:v>3145</c:v>
                </c:pt>
                <c:pt idx="1074">
                  <c:v>2916</c:v>
                </c:pt>
                <c:pt idx="1075">
                  <c:v>2922</c:v>
                </c:pt>
                <c:pt idx="1076">
                  <c:v>3094</c:v>
                </c:pt>
                <c:pt idx="1077">
                  <c:v>2999</c:v>
                </c:pt>
                <c:pt idx="1078">
                  <c:v>3179</c:v>
                </c:pt>
                <c:pt idx="1079">
                  <c:v>3194</c:v>
                </c:pt>
                <c:pt idx="1080">
                  <c:v>2865</c:v>
                </c:pt>
                <c:pt idx="1081">
                  <c:v>2236</c:v>
                </c:pt>
                <c:pt idx="1082">
                  <c:v>3124</c:v>
                </c:pt>
                <c:pt idx="1083">
                  <c:v>3397</c:v>
                </c:pt>
                <c:pt idx="1084">
                  <c:v>3130</c:v>
                </c:pt>
                <c:pt idx="1085">
                  <c:v>2714</c:v>
                </c:pt>
                <c:pt idx="1086">
                  <c:v>2435</c:v>
                </c:pt>
                <c:pt idx="1087">
                  <c:v>3386</c:v>
                </c:pt>
                <c:pt idx="1088">
                  <c:v>3041</c:v>
                </c:pt>
                <c:pt idx="1089">
                  <c:v>2751</c:v>
                </c:pt>
                <c:pt idx="1090">
                  <c:v>2873</c:v>
                </c:pt>
                <c:pt idx="1091">
                  <c:v>3206</c:v>
                </c:pt>
                <c:pt idx="1092">
                  <c:v>3106</c:v>
                </c:pt>
                <c:pt idx="1093">
                  <c:v>2922</c:v>
                </c:pt>
                <c:pt idx="1094">
                  <c:v>2996</c:v>
                </c:pt>
                <c:pt idx="1095">
                  <c:v>2562</c:v>
                </c:pt>
                <c:pt idx="1096">
                  <c:v>2682</c:v>
                </c:pt>
                <c:pt idx="1097">
                  <c:v>3370</c:v>
                </c:pt>
                <c:pt idx="1098">
                  <c:v>3236</c:v>
                </c:pt>
                <c:pt idx="1099">
                  <c:v>2703</c:v>
                </c:pt>
                <c:pt idx="1100">
                  <c:v>2136</c:v>
                </c:pt>
                <c:pt idx="1101">
                  <c:v>2260</c:v>
                </c:pt>
                <c:pt idx="1102">
                  <c:v>2724</c:v>
                </c:pt>
                <c:pt idx="1103">
                  <c:v>3066</c:v>
                </c:pt>
                <c:pt idx="1104">
                  <c:v>3064</c:v>
                </c:pt>
                <c:pt idx="1105">
                  <c:v>3168</c:v>
                </c:pt>
                <c:pt idx="1106">
                  <c:v>3184</c:v>
                </c:pt>
                <c:pt idx="1107">
                  <c:v>2970</c:v>
                </c:pt>
                <c:pt idx="1108">
                  <c:v>2668</c:v>
                </c:pt>
                <c:pt idx="1109">
                  <c:v>2786</c:v>
                </c:pt>
                <c:pt idx="1110">
                  <c:v>2787</c:v>
                </c:pt>
                <c:pt idx="1111">
                  <c:v>2176</c:v>
                </c:pt>
                <c:pt idx="1112">
                  <c:v>3303</c:v>
                </c:pt>
                <c:pt idx="1113">
                  <c:v>2967</c:v>
                </c:pt>
                <c:pt idx="1114">
                  <c:v>2621</c:v>
                </c:pt>
                <c:pt idx="1115">
                  <c:v>3338</c:v>
                </c:pt>
                <c:pt idx="1116">
                  <c:v>3193</c:v>
                </c:pt>
                <c:pt idx="1117">
                  <c:v>2920</c:v>
                </c:pt>
                <c:pt idx="1118">
                  <c:v>2837</c:v>
                </c:pt>
                <c:pt idx="1119">
                  <c:v>3096</c:v>
                </c:pt>
                <c:pt idx="1120">
                  <c:v>3100</c:v>
                </c:pt>
                <c:pt idx="1121">
                  <c:v>3043</c:v>
                </c:pt>
                <c:pt idx="1122">
                  <c:v>3410</c:v>
                </c:pt>
                <c:pt idx="1123">
                  <c:v>3432</c:v>
                </c:pt>
                <c:pt idx="1124">
                  <c:v>3241</c:v>
                </c:pt>
                <c:pt idx="1125">
                  <c:v>3459</c:v>
                </c:pt>
                <c:pt idx="1126">
                  <c:v>3151</c:v>
                </c:pt>
                <c:pt idx="1127">
                  <c:v>3419</c:v>
                </c:pt>
                <c:pt idx="1128">
                  <c:v>3401</c:v>
                </c:pt>
                <c:pt idx="1129">
                  <c:v>3376</c:v>
                </c:pt>
                <c:pt idx="1130">
                  <c:v>2492</c:v>
                </c:pt>
                <c:pt idx="1131">
                  <c:v>3023</c:v>
                </c:pt>
                <c:pt idx="1132">
                  <c:v>3646</c:v>
                </c:pt>
                <c:pt idx="1133">
                  <c:v>3736</c:v>
                </c:pt>
                <c:pt idx="1134">
                  <c:v>4113</c:v>
                </c:pt>
                <c:pt idx="1135">
                  <c:v>4695</c:v>
                </c:pt>
                <c:pt idx="1136">
                  <c:v>3565</c:v>
                </c:pt>
                <c:pt idx="1137">
                  <c:v>4323</c:v>
                </c:pt>
                <c:pt idx="1138">
                  <c:v>2768</c:v>
                </c:pt>
                <c:pt idx="1139">
                  <c:v>3562</c:v>
                </c:pt>
                <c:pt idx="1140">
                  <c:v>2989</c:v>
                </c:pt>
                <c:pt idx="1141">
                  <c:v>3847</c:v>
                </c:pt>
                <c:pt idx="1142">
                  <c:v>2474</c:v>
                </c:pt>
                <c:pt idx="1143">
                  <c:v>3211</c:v>
                </c:pt>
                <c:pt idx="1144">
                  <c:v>3290</c:v>
                </c:pt>
                <c:pt idx="1145">
                  <c:v>2869</c:v>
                </c:pt>
                <c:pt idx="1146">
                  <c:v>3691</c:v>
                </c:pt>
                <c:pt idx="1147">
                  <c:v>2943</c:v>
                </c:pt>
                <c:pt idx="1148">
                  <c:v>3222</c:v>
                </c:pt>
                <c:pt idx="1149">
                  <c:v>2558</c:v>
                </c:pt>
                <c:pt idx="1150">
                  <c:v>3250</c:v>
                </c:pt>
                <c:pt idx="1151">
                  <c:v>3725</c:v>
                </c:pt>
                <c:pt idx="1152">
                  <c:v>2718</c:v>
                </c:pt>
                <c:pt idx="1153">
                  <c:v>2617</c:v>
                </c:pt>
                <c:pt idx="1154">
                  <c:v>3053</c:v>
                </c:pt>
                <c:pt idx="1155">
                  <c:v>2844</c:v>
                </c:pt>
                <c:pt idx="1156">
                  <c:v>2842</c:v>
                </c:pt>
                <c:pt idx="1157">
                  <c:v>2423</c:v>
                </c:pt>
                <c:pt idx="1158">
                  <c:v>3024</c:v>
                </c:pt>
                <c:pt idx="1159">
                  <c:v>3536</c:v>
                </c:pt>
                <c:pt idx="1160">
                  <c:v>3003</c:v>
                </c:pt>
                <c:pt idx="1161">
                  <c:v>2765</c:v>
                </c:pt>
                <c:pt idx="1162">
                  <c:v>2785</c:v>
                </c:pt>
                <c:pt idx="1163">
                  <c:v>2172</c:v>
                </c:pt>
                <c:pt idx="1164">
                  <c:v>2574</c:v>
                </c:pt>
                <c:pt idx="1165">
                  <c:v>2973</c:v>
                </c:pt>
                <c:pt idx="1166">
                  <c:v>3202</c:v>
                </c:pt>
                <c:pt idx="1167">
                  <c:v>2861</c:v>
                </c:pt>
                <c:pt idx="1168">
                  <c:v>3307</c:v>
                </c:pt>
                <c:pt idx="1169">
                  <c:v>2881</c:v>
                </c:pt>
                <c:pt idx="1170">
                  <c:v>2988</c:v>
                </c:pt>
                <c:pt idx="1171">
                  <c:v>2617</c:v>
                </c:pt>
                <c:pt idx="1172">
                  <c:v>2703</c:v>
                </c:pt>
                <c:pt idx="1173">
                  <c:v>2950</c:v>
                </c:pt>
                <c:pt idx="1174">
                  <c:v>3313</c:v>
                </c:pt>
                <c:pt idx="1175">
                  <c:v>2611</c:v>
                </c:pt>
                <c:pt idx="1176">
                  <c:v>2872</c:v>
                </c:pt>
                <c:pt idx="1177">
                  <c:v>2632</c:v>
                </c:pt>
                <c:pt idx="1178">
                  <c:v>2168</c:v>
                </c:pt>
                <c:pt idx="1179">
                  <c:v>3009</c:v>
                </c:pt>
                <c:pt idx="1180">
                  <c:v>2517</c:v>
                </c:pt>
                <c:pt idx="1181">
                  <c:v>2313</c:v>
                </c:pt>
                <c:pt idx="1182">
                  <c:v>2919</c:v>
                </c:pt>
                <c:pt idx="1183">
                  <c:v>2697</c:v>
                </c:pt>
                <c:pt idx="1184">
                  <c:v>1799</c:v>
                </c:pt>
                <c:pt idx="1185">
                  <c:v>2266</c:v>
                </c:pt>
                <c:pt idx="1186">
                  <c:v>2714</c:v>
                </c:pt>
                <c:pt idx="1187">
                  <c:v>2748</c:v>
                </c:pt>
                <c:pt idx="1188">
                  <c:v>2636</c:v>
                </c:pt>
                <c:pt idx="1189">
                  <c:v>3168</c:v>
                </c:pt>
                <c:pt idx="1190">
                  <c:v>2553</c:v>
                </c:pt>
                <c:pt idx="1191">
                  <c:v>3138</c:v>
                </c:pt>
                <c:pt idx="1192">
                  <c:v>2987</c:v>
                </c:pt>
                <c:pt idx="1193">
                  <c:v>2785</c:v>
                </c:pt>
                <c:pt idx="1194">
                  <c:v>2431</c:v>
                </c:pt>
                <c:pt idx="1195">
                  <c:v>3799</c:v>
                </c:pt>
                <c:pt idx="1196">
                  <c:v>3260</c:v>
                </c:pt>
                <c:pt idx="1197">
                  <c:v>2632</c:v>
                </c:pt>
                <c:pt idx="1198">
                  <c:v>3023</c:v>
                </c:pt>
                <c:pt idx="1199">
                  <c:v>2422</c:v>
                </c:pt>
                <c:pt idx="1200">
                  <c:v>3000</c:v>
                </c:pt>
                <c:pt idx="1201">
                  <c:v>2204</c:v>
                </c:pt>
                <c:pt idx="1202">
                  <c:v>3353</c:v>
                </c:pt>
                <c:pt idx="1203">
                  <c:v>2473</c:v>
                </c:pt>
                <c:pt idx="1204">
                  <c:v>2691</c:v>
                </c:pt>
                <c:pt idx="1205">
                  <c:v>2822</c:v>
                </c:pt>
                <c:pt idx="1206">
                  <c:v>2498</c:v>
                </c:pt>
                <c:pt idx="1207">
                  <c:v>2320</c:v>
                </c:pt>
                <c:pt idx="1208">
                  <c:v>2650</c:v>
                </c:pt>
                <c:pt idx="1209">
                  <c:v>3032</c:v>
                </c:pt>
                <c:pt idx="1210">
                  <c:v>2806</c:v>
                </c:pt>
                <c:pt idx="1211">
                  <c:v>2446</c:v>
                </c:pt>
                <c:pt idx="1212">
                  <c:v>2533</c:v>
                </c:pt>
                <c:pt idx="1213">
                  <c:v>2782</c:v>
                </c:pt>
                <c:pt idx="1214">
                  <c:v>2187</c:v>
                </c:pt>
                <c:pt idx="1215">
                  <c:v>3362</c:v>
                </c:pt>
                <c:pt idx="1216">
                  <c:v>2751</c:v>
                </c:pt>
                <c:pt idx="1217">
                  <c:v>2574</c:v>
                </c:pt>
                <c:pt idx="1218">
                  <c:v>2699</c:v>
                </c:pt>
                <c:pt idx="1219">
                  <c:v>2149</c:v>
                </c:pt>
                <c:pt idx="1220">
                  <c:v>2188</c:v>
                </c:pt>
                <c:pt idx="1221">
                  <c:v>2498</c:v>
                </c:pt>
                <c:pt idx="1222">
                  <c:v>2390</c:v>
                </c:pt>
                <c:pt idx="1223">
                  <c:v>2417</c:v>
                </c:pt>
                <c:pt idx="1224">
                  <c:v>2588</c:v>
                </c:pt>
                <c:pt idx="1225">
                  <c:v>3176</c:v>
                </c:pt>
                <c:pt idx="1226">
                  <c:v>2816</c:v>
                </c:pt>
                <c:pt idx="1227">
                  <c:v>2874</c:v>
                </c:pt>
                <c:pt idx="1228">
                  <c:v>2507</c:v>
                </c:pt>
                <c:pt idx="1229">
                  <c:v>2534</c:v>
                </c:pt>
                <c:pt idx="1230">
                  <c:v>3432</c:v>
                </c:pt>
                <c:pt idx="1231">
                  <c:v>2237</c:v>
                </c:pt>
                <c:pt idx="1232">
                  <c:v>2259</c:v>
                </c:pt>
                <c:pt idx="1233">
                  <c:v>3012</c:v>
                </c:pt>
                <c:pt idx="1234">
                  <c:v>2866</c:v>
                </c:pt>
                <c:pt idx="1235">
                  <c:v>2597</c:v>
                </c:pt>
                <c:pt idx="1236">
                  <c:v>3291</c:v>
                </c:pt>
                <c:pt idx="1237">
                  <c:v>2711</c:v>
                </c:pt>
                <c:pt idx="1238">
                  <c:v>2732</c:v>
                </c:pt>
                <c:pt idx="1239">
                  <c:v>2961</c:v>
                </c:pt>
                <c:pt idx="1240">
                  <c:v>2433</c:v>
                </c:pt>
                <c:pt idx="1241">
                  <c:v>2518</c:v>
                </c:pt>
                <c:pt idx="1242">
                  <c:v>2966</c:v>
                </c:pt>
                <c:pt idx="1243">
                  <c:v>2390</c:v>
                </c:pt>
                <c:pt idx="1244">
                  <c:v>2293</c:v>
                </c:pt>
                <c:pt idx="1245">
                  <c:v>2795</c:v>
                </c:pt>
                <c:pt idx="1246">
                  <c:v>2777</c:v>
                </c:pt>
                <c:pt idx="1247">
                  <c:v>2121</c:v>
                </c:pt>
                <c:pt idx="1248">
                  <c:v>2804</c:v>
                </c:pt>
                <c:pt idx="1249">
                  <c:v>2450</c:v>
                </c:pt>
                <c:pt idx="1250">
                  <c:v>2967</c:v>
                </c:pt>
                <c:pt idx="1251">
                  <c:v>3385</c:v>
                </c:pt>
                <c:pt idx="1252">
                  <c:v>3045</c:v>
                </c:pt>
                <c:pt idx="1253">
                  <c:v>3452</c:v>
                </c:pt>
                <c:pt idx="1254">
                  <c:v>2784</c:v>
                </c:pt>
                <c:pt idx="1255">
                  <c:v>3464</c:v>
                </c:pt>
                <c:pt idx="1256">
                  <c:v>2913</c:v>
                </c:pt>
                <c:pt idx="1257">
                  <c:v>2443</c:v>
                </c:pt>
                <c:pt idx="1258">
                  <c:v>3326</c:v>
                </c:pt>
                <c:pt idx="1259">
                  <c:v>3266</c:v>
                </c:pt>
                <c:pt idx="1260">
                  <c:v>3122</c:v>
                </c:pt>
                <c:pt idx="1261">
                  <c:v>2655</c:v>
                </c:pt>
                <c:pt idx="1262">
                  <c:v>3343</c:v>
                </c:pt>
                <c:pt idx="1263">
                  <c:v>2142</c:v>
                </c:pt>
                <c:pt idx="1264">
                  <c:v>2301</c:v>
                </c:pt>
                <c:pt idx="1265">
                  <c:v>2000</c:v>
                </c:pt>
                <c:pt idx="1266">
                  <c:v>2494</c:v>
                </c:pt>
                <c:pt idx="1267">
                  <c:v>2779</c:v>
                </c:pt>
                <c:pt idx="1268">
                  <c:v>2136</c:v>
                </c:pt>
                <c:pt idx="1269">
                  <c:v>2694</c:v>
                </c:pt>
                <c:pt idx="1270">
                  <c:v>2584</c:v>
                </c:pt>
                <c:pt idx="1271">
                  <c:v>2800</c:v>
                </c:pt>
                <c:pt idx="1272">
                  <c:v>2171</c:v>
                </c:pt>
                <c:pt idx="1273">
                  <c:v>2742</c:v>
                </c:pt>
                <c:pt idx="1274">
                  <c:v>2433</c:v>
                </c:pt>
                <c:pt idx="1275">
                  <c:v>2627</c:v>
                </c:pt>
                <c:pt idx="1276">
                  <c:v>2277</c:v>
                </c:pt>
                <c:pt idx="1277">
                  <c:v>2395</c:v>
                </c:pt>
                <c:pt idx="1278">
                  <c:v>2192</c:v>
                </c:pt>
                <c:pt idx="1279">
                  <c:v>2239</c:v>
                </c:pt>
                <c:pt idx="1280">
                  <c:v>2774</c:v>
                </c:pt>
                <c:pt idx="1281">
                  <c:v>2346</c:v>
                </c:pt>
                <c:pt idx="1282">
                  <c:v>2411</c:v>
                </c:pt>
                <c:pt idx="1283">
                  <c:v>2764</c:v>
                </c:pt>
                <c:pt idx="1284">
                  <c:v>2588</c:v>
                </c:pt>
                <c:pt idx="1285">
                  <c:v>3134</c:v>
                </c:pt>
                <c:pt idx="1286">
                  <c:v>2990</c:v>
                </c:pt>
                <c:pt idx="1287">
                  <c:v>2859</c:v>
                </c:pt>
                <c:pt idx="1288">
                  <c:v>2968</c:v>
                </c:pt>
                <c:pt idx="1289">
                  <c:v>4212</c:v>
                </c:pt>
                <c:pt idx="1290">
                  <c:v>3878</c:v>
                </c:pt>
                <c:pt idx="1291">
                  <c:v>4728</c:v>
                </c:pt>
                <c:pt idx="1292">
                  <c:v>6932</c:v>
                </c:pt>
                <c:pt idx="1293">
                  <c:v>7168</c:v>
                </c:pt>
                <c:pt idx="1294">
                  <c:v>7095</c:v>
                </c:pt>
                <c:pt idx="1295">
                  <c:v>5782</c:v>
                </c:pt>
                <c:pt idx="1296">
                  <c:v>5796</c:v>
                </c:pt>
                <c:pt idx="1297">
                  <c:v>4851</c:v>
                </c:pt>
                <c:pt idx="1298">
                  <c:v>4362</c:v>
                </c:pt>
                <c:pt idx="1299">
                  <c:v>3916</c:v>
                </c:pt>
                <c:pt idx="1300">
                  <c:v>2986</c:v>
                </c:pt>
                <c:pt idx="1301">
                  <c:v>2698</c:v>
                </c:pt>
                <c:pt idx="1302">
                  <c:v>3033</c:v>
                </c:pt>
                <c:pt idx="1303">
                  <c:v>2924</c:v>
                </c:pt>
                <c:pt idx="1304">
                  <c:v>2622</c:v>
                </c:pt>
                <c:pt idx="1305">
                  <c:v>2959</c:v>
                </c:pt>
                <c:pt idx="1306">
                  <c:v>2808</c:v>
                </c:pt>
                <c:pt idx="1307">
                  <c:v>2744</c:v>
                </c:pt>
                <c:pt idx="1308">
                  <c:v>2804</c:v>
                </c:pt>
                <c:pt idx="1309">
                  <c:v>3027</c:v>
                </c:pt>
                <c:pt idx="1310">
                  <c:v>2290</c:v>
                </c:pt>
                <c:pt idx="1311">
                  <c:v>3128</c:v>
                </c:pt>
                <c:pt idx="1312">
                  <c:v>2796</c:v>
                </c:pt>
                <c:pt idx="1313">
                  <c:v>2873</c:v>
                </c:pt>
                <c:pt idx="1314">
                  <c:v>2902</c:v>
                </c:pt>
                <c:pt idx="1315">
                  <c:v>2472</c:v>
                </c:pt>
                <c:pt idx="1316">
                  <c:v>3153</c:v>
                </c:pt>
                <c:pt idx="1317">
                  <c:v>2506</c:v>
                </c:pt>
                <c:pt idx="1318">
                  <c:v>2579</c:v>
                </c:pt>
                <c:pt idx="1319">
                  <c:v>2315</c:v>
                </c:pt>
                <c:pt idx="1320">
                  <c:v>2527</c:v>
                </c:pt>
                <c:pt idx="1321">
                  <c:v>2972</c:v>
                </c:pt>
                <c:pt idx="1322">
                  <c:v>2911</c:v>
                </c:pt>
                <c:pt idx="1323">
                  <c:v>3260</c:v>
                </c:pt>
                <c:pt idx="1324">
                  <c:v>2894</c:v>
                </c:pt>
                <c:pt idx="1325">
                  <c:v>3437</c:v>
                </c:pt>
                <c:pt idx="1326">
                  <c:v>3979</c:v>
                </c:pt>
                <c:pt idx="1327">
                  <c:v>4056</c:v>
                </c:pt>
                <c:pt idx="1328">
                  <c:v>2967</c:v>
                </c:pt>
                <c:pt idx="1329">
                  <c:v>3272</c:v>
                </c:pt>
                <c:pt idx="1330">
                  <c:v>3642</c:v>
                </c:pt>
                <c:pt idx="1331">
                  <c:v>3212</c:v>
                </c:pt>
                <c:pt idx="1332">
                  <c:v>2983</c:v>
                </c:pt>
                <c:pt idx="1333">
                  <c:v>2798</c:v>
                </c:pt>
                <c:pt idx="1334">
                  <c:v>3304</c:v>
                </c:pt>
                <c:pt idx="1335">
                  <c:v>2833</c:v>
                </c:pt>
                <c:pt idx="1336">
                  <c:v>2324</c:v>
                </c:pt>
                <c:pt idx="1337">
                  <c:v>2898</c:v>
                </c:pt>
                <c:pt idx="1338">
                  <c:v>2435</c:v>
                </c:pt>
                <c:pt idx="1339">
                  <c:v>2773</c:v>
                </c:pt>
                <c:pt idx="1340">
                  <c:v>2893</c:v>
                </c:pt>
                <c:pt idx="1341">
                  <c:v>3124</c:v>
                </c:pt>
                <c:pt idx="1342">
                  <c:v>2672</c:v>
                </c:pt>
                <c:pt idx="1343">
                  <c:v>2751</c:v>
                </c:pt>
                <c:pt idx="1344">
                  <c:v>2500</c:v>
                </c:pt>
                <c:pt idx="1345">
                  <c:v>2902</c:v>
                </c:pt>
                <c:pt idx="1346">
                  <c:v>2475</c:v>
                </c:pt>
                <c:pt idx="1347">
                  <c:v>2503</c:v>
                </c:pt>
                <c:pt idx="1348">
                  <c:v>2851</c:v>
                </c:pt>
                <c:pt idx="1349">
                  <c:v>3721</c:v>
                </c:pt>
                <c:pt idx="1350">
                  <c:v>2436</c:v>
                </c:pt>
                <c:pt idx="1351">
                  <c:v>2719</c:v>
                </c:pt>
                <c:pt idx="1352">
                  <c:v>3000</c:v>
                </c:pt>
                <c:pt idx="1353">
                  <c:v>2787</c:v>
                </c:pt>
                <c:pt idx="1354">
                  <c:v>2729</c:v>
                </c:pt>
                <c:pt idx="1355">
                  <c:v>3437</c:v>
                </c:pt>
                <c:pt idx="1356">
                  <c:v>3286</c:v>
                </c:pt>
                <c:pt idx="1357">
                  <c:v>3225</c:v>
                </c:pt>
                <c:pt idx="1358">
                  <c:v>3216</c:v>
                </c:pt>
                <c:pt idx="1359">
                  <c:v>3446</c:v>
                </c:pt>
                <c:pt idx="1360">
                  <c:v>4077</c:v>
                </c:pt>
                <c:pt idx="1361">
                  <c:v>3747</c:v>
                </c:pt>
                <c:pt idx="1362">
                  <c:v>3848</c:v>
                </c:pt>
                <c:pt idx="1363">
                  <c:v>4051</c:v>
                </c:pt>
                <c:pt idx="1364">
                  <c:v>3421</c:v>
                </c:pt>
                <c:pt idx="1365">
                  <c:v>3092</c:v>
                </c:pt>
                <c:pt idx="1366">
                  <c:v>3234</c:v>
                </c:pt>
                <c:pt idx="1367">
                  <c:v>3598</c:v>
                </c:pt>
                <c:pt idx="1368">
                  <c:v>3245</c:v>
                </c:pt>
                <c:pt idx="1369">
                  <c:v>3508</c:v>
                </c:pt>
                <c:pt idx="1370">
                  <c:v>3445</c:v>
                </c:pt>
                <c:pt idx="1371">
                  <c:v>3709</c:v>
                </c:pt>
                <c:pt idx="1372">
                  <c:v>3322</c:v>
                </c:pt>
                <c:pt idx="1373">
                  <c:v>2806</c:v>
                </c:pt>
                <c:pt idx="1374">
                  <c:v>3384</c:v>
                </c:pt>
                <c:pt idx="1375">
                  <c:v>3030</c:v>
                </c:pt>
                <c:pt idx="1376">
                  <c:v>4018</c:v>
                </c:pt>
                <c:pt idx="1377">
                  <c:v>2485</c:v>
                </c:pt>
                <c:pt idx="1378">
                  <c:v>2933</c:v>
                </c:pt>
                <c:pt idx="1379">
                  <c:v>2434</c:v>
                </c:pt>
                <c:pt idx="1380">
                  <c:v>3925</c:v>
                </c:pt>
                <c:pt idx="1381">
                  <c:v>3454</c:v>
                </c:pt>
                <c:pt idx="1382">
                  <c:v>3025</c:v>
                </c:pt>
                <c:pt idx="1383">
                  <c:v>3162</c:v>
                </c:pt>
                <c:pt idx="1384">
                  <c:v>3299</c:v>
                </c:pt>
                <c:pt idx="1385">
                  <c:v>3026</c:v>
                </c:pt>
                <c:pt idx="1386">
                  <c:v>3202</c:v>
                </c:pt>
                <c:pt idx="1387">
                  <c:v>4033</c:v>
                </c:pt>
                <c:pt idx="1388">
                  <c:v>3242</c:v>
                </c:pt>
                <c:pt idx="1389">
                  <c:v>2539</c:v>
                </c:pt>
                <c:pt idx="1390">
                  <c:v>2984</c:v>
                </c:pt>
                <c:pt idx="1391">
                  <c:v>3245</c:v>
                </c:pt>
                <c:pt idx="1392">
                  <c:v>2974</c:v>
                </c:pt>
                <c:pt idx="1393">
                  <c:v>2744</c:v>
                </c:pt>
                <c:pt idx="1394">
                  <c:v>2704</c:v>
                </c:pt>
                <c:pt idx="1395">
                  <c:v>3328</c:v>
                </c:pt>
                <c:pt idx="1396">
                  <c:v>3125</c:v>
                </c:pt>
                <c:pt idx="1397">
                  <c:v>2564</c:v>
                </c:pt>
                <c:pt idx="1398">
                  <c:v>3719</c:v>
                </c:pt>
                <c:pt idx="1399">
                  <c:v>3786</c:v>
                </c:pt>
                <c:pt idx="1400">
                  <c:v>3441</c:v>
                </c:pt>
                <c:pt idx="1401">
                  <c:v>2673</c:v>
                </c:pt>
                <c:pt idx="1402">
                  <c:v>3193</c:v>
                </c:pt>
                <c:pt idx="1403">
                  <c:v>3069</c:v>
                </c:pt>
                <c:pt idx="1404">
                  <c:v>2649</c:v>
                </c:pt>
                <c:pt idx="1405">
                  <c:v>3100</c:v>
                </c:pt>
                <c:pt idx="1406">
                  <c:v>2928</c:v>
                </c:pt>
                <c:pt idx="1407">
                  <c:v>3150</c:v>
                </c:pt>
                <c:pt idx="1408">
                  <c:v>2888</c:v>
                </c:pt>
                <c:pt idx="1409">
                  <c:v>2978</c:v>
                </c:pt>
                <c:pt idx="1410">
                  <c:v>3155</c:v>
                </c:pt>
                <c:pt idx="1411">
                  <c:v>2978</c:v>
                </c:pt>
                <c:pt idx="1412">
                  <c:v>2742</c:v>
                </c:pt>
                <c:pt idx="1413">
                  <c:v>2842</c:v>
                </c:pt>
                <c:pt idx="1414">
                  <c:v>2910</c:v>
                </c:pt>
                <c:pt idx="1415">
                  <c:v>3110</c:v>
                </c:pt>
                <c:pt idx="1416">
                  <c:v>2491</c:v>
                </c:pt>
                <c:pt idx="1417">
                  <c:v>3633</c:v>
                </c:pt>
                <c:pt idx="1418">
                  <c:v>3031</c:v>
                </c:pt>
                <c:pt idx="1419">
                  <c:v>3291</c:v>
                </c:pt>
                <c:pt idx="1420">
                  <c:v>2980</c:v>
                </c:pt>
                <c:pt idx="1421">
                  <c:v>2917</c:v>
                </c:pt>
                <c:pt idx="1422">
                  <c:v>2754</c:v>
                </c:pt>
                <c:pt idx="1423">
                  <c:v>2562</c:v>
                </c:pt>
                <c:pt idx="1424">
                  <c:v>2505</c:v>
                </c:pt>
                <c:pt idx="1425">
                  <c:v>3150</c:v>
                </c:pt>
                <c:pt idx="1426">
                  <c:v>2490</c:v>
                </c:pt>
                <c:pt idx="1427">
                  <c:v>2843</c:v>
                </c:pt>
                <c:pt idx="1428">
                  <c:v>2748</c:v>
                </c:pt>
                <c:pt idx="1429">
                  <c:v>2907</c:v>
                </c:pt>
                <c:pt idx="1430">
                  <c:v>3090</c:v>
                </c:pt>
                <c:pt idx="1431">
                  <c:v>3160</c:v>
                </c:pt>
                <c:pt idx="1432">
                  <c:v>2538</c:v>
                </c:pt>
                <c:pt idx="1433">
                  <c:v>2283</c:v>
                </c:pt>
                <c:pt idx="1434">
                  <c:v>2784</c:v>
                </c:pt>
                <c:pt idx="1435">
                  <c:v>3174</c:v>
                </c:pt>
                <c:pt idx="1436">
                  <c:v>2154</c:v>
                </c:pt>
                <c:pt idx="1437">
                  <c:v>3058</c:v>
                </c:pt>
                <c:pt idx="1438">
                  <c:v>2789</c:v>
                </c:pt>
                <c:pt idx="1439">
                  <c:v>2386</c:v>
                </c:pt>
                <c:pt idx="1440">
                  <c:v>2815</c:v>
                </c:pt>
                <c:pt idx="1441">
                  <c:v>2400</c:v>
                </c:pt>
                <c:pt idx="1442">
                  <c:v>2430</c:v>
                </c:pt>
                <c:pt idx="1443">
                  <c:v>2540</c:v>
                </c:pt>
                <c:pt idx="1444">
                  <c:v>2395</c:v>
                </c:pt>
                <c:pt idx="1445">
                  <c:v>2611</c:v>
                </c:pt>
                <c:pt idx="1446">
                  <c:v>2457</c:v>
                </c:pt>
                <c:pt idx="1447">
                  <c:v>2426</c:v>
                </c:pt>
                <c:pt idx="1448">
                  <c:v>2727</c:v>
                </c:pt>
                <c:pt idx="1449">
                  <c:v>2320</c:v>
                </c:pt>
                <c:pt idx="1450">
                  <c:v>2315</c:v>
                </c:pt>
                <c:pt idx="1451">
                  <c:v>2419</c:v>
                </c:pt>
                <c:pt idx="1452">
                  <c:v>2684</c:v>
                </c:pt>
                <c:pt idx="1453">
                  <c:v>3002</c:v>
                </c:pt>
                <c:pt idx="1454">
                  <c:v>2463</c:v>
                </c:pt>
                <c:pt idx="1455">
                  <c:v>2486</c:v>
                </c:pt>
                <c:pt idx="1456">
                  <c:v>2950</c:v>
                </c:pt>
                <c:pt idx="1457">
                  <c:v>2442</c:v>
                </c:pt>
                <c:pt idx="1458">
                  <c:v>2568</c:v>
                </c:pt>
                <c:pt idx="1459">
                  <c:v>1866</c:v>
                </c:pt>
                <c:pt idx="1460">
                  <c:v>2267</c:v>
                </c:pt>
                <c:pt idx="1461">
                  <c:v>2497</c:v>
                </c:pt>
                <c:pt idx="1462">
                  <c:v>2629</c:v>
                </c:pt>
                <c:pt idx="1463">
                  <c:v>2452</c:v>
                </c:pt>
                <c:pt idx="1464">
                  <c:v>2139</c:v>
                </c:pt>
                <c:pt idx="1465">
                  <c:v>2410</c:v>
                </c:pt>
                <c:pt idx="1466">
                  <c:v>2476</c:v>
                </c:pt>
                <c:pt idx="1467">
                  <c:v>2259</c:v>
                </c:pt>
                <c:pt idx="1468">
                  <c:v>214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E583-4B47-812B-4772A7BB88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262016"/>
        <c:axId val="123262576"/>
      </c:scatterChart>
      <c:valAx>
        <c:axId val="123262016"/>
        <c:scaling>
          <c:orientation val="minMax"/>
          <c:max val="9"/>
          <c:min val="3"/>
        </c:scaling>
        <c:delete val="0"/>
        <c:axPos val="b"/>
        <c:numFmt formatCode="General" sourceLinked="1"/>
        <c:majorTickMark val="out"/>
        <c:minorTickMark val="none"/>
        <c:tickLblPos val="nextTo"/>
        <c:crossAx val="123262576"/>
        <c:crosses val="autoZero"/>
        <c:crossBetween val="midCat"/>
      </c:valAx>
      <c:valAx>
        <c:axId val="123262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326201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590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047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054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387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023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163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055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095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659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961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163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F4551F-BCD5-49B0-BAC9-DF01960D9CF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FA96E5-53F9-43BC-AFAC-E3D121514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138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chart" Target="../charts/chart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39019" y="2835831"/>
            <a:ext cx="27361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Spicellum roseum </a:t>
            </a:r>
            <a:r>
              <a:rPr lang="en-US" dirty="0" smtClean="0"/>
              <a:t>YEPD 8d 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7451229" y="4267200"/>
            <a:ext cx="1692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8-deoxy trichothecin</a:t>
            </a:r>
            <a:endParaRPr lang="en-US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3352800" y="4724400"/>
            <a:ext cx="1140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richodermol</a:t>
            </a:r>
            <a:endParaRPr lang="en-US" sz="1400" dirty="0"/>
          </a:p>
        </p:txBody>
      </p:sp>
      <p:graphicFrame>
        <p:nvGraphicFramePr>
          <p:cNvPr id="5" name="Object 2"/>
          <p:cNvGraphicFramePr>
            <a:graphicFrameLocks noChangeAspect="1"/>
          </p:cNvGraphicFramePr>
          <p:nvPr/>
        </p:nvGraphicFramePr>
        <p:xfrm>
          <a:off x="7315200" y="3429000"/>
          <a:ext cx="1604963" cy="8696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CS ChemDraw Drawing" r:id="rId3" imgW="2976120" imgH="1612800" progId="ChemDraw.Document.6.0">
                  <p:embed/>
                </p:oleObj>
              </mc:Choice>
              <mc:Fallback>
                <p:oleObj name="CS ChemDraw Drawing" r:id="rId3" imgW="2976120" imgH="1612800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315200" y="3429000"/>
                        <a:ext cx="1604963" cy="8696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3"/>
          <p:cNvGraphicFramePr>
            <a:graphicFrameLocks noChangeAspect="1"/>
          </p:cNvGraphicFramePr>
          <p:nvPr/>
        </p:nvGraphicFramePr>
        <p:xfrm>
          <a:off x="3276600" y="3886200"/>
          <a:ext cx="1554163" cy="76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CS ChemDraw Drawing" r:id="rId5" imgW="2493000" imgH="1227240" progId="ChemDraw.Document.6.0">
                  <p:embed/>
                </p:oleObj>
              </mc:Choice>
              <mc:Fallback>
                <p:oleObj name="CS ChemDraw Drawing" r:id="rId5" imgW="2493000" imgH="1227240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76600" y="3886200"/>
                        <a:ext cx="1554163" cy="7667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Chart 6"/>
          <p:cNvGraphicFramePr>
            <a:graphicFrameLocks noGrp="1"/>
          </p:cNvGraphicFramePr>
          <p:nvPr>
            <p:extLst/>
          </p:nvPr>
        </p:nvGraphicFramePr>
        <p:xfrm>
          <a:off x="321892" y="3276600"/>
          <a:ext cx="8649511" cy="31371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8" name="Straight Connector 7"/>
          <p:cNvCxnSpPr/>
          <p:nvPr/>
        </p:nvCxnSpPr>
        <p:spPr>
          <a:xfrm>
            <a:off x="4572000" y="4495800"/>
            <a:ext cx="304800" cy="914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>
            <a:off x="7366476" y="3886200"/>
            <a:ext cx="228600" cy="76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62076" y="94068"/>
            <a:ext cx="675388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S4 Figure:</a:t>
            </a:r>
            <a:r>
              <a:rPr lang="en-US"/>
              <a:t> Total ion chromatograms from gas chromatography-mass spectrometry analysis of an extract from a seven-day-old YEPD culture of </a:t>
            </a:r>
            <a:r>
              <a:rPr lang="en-US" i="1"/>
              <a:t>Spicellum roseum </a:t>
            </a:r>
            <a:r>
              <a:rPr lang="en-US"/>
              <a:t>strain DAOM 209012. Peaks corresponding to trichodermol (4-hydroxy EPT), trichodermin (4-</a:t>
            </a:r>
            <a:r>
              <a:rPr lang="en-US" i="1"/>
              <a:t>O</a:t>
            </a:r>
            <a:r>
              <a:rPr lang="en-US"/>
              <a:t>-acetyl EPT), and 8-deoxy trichothecin (4-</a:t>
            </a:r>
            <a:r>
              <a:rPr lang="en-US" i="1"/>
              <a:t>O</a:t>
            </a:r>
            <a:r>
              <a:rPr lang="en-US"/>
              <a:t>-butenoyl EPT) are shown. Based on mass spectral fragmentation patterns, the unlabeled peaks at 5 min and 6.1 min do not correspond to trichothecenes.</a:t>
            </a:r>
          </a:p>
        </p:txBody>
      </p:sp>
    </p:spTree>
    <p:extLst>
      <p:ext uri="{BB962C8B-B14F-4D97-AF65-F5344CB8AC3E}">
        <p14:creationId xmlns:p14="http://schemas.microsoft.com/office/powerpoint/2010/main" val="1861472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S ChemDraw Drawing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hp</dc:creator>
  <cp:lastModifiedBy>rhp</cp:lastModifiedBy>
  <cp:revision>2</cp:revision>
  <dcterms:created xsi:type="dcterms:W3CDTF">2017-12-14T20:10:24Z</dcterms:created>
  <dcterms:modified xsi:type="dcterms:W3CDTF">2018-03-01T18:40:41Z</dcterms:modified>
</cp:coreProperties>
</file>